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88" r:id="rId2"/>
    <p:sldId id="278" r:id="rId3"/>
    <p:sldId id="27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CCFF"/>
    <a:srgbClr val="FC6666"/>
    <a:srgbClr val="942093"/>
    <a:srgbClr val="D883FF"/>
    <a:srgbClr val="118002"/>
    <a:srgbClr val="8000FF"/>
    <a:srgbClr val="000080"/>
    <a:srgbClr val="0092FF"/>
    <a:srgbClr val="21F106"/>
    <a:srgbClr val="FFE4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10" autoAdjust="0"/>
    <p:restoredTop sz="97680" autoAdjust="0"/>
  </p:normalViewPr>
  <p:slideViewPr>
    <p:cSldViewPr snapToGrid="0">
      <p:cViewPr>
        <p:scale>
          <a:sx n="139" d="100"/>
          <a:sy n="139" d="100"/>
        </p:scale>
        <p:origin x="2104" y="-2984"/>
      </p:cViewPr>
      <p:guideLst/>
    </p:cSldViewPr>
  </p:slideViewPr>
  <p:notesTextViewPr>
    <p:cViewPr>
      <p:scale>
        <a:sx n="110" d="100"/>
        <a:sy n="110" d="100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PowerPoint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hart%202%20in%20Microsoft%20PowerPoint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Chart%203%20in%20Microsoft%20PowerPoint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[Chart in Microsoft PowerPoint]Sheet1'!$A$6:$A$606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[Chart in Microsoft PowerPoint]Sheet1'!$B$6:$B$606</c:f>
              <c:numCache>
                <c:formatCode>General</c:formatCode>
                <c:ptCount val="601"/>
                <c:pt idx="0">
                  <c:v>0.11234788599999999</c:v>
                </c:pt>
                <c:pt idx="1">
                  <c:v>0.1131860316</c:v>
                </c:pt>
                <c:pt idx="2">
                  <c:v>0.1133112833</c:v>
                </c:pt>
                <c:pt idx="3">
                  <c:v>0.1132987216</c:v>
                </c:pt>
                <c:pt idx="4">
                  <c:v>0.1135211512</c:v>
                </c:pt>
                <c:pt idx="5">
                  <c:v>0.11362545189999999</c:v>
                </c:pt>
                <c:pt idx="6">
                  <c:v>0.11387947950000001</c:v>
                </c:pt>
                <c:pt idx="7">
                  <c:v>0.11400233949999999</c:v>
                </c:pt>
                <c:pt idx="8">
                  <c:v>0.1139663979</c:v>
                </c:pt>
                <c:pt idx="9">
                  <c:v>0.1142326742</c:v>
                </c:pt>
                <c:pt idx="10">
                  <c:v>0.11459172519999999</c:v>
                </c:pt>
                <c:pt idx="11">
                  <c:v>0.11440879850000001</c:v>
                </c:pt>
                <c:pt idx="12">
                  <c:v>0.1148124933</c:v>
                </c:pt>
                <c:pt idx="13">
                  <c:v>0.1148391366</c:v>
                </c:pt>
                <c:pt idx="14">
                  <c:v>0.1151240394</c:v>
                </c:pt>
                <c:pt idx="15">
                  <c:v>0.1152464747</c:v>
                </c:pt>
                <c:pt idx="16">
                  <c:v>0.1153229699</c:v>
                </c:pt>
                <c:pt idx="17">
                  <c:v>0.11532516029999999</c:v>
                </c:pt>
                <c:pt idx="18">
                  <c:v>0.1154629216</c:v>
                </c:pt>
                <c:pt idx="19">
                  <c:v>0.11562183500000001</c:v>
                </c:pt>
                <c:pt idx="20">
                  <c:v>0.1159171239</c:v>
                </c:pt>
                <c:pt idx="21">
                  <c:v>0.1159827784</c:v>
                </c:pt>
                <c:pt idx="22">
                  <c:v>0.1161426976</c:v>
                </c:pt>
                <c:pt idx="23">
                  <c:v>0.1162806153</c:v>
                </c:pt>
                <c:pt idx="24">
                  <c:v>0.1163398623</c:v>
                </c:pt>
                <c:pt idx="25">
                  <c:v>0.1166003197</c:v>
                </c:pt>
                <c:pt idx="26">
                  <c:v>0.1165823787</c:v>
                </c:pt>
                <c:pt idx="27">
                  <c:v>0.11688323320000001</c:v>
                </c:pt>
                <c:pt idx="28">
                  <c:v>0.1169109792</c:v>
                </c:pt>
                <c:pt idx="29">
                  <c:v>0.11696546519999999</c:v>
                </c:pt>
                <c:pt idx="30">
                  <c:v>0.1173491329</c:v>
                </c:pt>
                <c:pt idx="31">
                  <c:v>0.1170870364</c:v>
                </c:pt>
                <c:pt idx="32">
                  <c:v>0.1173955649</c:v>
                </c:pt>
                <c:pt idx="33">
                  <c:v>0.1174438745</c:v>
                </c:pt>
                <c:pt idx="34">
                  <c:v>0.1175072789</c:v>
                </c:pt>
                <c:pt idx="35">
                  <c:v>0.1176261827</c:v>
                </c:pt>
                <c:pt idx="36">
                  <c:v>0.1176895872</c:v>
                </c:pt>
                <c:pt idx="37">
                  <c:v>0.11782680450000001</c:v>
                </c:pt>
                <c:pt idx="38">
                  <c:v>0.1180465743</c:v>
                </c:pt>
                <c:pt idx="39">
                  <c:v>0.11783766750000001</c:v>
                </c:pt>
                <c:pt idx="40">
                  <c:v>0.118151933</c:v>
                </c:pt>
                <c:pt idx="41">
                  <c:v>0.11839128290000001</c:v>
                </c:pt>
                <c:pt idx="42">
                  <c:v>0.11842076479999999</c:v>
                </c:pt>
                <c:pt idx="43">
                  <c:v>0.1184174269</c:v>
                </c:pt>
                <c:pt idx="44">
                  <c:v>0.1186211407</c:v>
                </c:pt>
                <c:pt idx="45">
                  <c:v>0.11857029049999999</c:v>
                </c:pt>
                <c:pt idx="46">
                  <c:v>0.1188194305</c:v>
                </c:pt>
                <c:pt idx="47">
                  <c:v>0.118767634</c:v>
                </c:pt>
                <c:pt idx="48">
                  <c:v>0.11895326520000001</c:v>
                </c:pt>
                <c:pt idx="49">
                  <c:v>0.11905986070000001</c:v>
                </c:pt>
                <c:pt idx="50">
                  <c:v>0.1192476898</c:v>
                </c:pt>
                <c:pt idx="51">
                  <c:v>0.1192789003</c:v>
                </c:pt>
                <c:pt idx="52">
                  <c:v>0.1193463206</c:v>
                </c:pt>
                <c:pt idx="53">
                  <c:v>0.119377397</c:v>
                </c:pt>
                <c:pt idx="54">
                  <c:v>0.1196879745</c:v>
                </c:pt>
                <c:pt idx="55">
                  <c:v>0.1196238697</c:v>
                </c:pt>
                <c:pt idx="56">
                  <c:v>0.11977735909999999</c:v>
                </c:pt>
                <c:pt idx="57">
                  <c:v>0.1198501438</c:v>
                </c:pt>
                <c:pt idx="58">
                  <c:v>0.1199599355</c:v>
                </c:pt>
                <c:pt idx="59">
                  <c:v>0.12005780639999999</c:v>
                </c:pt>
                <c:pt idx="60">
                  <c:v>0.12003483619999999</c:v>
                </c:pt>
                <c:pt idx="61">
                  <c:v>0.1200655177</c:v>
                </c:pt>
                <c:pt idx="62">
                  <c:v>0.1201422811</c:v>
                </c:pt>
                <c:pt idx="63">
                  <c:v>0.1200808734</c:v>
                </c:pt>
                <c:pt idx="64">
                  <c:v>0.1199900284</c:v>
                </c:pt>
                <c:pt idx="65">
                  <c:v>0.1196703762</c:v>
                </c:pt>
                <c:pt idx="66">
                  <c:v>0.1195243597</c:v>
                </c:pt>
                <c:pt idx="67">
                  <c:v>0.11936468629999999</c:v>
                </c:pt>
                <c:pt idx="68">
                  <c:v>0.1188885868</c:v>
                </c:pt>
                <c:pt idx="69">
                  <c:v>0.118598178</c:v>
                </c:pt>
                <c:pt idx="70">
                  <c:v>0.1182413101</c:v>
                </c:pt>
                <c:pt idx="71">
                  <c:v>0.1178174317</c:v>
                </c:pt>
                <c:pt idx="72">
                  <c:v>0.1175832227</c:v>
                </c:pt>
                <c:pt idx="73">
                  <c:v>0.11728961020000001</c:v>
                </c:pt>
                <c:pt idx="74">
                  <c:v>0.1170643941</c:v>
                </c:pt>
                <c:pt idx="75">
                  <c:v>0.1168924123</c:v>
                </c:pt>
                <c:pt idx="76">
                  <c:v>0.1166079417</c:v>
                </c:pt>
                <c:pt idx="77">
                  <c:v>0.11642896379999999</c:v>
                </c:pt>
                <c:pt idx="78">
                  <c:v>0.1161923185</c:v>
                </c:pt>
                <c:pt idx="79">
                  <c:v>0.116134271</c:v>
                </c:pt>
                <c:pt idx="80">
                  <c:v>0.1158746704</c:v>
                </c:pt>
                <c:pt idx="81">
                  <c:v>0.11544816199999999</c:v>
                </c:pt>
                <c:pt idx="82">
                  <c:v>0.1146652326</c:v>
                </c:pt>
                <c:pt idx="83">
                  <c:v>0.1149402112</c:v>
                </c:pt>
                <c:pt idx="84">
                  <c:v>0.11477102340000001</c:v>
                </c:pt>
                <c:pt idx="85">
                  <c:v>0.1145284399</c:v>
                </c:pt>
                <c:pt idx="86">
                  <c:v>0.1141288355</c:v>
                </c:pt>
                <c:pt idx="87">
                  <c:v>0.11391090600000001</c:v>
                </c:pt>
                <c:pt idx="88">
                  <c:v>0.1136373878</c:v>
                </c:pt>
                <c:pt idx="89">
                  <c:v>0.11332885920000001</c:v>
                </c:pt>
                <c:pt idx="90">
                  <c:v>0.1130452007</c:v>
                </c:pt>
                <c:pt idx="91">
                  <c:v>0.11293230949999999</c:v>
                </c:pt>
                <c:pt idx="92">
                  <c:v>0.1126190126</c:v>
                </c:pt>
                <c:pt idx="93">
                  <c:v>0.1125221699</c:v>
                </c:pt>
                <c:pt idx="94">
                  <c:v>0.11234755070000001</c:v>
                </c:pt>
                <c:pt idx="95">
                  <c:v>0.1122619659</c:v>
                </c:pt>
                <c:pt idx="96">
                  <c:v>0.112174511</c:v>
                </c:pt>
                <c:pt idx="97">
                  <c:v>0.11206001040000001</c:v>
                </c:pt>
                <c:pt idx="98">
                  <c:v>0.111945264</c:v>
                </c:pt>
                <c:pt idx="99">
                  <c:v>0.1119541377</c:v>
                </c:pt>
                <c:pt idx="100">
                  <c:v>0.1118067428</c:v>
                </c:pt>
                <c:pt idx="101">
                  <c:v>0.1118113622</c:v>
                </c:pt>
                <c:pt idx="102">
                  <c:v>0.11179981379999999</c:v>
                </c:pt>
                <c:pt idx="103">
                  <c:v>0.1116830632</c:v>
                </c:pt>
                <c:pt idx="104">
                  <c:v>0.1118123978</c:v>
                </c:pt>
                <c:pt idx="105">
                  <c:v>0.11170813440000001</c:v>
                </c:pt>
                <c:pt idx="106">
                  <c:v>0.11175403740000001</c:v>
                </c:pt>
                <c:pt idx="107">
                  <c:v>0.1117812619</c:v>
                </c:pt>
                <c:pt idx="108">
                  <c:v>0.11170618979999999</c:v>
                </c:pt>
                <c:pt idx="109">
                  <c:v>0.11179016529999999</c:v>
                </c:pt>
                <c:pt idx="110">
                  <c:v>0.11172915999999999</c:v>
                </c:pt>
                <c:pt idx="111">
                  <c:v>0.1118237227</c:v>
                </c:pt>
                <c:pt idx="112">
                  <c:v>0.1117637828</c:v>
                </c:pt>
                <c:pt idx="113">
                  <c:v>0.1117502227</c:v>
                </c:pt>
                <c:pt idx="114">
                  <c:v>0.1117961928</c:v>
                </c:pt>
                <c:pt idx="115">
                  <c:v>0.1117697433</c:v>
                </c:pt>
                <c:pt idx="116">
                  <c:v>0.111812599</c:v>
                </c:pt>
                <c:pt idx="117">
                  <c:v>0.11184772849999999</c:v>
                </c:pt>
                <c:pt idx="118">
                  <c:v>0.11200911550000001</c:v>
                </c:pt>
                <c:pt idx="119">
                  <c:v>0.11180262270000001</c:v>
                </c:pt>
                <c:pt idx="120">
                  <c:v>0.1118207052</c:v>
                </c:pt>
                <c:pt idx="121">
                  <c:v>0.1119677424</c:v>
                </c:pt>
                <c:pt idx="122">
                  <c:v>0.11191381509999999</c:v>
                </c:pt>
                <c:pt idx="123">
                  <c:v>0.11200392250000001</c:v>
                </c:pt>
                <c:pt idx="124">
                  <c:v>0.112060681</c:v>
                </c:pt>
                <c:pt idx="125">
                  <c:v>0.1120359153</c:v>
                </c:pt>
                <c:pt idx="126">
                  <c:v>0.1122037694</c:v>
                </c:pt>
                <c:pt idx="127">
                  <c:v>0.1120780334</c:v>
                </c:pt>
                <c:pt idx="128">
                  <c:v>0.1121162698</c:v>
                </c:pt>
                <c:pt idx="129">
                  <c:v>0.1121392548</c:v>
                </c:pt>
                <c:pt idx="130">
                  <c:v>0.112221837</c:v>
                </c:pt>
                <c:pt idx="131">
                  <c:v>0.1123534516</c:v>
                </c:pt>
                <c:pt idx="132">
                  <c:v>0.1127545387</c:v>
                </c:pt>
                <c:pt idx="133">
                  <c:v>0.1129568219</c:v>
                </c:pt>
                <c:pt idx="134">
                  <c:v>0.11283368620000001</c:v>
                </c:pt>
                <c:pt idx="135">
                  <c:v>0.1129367426</c:v>
                </c:pt>
                <c:pt idx="136">
                  <c:v>0.1129011586</c:v>
                </c:pt>
                <c:pt idx="137">
                  <c:v>0.1129457057</c:v>
                </c:pt>
                <c:pt idx="138">
                  <c:v>0.1130008772</c:v>
                </c:pt>
                <c:pt idx="139">
                  <c:v>0.1128755733</c:v>
                </c:pt>
                <c:pt idx="140">
                  <c:v>0.1129284129</c:v>
                </c:pt>
                <c:pt idx="141">
                  <c:v>0.11295678470000001</c:v>
                </c:pt>
                <c:pt idx="142">
                  <c:v>0.1130875796</c:v>
                </c:pt>
                <c:pt idx="143">
                  <c:v>0.1130456999</c:v>
                </c:pt>
                <c:pt idx="144">
                  <c:v>0.1130986288</c:v>
                </c:pt>
                <c:pt idx="145">
                  <c:v>0.1130832806</c:v>
                </c:pt>
                <c:pt idx="146">
                  <c:v>0.1130831838</c:v>
                </c:pt>
                <c:pt idx="147">
                  <c:v>0.1132412627</c:v>
                </c:pt>
                <c:pt idx="148">
                  <c:v>0.1132851094</c:v>
                </c:pt>
                <c:pt idx="149">
                  <c:v>0.1131336614</c:v>
                </c:pt>
                <c:pt idx="150">
                  <c:v>0.11312446</c:v>
                </c:pt>
                <c:pt idx="151">
                  <c:v>0.11327748</c:v>
                </c:pt>
                <c:pt idx="152">
                  <c:v>0.1133826002</c:v>
                </c:pt>
                <c:pt idx="153">
                  <c:v>0.1133938879</c:v>
                </c:pt>
                <c:pt idx="154">
                  <c:v>0.11334703860000001</c:v>
                </c:pt>
                <c:pt idx="155">
                  <c:v>0.11348091070000001</c:v>
                </c:pt>
                <c:pt idx="156">
                  <c:v>0.11347029359999999</c:v>
                </c:pt>
                <c:pt idx="157">
                  <c:v>0.1133823618</c:v>
                </c:pt>
                <c:pt idx="158">
                  <c:v>0.1135706455</c:v>
                </c:pt>
                <c:pt idx="159">
                  <c:v>0.11352488400000001</c:v>
                </c:pt>
                <c:pt idx="160">
                  <c:v>0.11356183139999999</c:v>
                </c:pt>
                <c:pt idx="161">
                  <c:v>0.1136211157</c:v>
                </c:pt>
                <c:pt idx="162">
                  <c:v>0.11363624780000001</c:v>
                </c:pt>
                <c:pt idx="163">
                  <c:v>0.1136874631</c:v>
                </c:pt>
                <c:pt idx="164">
                  <c:v>0.1137790233</c:v>
                </c:pt>
                <c:pt idx="165">
                  <c:v>0.11380462349999999</c:v>
                </c:pt>
                <c:pt idx="166">
                  <c:v>0.1138667241</c:v>
                </c:pt>
                <c:pt idx="167">
                  <c:v>0.1138441488</c:v>
                </c:pt>
                <c:pt idx="168">
                  <c:v>0.1139641404</c:v>
                </c:pt>
                <c:pt idx="169">
                  <c:v>0.11390915510000001</c:v>
                </c:pt>
                <c:pt idx="170">
                  <c:v>0.1140392646</c:v>
                </c:pt>
                <c:pt idx="171">
                  <c:v>0.1138970107</c:v>
                </c:pt>
                <c:pt idx="172">
                  <c:v>0.1140495315</c:v>
                </c:pt>
                <c:pt idx="173">
                  <c:v>0.1141006649</c:v>
                </c:pt>
                <c:pt idx="174">
                  <c:v>0.1140546128</c:v>
                </c:pt>
                <c:pt idx="175">
                  <c:v>0.1141134202</c:v>
                </c:pt>
                <c:pt idx="176">
                  <c:v>0.11420512939999999</c:v>
                </c:pt>
                <c:pt idx="177">
                  <c:v>0.1142918468</c:v>
                </c:pt>
                <c:pt idx="178">
                  <c:v>0.1142945439</c:v>
                </c:pt>
                <c:pt idx="179">
                  <c:v>0.1144562662</c:v>
                </c:pt>
                <c:pt idx="180">
                  <c:v>0.1142780036</c:v>
                </c:pt>
                <c:pt idx="181">
                  <c:v>0.11444352570000001</c:v>
                </c:pt>
                <c:pt idx="182">
                  <c:v>0.1144581512</c:v>
                </c:pt>
                <c:pt idx="183">
                  <c:v>0.1144964248</c:v>
                </c:pt>
                <c:pt idx="184">
                  <c:v>0.1144723669</c:v>
                </c:pt>
                <c:pt idx="185">
                  <c:v>0.114565745</c:v>
                </c:pt>
                <c:pt idx="186">
                  <c:v>0.1145953014</c:v>
                </c:pt>
                <c:pt idx="187">
                  <c:v>0.1147361994</c:v>
                </c:pt>
                <c:pt idx="188">
                  <c:v>0.1148364395</c:v>
                </c:pt>
                <c:pt idx="189">
                  <c:v>0.1147540286</c:v>
                </c:pt>
                <c:pt idx="190">
                  <c:v>0.1148769036</c:v>
                </c:pt>
                <c:pt idx="191">
                  <c:v>0.1148181632</c:v>
                </c:pt>
                <c:pt idx="192">
                  <c:v>0.1150145531</c:v>
                </c:pt>
                <c:pt idx="193">
                  <c:v>0.11489261689999999</c:v>
                </c:pt>
                <c:pt idx="194">
                  <c:v>0.11496574430000001</c:v>
                </c:pt>
                <c:pt idx="195">
                  <c:v>0.1149170026</c:v>
                </c:pt>
                <c:pt idx="196">
                  <c:v>0.114971377</c:v>
                </c:pt>
                <c:pt idx="197">
                  <c:v>0.1149688438</c:v>
                </c:pt>
                <c:pt idx="198">
                  <c:v>0.11516413089999999</c:v>
                </c:pt>
                <c:pt idx="199">
                  <c:v>0.11514472219999999</c:v>
                </c:pt>
                <c:pt idx="200">
                  <c:v>0.1152188331</c:v>
                </c:pt>
                <c:pt idx="201">
                  <c:v>0.11525747929999999</c:v>
                </c:pt>
                <c:pt idx="202">
                  <c:v>0.1152787805</c:v>
                </c:pt>
                <c:pt idx="203">
                  <c:v>0.1151837334</c:v>
                </c:pt>
                <c:pt idx="204">
                  <c:v>0.11515667290000001</c:v>
                </c:pt>
                <c:pt idx="205">
                  <c:v>0.1152288616</c:v>
                </c:pt>
                <c:pt idx="206">
                  <c:v>0.11533664170000001</c:v>
                </c:pt>
                <c:pt idx="207">
                  <c:v>0.1151957139</c:v>
                </c:pt>
                <c:pt idx="208">
                  <c:v>0.11532077189999999</c:v>
                </c:pt>
                <c:pt idx="209">
                  <c:v>0.11518903079999999</c:v>
                </c:pt>
                <c:pt idx="210">
                  <c:v>0.1153232008</c:v>
                </c:pt>
                <c:pt idx="211">
                  <c:v>0.11550739409999999</c:v>
                </c:pt>
                <c:pt idx="212">
                  <c:v>0.1154159158</c:v>
                </c:pt>
                <c:pt idx="213">
                  <c:v>0.1155473888</c:v>
                </c:pt>
                <c:pt idx="214">
                  <c:v>0.1154150739</c:v>
                </c:pt>
                <c:pt idx="215">
                  <c:v>0.1155655906</c:v>
                </c:pt>
                <c:pt idx="216">
                  <c:v>0.1156580821</c:v>
                </c:pt>
                <c:pt idx="217">
                  <c:v>0.115731135</c:v>
                </c:pt>
                <c:pt idx="218">
                  <c:v>0.1156864688</c:v>
                </c:pt>
                <c:pt idx="219">
                  <c:v>0.1158118695</c:v>
                </c:pt>
                <c:pt idx="220">
                  <c:v>0.11572309579999999</c:v>
                </c:pt>
                <c:pt idx="221">
                  <c:v>0.1159913987</c:v>
                </c:pt>
                <c:pt idx="222">
                  <c:v>0.11587831379999999</c:v>
                </c:pt>
                <c:pt idx="223">
                  <c:v>0.11612331870000001</c:v>
                </c:pt>
                <c:pt idx="224">
                  <c:v>0.1161626875</c:v>
                </c:pt>
                <c:pt idx="225">
                  <c:v>0.1161015034</c:v>
                </c:pt>
                <c:pt idx="226">
                  <c:v>0.116145134</c:v>
                </c:pt>
                <c:pt idx="227">
                  <c:v>0.11630250509999999</c:v>
                </c:pt>
                <c:pt idx="228">
                  <c:v>0.1162128821</c:v>
                </c:pt>
                <c:pt idx="229">
                  <c:v>0.11630839110000001</c:v>
                </c:pt>
                <c:pt idx="230">
                  <c:v>0.11645011600000001</c:v>
                </c:pt>
                <c:pt idx="231">
                  <c:v>0.1165260747</c:v>
                </c:pt>
                <c:pt idx="232">
                  <c:v>0.1167764887</c:v>
                </c:pt>
                <c:pt idx="233">
                  <c:v>0.11738403140000001</c:v>
                </c:pt>
                <c:pt idx="234">
                  <c:v>0.11746799199999999</c:v>
                </c:pt>
                <c:pt idx="235">
                  <c:v>0.11757602540000001</c:v>
                </c:pt>
                <c:pt idx="236">
                  <c:v>0.11756666</c:v>
                </c:pt>
                <c:pt idx="237">
                  <c:v>0.1176887378</c:v>
                </c:pt>
                <c:pt idx="238">
                  <c:v>0.11786375189999999</c:v>
                </c:pt>
                <c:pt idx="239">
                  <c:v>0.1179445088</c:v>
                </c:pt>
                <c:pt idx="240">
                  <c:v>0.1180295572</c:v>
                </c:pt>
                <c:pt idx="241">
                  <c:v>0.1182552427</c:v>
                </c:pt>
                <c:pt idx="242">
                  <c:v>0.11816936729999999</c:v>
                </c:pt>
                <c:pt idx="243">
                  <c:v>0.11818560960000001</c:v>
                </c:pt>
                <c:pt idx="244">
                  <c:v>0.11835055799999999</c:v>
                </c:pt>
                <c:pt idx="245">
                  <c:v>0.1184678227</c:v>
                </c:pt>
                <c:pt idx="246">
                  <c:v>0.11861821259999999</c:v>
                </c:pt>
                <c:pt idx="247">
                  <c:v>0.11870621889999999</c:v>
                </c:pt>
                <c:pt idx="248">
                  <c:v>0.11894305049999999</c:v>
                </c:pt>
                <c:pt idx="249">
                  <c:v>0.1187155768</c:v>
                </c:pt>
                <c:pt idx="250">
                  <c:v>0.11890805510000001</c:v>
                </c:pt>
                <c:pt idx="251">
                  <c:v>0.1189594269</c:v>
                </c:pt>
                <c:pt idx="252">
                  <c:v>0.1190430447</c:v>
                </c:pt>
                <c:pt idx="253">
                  <c:v>0.11902186269999999</c:v>
                </c:pt>
                <c:pt idx="254">
                  <c:v>0.11928291620000001</c:v>
                </c:pt>
                <c:pt idx="255">
                  <c:v>0.1192784533</c:v>
                </c:pt>
                <c:pt idx="256">
                  <c:v>0.11938295509999999</c:v>
                </c:pt>
                <c:pt idx="257">
                  <c:v>0.119410485</c:v>
                </c:pt>
                <c:pt idx="258">
                  <c:v>0.11951096360000001</c:v>
                </c:pt>
                <c:pt idx="259">
                  <c:v>0.1195399016</c:v>
                </c:pt>
                <c:pt idx="260">
                  <c:v>0.1194116101</c:v>
                </c:pt>
                <c:pt idx="261">
                  <c:v>0.11946201319999999</c:v>
                </c:pt>
                <c:pt idx="262">
                  <c:v>0.1196197048</c:v>
                </c:pt>
                <c:pt idx="263">
                  <c:v>0.1195563972</c:v>
                </c:pt>
                <c:pt idx="264">
                  <c:v>0.1194924191</c:v>
                </c:pt>
                <c:pt idx="265">
                  <c:v>0.1196319163</c:v>
                </c:pt>
                <c:pt idx="266">
                  <c:v>0.1196441203</c:v>
                </c:pt>
                <c:pt idx="267">
                  <c:v>0.1196164712</c:v>
                </c:pt>
                <c:pt idx="268">
                  <c:v>0.11960388719999999</c:v>
                </c:pt>
                <c:pt idx="269">
                  <c:v>0.1197050214</c:v>
                </c:pt>
                <c:pt idx="270">
                  <c:v>0.11964268979999999</c:v>
                </c:pt>
                <c:pt idx="271">
                  <c:v>0.11964654180000001</c:v>
                </c:pt>
                <c:pt idx="272">
                  <c:v>0.1196706817</c:v>
                </c:pt>
                <c:pt idx="273">
                  <c:v>0.1195145398</c:v>
                </c:pt>
                <c:pt idx="274">
                  <c:v>0.1198368073</c:v>
                </c:pt>
                <c:pt idx="275">
                  <c:v>0.1196484193</c:v>
                </c:pt>
                <c:pt idx="276">
                  <c:v>0.11986461280000001</c:v>
                </c:pt>
                <c:pt idx="277">
                  <c:v>0.11999016999999999</c:v>
                </c:pt>
                <c:pt idx="278">
                  <c:v>0.1198400855</c:v>
                </c:pt>
                <c:pt idx="279">
                  <c:v>0.1197046116</c:v>
                </c:pt>
                <c:pt idx="280">
                  <c:v>0.1197891235</c:v>
                </c:pt>
                <c:pt idx="281">
                  <c:v>0.11970341950000001</c:v>
                </c:pt>
                <c:pt idx="282">
                  <c:v>0.1197888181</c:v>
                </c:pt>
                <c:pt idx="283">
                  <c:v>0.12001835550000001</c:v>
                </c:pt>
                <c:pt idx="284">
                  <c:v>0.1199223027</c:v>
                </c:pt>
                <c:pt idx="285">
                  <c:v>0.1199948788</c:v>
                </c:pt>
                <c:pt idx="286">
                  <c:v>0.1200900599</c:v>
                </c:pt>
                <c:pt idx="287">
                  <c:v>0.1202287897</c:v>
                </c:pt>
                <c:pt idx="288">
                  <c:v>0.120253101</c:v>
                </c:pt>
                <c:pt idx="289">
                  <c:v>0.12070249769999999</c:v>
                </c:pt>
                <c:pt idx="290">
                  <c:v>0.1208937764</c:v>
                </c:pt>
                <c:pt idx="291">
                  <c:v>0.12076717620000001</c:v>
                </c:pt>
                <c:pt idx="292">
                  <c:v>0.1209952757</c:v>
                </c:pt>
                <c:pt idx="293">
                  <c:v>0.12105113269999999</c:v>
                </c:pt>
                <c:pt idx="294">
                  <c:v>0.12114661929999999</c:v>
                </c:pt>
                <c:pt idx="295">
                  <c:v>0.1212660745</c:v>
                </c:pt>
                <c:pt idx="296">
                  <c:v>0.12139635529999999</c:v>
                </c:pt>
                <c:pt idx="297">
                  <c:v>0.1215650886</c:v>
                </c:pt>
                <c:pt idx="298">
                  <c:v>0.12160581350000001</c:v>
                </c:pt>
                <c:pt idx="299">
                  <c:v>0.12184149029999999</c:v>
                </c:pt>
                <c:pt idx="300">
                  <c:v>0.12197522819999999</c:v>
                </c:pt>
                <c:pt idx="301">
                  <c:v>0.1219196618</c:v>
                </c:pt>
                <c:pt idx="302">
                  <c:v>0.1222551838</c:v>
                </c:pt>
                <c:pt idx="303">
                  <c:v>0.12233439090000001</c:v>
                </c:pt>
                <c:pt idx="304">
                  <c:v>0.12251674379999999</c:v>
                </c:pt>
                <c:pt idx="305">
                  <c:v>0.12268935139999999</c:v>
                </c:pt>
                <c:pt idx="306">
                  <c:v>0.1228468791</c:v>
                </c:pt>
                <c:pt idx="307">
                  <c:v>0.1230490357</c:v>
                </c:pt>
                <c:pt idx="308">
                  <c:v>0.12328206</c:v>
                </c:pt>
                <c:pt idx="309">
                  <c:v>0.12330447880000001</c:v>
                </c:pt>
                <c:pt idx="310">
                  <c:v>0.1237053499</c:v>
                </c:pt>
                <c:pt idx="311">
                  <c:v>0.1238736808</c:v>
                </c:pt>
                <c:pt idx="312">
                  <c:v>0.1239855886</c:v>
                </c:pt>
                <c:pt idx="313">
                  <c:v>0.1241139621</c:v>
                </c:pt>
                <c:pt idx="314">
                  <c:v>0.1243921593</c:v>
                </c:pt>
                <c:pt idx="315">
                  <c:v>0.1244789362</c:v>
                </c:pt>
                <c:pt idx="316">
                  <c:v>0.1245314106</c:v>
                </c:pt>
                <c:pt idx="317">
                  <c:v>0.1249140576</c:v>
                </c:pt>
                <c:pt idx="318">
                  <c:v>0.1250881106</c:v>
                </c:pt>
                <c:pt idx="319">
                  <c:v>0.12527067959999999</c:v>
                </c:pt>
                <c:pt idx="320">
                  <c:v>0.1252517551</c:v>
                </c:pt>
                <c:pt idx="321">
                  <c:v>0.12560313940000001</c:v>
                </c:pt>
                <c:pt idx="322">
                  <c:v>0.1255739927</c:v>
                </c:pt>
                <c:pt idx="323">
                  <c:v>0.12563642859999999</c:v>
                </c:pt>
                <c:pt idx="324">
                  <c:v>0.1257533878</c:v>
                </c:pt>
                <c:pt idx="325">
                  <c:v>0.12586167449999999</c:v>
                </c:pt>
                <c:pt idx="326">
                  <c:v>0.1257941574</c:v>
                </c:pt>
                <c:pt idx="327">
                  <c:v>0.12594693900000001</c:v>
                </c:pt>
                <c:pt idx="328">
                  <c:v>0.12588353460000001</c:v>
                </c:pt>
                <c:pt idx="329">
                  <c:v>0.1259839982</c:v>
                </c:pt>
                <c:pt idx="330">
                  <c:v>0.12597991529999999</c:v>
                </c:pt>
                <c:pt idx="331">
                  <c:v>0.12611253559999999</c:v>
                </c:pt>
                <c:pt idx="332">
                  <c:v>0.12611140309999999</c:v>
                </c:pt>
                <c:pt idx="333">
                  <c:v>0.12629128989999999</c:v>
                </c:pt>
                <c:pt idx="334">
                  <c:v>0.12649069730000001</c:v>
                </c:pt>
                <c:pt idx="335">
                  <c:v>0.12648345529999999</c:v>
                </c:pt>
                <c:pt idx="336">
                  <c:v>0.12659950549999999</c:v>
                </c:pt>
                <c:pt idx="337">
                  <c:v>0.12654840949999999</c:v>
                </c:pt>
                <c:pt idx="338">
                  <c:v>0.12683634460000001</c:v>
                </c:pt>
                <c:pt idx="339">
                  <c:v>0.12707051629999999</c:v>
                </c:pt>
                <c:pt idx="340">
                  <c:v>0.1273003966</c:v>
                </c:pt>
                <c:pt idx="341">
                  <c:v>0.12729309499999999</c:v>
                </c:pt>
                <c:pt idx="342">
                  <c:v>0.1275859177</c:v>
                </c:pt>
                <c:pt idx="343">
                  <c:v>0.1276252568</c:v>
                </c:pt>
                <c:pt idx="344">
                  <c:v>0.1280175596</c:v>
                </c:pt>
                <c:pt idx="345">
                  <c:v>0.12817773220000001</c:v>
                </c:pt>
                <c:pt idx="346">
                  <c:v>0.1281317323</c:v>
                </c:pt>
                <c:pt idx="347">
                  <c:v>0.1284182519</c:v>
                </c:pt>
                <c:pt idx="348">
                  <c:v>0.12864233550000001</c:v>
                </c:pt>
                <c:pt idx="349">
                  <c:v>0.1287967414</c:v>
                </c:pt>
                <c:pt idx="350">
                  <c:v>0.1286162585</c:v>
                </c:pt>
                <c:pt idx="351">
                  <c:v>0.1288433075</c:v>
                </c:pt>
                <c:pt idx="352">
                  <c:v>0.1291675866</c:v>
                </c:pt>
                <c:pt idx="353">
                  <c:v>0.12908081709999999</c:v>
                </c:pt>
                <c:pt idx="354">
                  <c:v>0.1293373555</c:v>
                </c:pt>
                <c:pt idx="355">
                  <c:v>0.12943024929999999</c:v>
                </c:pt>
                <c:pt idx="356">
                  <c:v>0.12976114450000001</c:v>
                </c:pt>
                <c:pt idx="357">
                  <c:v>0.1300339401</c:v>
                </c:pt>
                <c:pt idx="358">
                  <c:v>0.13033741709999999</c:v>
                </c:pt>
                <c:pt idx="359">
                  <c:v>0.13073895869999999</c:v>
                </c:pt>
                <c:pt idx="360">
                  <c:v>0.13104607160000001</c:v>
                </c:pt>
                <c:pt idx="361">
                  <c:v>0.1313408315</c:v>
                </c:pt>
                <c:pt idx="362">
                  <c:v>0.1316635609</c:v>
                </c:pt>
                <c:pt idx="363">
                  <c:v>0.13183963300000001</c:v>
                </c:pt>
                <c:pt idx="364">
                  <c:v>0.1321284324</c:v>
                </c:pt>
                <c:pt idx="365">
                  <c:v>0.13229273259999999</c:v>
                </c:pt>
                <c:pt idx="366">
                  <c:v>0.13244850929999999</c:v>
                </c:pt>
                <c:pt idx="367">
                  <c:v>0.13275602459999999</c:v>
                </c:pt>
                <c:pt idx="368">
                  <c:v>0.1329520941</c:v>
                </c:pt>
                <c:pt idx="369">
                  <c:v>0.1331296116</c:v>
                </c:pt>
                <c:pt idx="370">
                  <c:v>0.13335761430000001</c:v>
                </c:pt>
                <c:pt idx="371">
                  <c:v>0.13364659249999999</c:v>
                </c:pt>
                <c:pt idx="372">
                  <c:v>0.13399848340000001</c:v>
                </c:pt>
                <c:pt idx="373">
                  <c:v>0.13417871300000001</c:v>
                </c:pt>
                <c:pt idx="374">
                  <c:v>0.13444276150000001</c:v>
                </c:pt>
                <c:pt idx="375">
                  <c:v>0.13488954310000001</c:v>
                </c:pt>
                <c:pt idx="376">
                  <c:v>0.13493238390000001</c:v>
                </c:pt>
                <c:pt idx="377">
                  <c:v>0.1351301372</c:v>
                </c:pt>
                <c:pt idx="378">
                  <c:v>0.13545323910000001</c:v>
                </c:pt>
                <c:pt idx="379">
                  <c:v>0.1357598901</c:v>
                </c:pt>
                <c:pt idx="380">
                  <c:v>0.1362049431</c:v>
                </c:pt>
                <c:pt idx="381">
                  <c:v>0.13659869129999999</c:v>
                </c:pt>
                <c:pt idx="382">
                  <c:v>0.1366248578</c:v>
                </c:pt>
                <c:pt idx="383">
                  <c:v>0.13692697879999999</c:v>
                </c:pt>
                <c:pt idx="384">
                  <c:v>0.13748648760000001</c:v>
                </c:pt>
                <c:pt idx="385">
                  <c:v>0.13773505389999999</c:v>
                </c:pt>
                <c:pt idx="386">
                  <c:v>0.1380275339</c:v>
                </c:pt>
                <c:pt idx="387">
                  <c:v>0.13830865919999999</c:v>
                </c:pt>
                <c:pt idx="388">
                  <c:v>0.13895727690000001</c:v>
                </c:pt>
                <c:pt idx="389">
                  <c:v>0.13929006460000001</c:v>
                </c:pt>
                <c:pt idx="390">
                  <c:v>0.1395151466</c:v>
                </c:pt>
                <c:pt idx="391">
                  <c:v>0.1397491843</c:v>
                </c:pt>
                <c:pt idx="392">
                  <c:v>0.14029319579999999</c:v>
                </c:pt>
                <c:pt idx="393">
                  <c:v>0.14066286389999999</c:v>
                </c:pt>
                <c:pt idx="394">
                  <c:v>0.14126510919999999</c:v>
                </c:pt>
                <c:pt idx="395">
                  <c:v>0.14142633969999999</c:v>
                </c:pt>
                <c:pt idx="396">
                  <c:v>0.1420349628</c:v>
                </c:pt>
                <c:pt idx="397">
                  <c:v>0.14239178599999999</c:v>
                </c:pt>
                <c:pt idx="398">
                  <c:v>0.14281733329999999</c:v>
                </c:pt>
                <c:pt idx="399">
                  <c:v>0.1431756169</c:v>
                </c:pt>
                <c:pt idx="400">
                  <c:v>0.14327338340000001</c:v>
                </c:pt>
                <c:pt idx="401">
                  <c:v>0.14371323590000001</c:v>
                </c:pt>
                <c:pt idx="402">
                  <c:v>0.14420264960000001</c:v>
                </c:pt>
                <c:pt idx="403">
                  <c:v>0.14454601710000001</c:v>
                </c:pt>
                <c:pt idx="404">
                  <c:v>0.145200789</c:v>
                </c:pt>
                <c:pt idx="405">
                  <c:v>0.14565958079999999</c:v>
                </c:pt>
                <c:pt idx="406">
                  <c:v>0.14611226320000001</c:v>
                </c:pt>
                <c:pt idx="407">
                  <c:v>0.14703792330000001</c:v>
                </c:pt>
                <c:pt idx="408">
                  <c:v>0.14735192059999999</c:v>
                </c:pt>
                <c:pt idx="409">
                  <c:v>0.14828114210000001</c:v>
                </c:pt>
                <c:pt idx="410">
                  <c:v>0.1484588385</c:v>
                </c:pt>
                <c:pt idx="411">
                  <c:v>0.14901530739999999</c:v>
                </c:pt>
                <c:pt idx="412">
                  <c:v>0.1495898813</c:v>
                </c:pt>
                <c:pt idx="413">
                  <c:v>0.1500589997</c:v>
                </c:pt>
                <c:pt idx="414">
                  <c:v>0.15057863299999999</c:v>
                </c:pt>
                <c:pt idx="415">
                  <c:v>0.1512032747</c:v>
                </c:pt>
                <c:pt idx="416">
                  <c:v>0.15150800349999999</c:v>
                </c:pt>
                <c:pt idx="417">
                  <c:v>0.15272392330000001</c:v>
                </c:pt>
                <c:pt idx="418">
                  <c:v>0.1525571644</c:v>
                </c:pt>
                <c:pt idx="419">
                  <c:v>0.15317128599999999</c:v>
                </c:pt>
                <c:pt idx="420">
                  <c:v>0.1535990089</c:v>
                </c:pt>
                <c:pt idx="421">
                  <c:v>0.1540080905</c:v>
                </c:pt>
                <c:pt idx="422">
                  <c:v>0.15448325869999999</c:v>
                </c:pt>
                <c:pt idx="423">
                  <c:v>0.15535639230000001</c:v>
                </c:pt>
                <c:pt idx="424">
                  <c:v>0.15633845330000001</c:v>
                </c:pt>
                <c:pt idx="425">
                  <c:v>0.1567823887</c:v>
                </c:pt>
                <c:pt idx="426">
                  <c:v>0.15718901160000001</c:v>
                </c:pt>
                <c:pt idx="427">
                  <c:v>0.15795333680000001</c:v>
                </c:pt>
                <c:pt idx="428">
                  <c:v>0.15850533550000001</c:v>
                </c:pt>
                <c:pt idx="429">
                  <c:v>0.15980347989999999</c:v>
                </c:pt>
                <c:pt idx="430">
                  <c:v>0.1589452177</c:v>
                </c:pt>
                <c:pt idx="431">
                  <c:v>0.15995988250000001</c:v>
                </c:pt>
                <c:pt idx="432">
                  <c:v>0.16655893620000001</c:v>
                </c:pt>
                <c:pt idx="433">
                  <c:v>0.16213874519999999</c:v>
                </c:pt>
                <c:pt idx="434">
                  <c:v>0.1618992537</c:v>
                </c:pt>
                <c:pt idx="435">
                  <c:v>0.1628516018</c:v>
                </c:pt>
                <c:pt idx="436">
                  <c:v>0.1636084616</c:v>
                </c:pt>
                <c:pt idx="437">
                  <c:v>0.1645662487</c:v>
                </c:pt>
                <c:pt idx="438">
                  <c:v>0.16474899649999999</c:v>
                </c:pt>
                <c:pt idx="439">
                  <c:v>0.1665675938</c:v>
                </c:pt>
                <c:pt idx="440">
                  <c:v>0.16562017800000001</c:v>
                </c:pt>
                <c:pt idx="441">
                  <c:v>0.1669499129</c:v>
                </c:pt>
                <c:pt idx="442">
                  <c:v>0.16759300229999999</c:v>
                </c:pt>
                <c:pt idx="443">
                  <c:v>0.16786548500000001</c:v>
                </c:pt>
                <c:pt idx="444">
                  <c:v>0.1696207374</c:v>
                </c:pt>
                <c:pt idx="445">
                  <c:v>0.168937698</c:v>
                </c:pt>
                <c:pt idx="446">
                  <c:v>0.16927792129999999</c:v>
                </c:pt>
                <c:pt idx="447">
                  <c:v>0.17042919989999999</c:v>
                </c:pt>
                <c:pt idx="448">
                  <c:v>0.17245152590000001</c:v>
                </c:pt>
                <c:pt idx="449">
                  <c:v>0.17128969729999999</c:v>
                </c:pt>
                <c:pt idx="450">
                  <c:v>0.17191317680000001</c:v>
                </c:pt>
                <c:pt idx="451">
                  <c:v>0.17425842580000001</c:v>
                </c:pt>
                <c:pt idx="452">
                  <c:v>0.18545271460000001</c:v>
                </c:pt>
                <c:pt idx="453">
                  <c:v>0.1866233051</c:v>
                </c:pt>
                <c:pt idx="454">
                  <c:v>0.18803040679999999</c:v>
                </c:pt>
                <c:pt idx="455">
                  <c:v>0.18921731410000001</c:v>
                </c:pt>
                <c:pt idx="456">
                  <c:v>0.1905640811</c:v>
                </c:pt>
                <c:pt idx="457">
                  <c:v>0.19203442339999999</c:v>
                </c:pt>
                <c:pt idx="458">
                  <c:v>0.19260977209999999</c:v>
                </c:pt>
                <c:pt idx="459">
                  <c:v>0.1950124651</c:v>
                </c:pt>
                <c:pt idx="460">
                  <c:v>0.19598312679999999</c:v>
                </c:pt>
                <c:pt idx="461">
                  <c:v>0.1973337084</c:v>
                </c:pt>
                <c:pt idx="462">
                  <c:v>0.19885042310000001</c:v>
                </c:pt>
                <c:pt idx="463">
                  <c:v>0.2004277706</c:v>
                </c:pt>
                <c:pt idx="464">
                  <c:v>0.20207089189999999</c:v>
                </c:pt>
                <c:pt idx="465">
                  <c:v>0.2034121901</c:v>
                </c:pt>
                <c:pt idx="466">
                  <c:v>0.2049536109</c:v>
                </c:pt>
                <c:pt idx="467">
                  <c:v>0.2065421194</c:v>
                </c:pt>
                <c:pt idx="468">
                  <c:v>0.20828486979999999</c:v>
                </c:pt>
                <c:pt idx="469">
                  <c:v>0.2099231631</c:v>
                </c:pt>
                <c:pt idx="470">
                  <c:v>0.21203280990000001</c:v>
                </c:pt>
                <c:pt idx="471">
                  <c:v>0.21366667750000001</c:v>
                </c:pt>
                <c:pt idx="472">
                  <c:v>0.21556591990000001</c:v>
                </c:pt>
                <c:pt idx="473">
                  <c:v>0.2179510593</c:v>
                </c:pt>
                <c:pt idx="474">
                  <c:v>0.22050641479999999</c:v>
                </c:pt>
                <c:pt idx="475">
                  <c:v>0.22161138059999999</c:v>
                </c:pt>
                <c:pt idx="476">
                  <c:v>0.2245521992</c:v>
                </c:pt>
                <c:pt idx="477">
                  <c:v>0.226878792</c:v>
                </c:pt>
                <c:pt idx="478">
                  <c:v>0.2292551696</c:v>
                </c:pt>
                <c:pt idx="479">
                  <c:v>0.23166751860000001</c:v>
                </c:pt>
                <c:pt idx="480">
                  <c:v>0.23424166439999999</c:v>
                </c:pt>
                <c:pt idx="481">
                  <c:v>0.23763307929999999</c:v>
                </c:pt>
                <c:pt idx="482">
                  <c:v>0.240153119</c:v>
                </c:pt>
                <c:pt idx="483">
                  <c:v>0.24346111710000001</c:v>
                </c:pt>
                <c:pt idx="484">
                  <c:v>0.2462428659</c:v>
                </c:pt>
                <c:pt idx="485">
                  <c:v>0.25042241809999999</c:v>
                </c:pt>
                <c:pt idx="486">
                  <c:v>0.253786236</c:v>
                </c:pt>
                <c:pt idx="487">
                  <c:v>0.2572922111</c:v>
                </c:pt>
                <c:pt idx="488">
                  <c:v>0.26131516700000001</c:v>
                </c:pt>
                <c:pt idx="489">
                  <c:v>0.26529949899999999</c:v>
                </c:pt>
                <c:pt idx="490">
                  <c:v>0.26906105879999997</c:v>
                </c:pt>
                <c:pt idx="491">
                  <c:v>0.27349790930000001</c:v>
                </c:pt>
                <c:pt idx="492">
                  <c:v>0.27997049689999998</c:v>
                </c:pt>
                <c:pt idx="493">
                  <c:v>0.28443965319999998</c:v>
                </c:pt>
                <c:pt idx="494">
                  <c:v>0.28965923189999998</c:v>
                </c:pt>
                <c:pt idx="495">
                  <c:v>0.29568678139999999</c:v>
                </c:pt>
                <c:pt idx="496">
                  <c:v>0.30178043249999997</c:v>
                </c:pt>
                <c:pt idx="497">
                  <c:v>0.30880776049999997</c:v>
                </c:pt>
                <c:pt idx="498">
                  <c:v>0.31704029439999998</c:v>
                </c:pt>
                <c:pt idx="499">
                  <c:v>0.32682254910000003</c:v>
                </c:pt>
                <c:pt idx="500">
                  <c:v>0.33654600379999999</c:v>
                </c:pt>
                <c:pt idx="501">
                  <c:v>0.34818077089999999</c:v>
                </c:pt>
                <c:pt idx="502">
                  <c:v>0.3603971601</c:v>
                </c:pt>
                <c:pt idx="503">
                  <c:v>0.37220475079999998</c:v>
                </c:pt>
                <c:pt idx="504">
                  <c:v>0.38266891240000001</c:v>
                </c:pt>
                <c:pt idx="505">
                  <c:v>0.39201590419999999</c:v>
                </c:pt>
                <c:pt idx="506">
                  <c:v>0.39960923790000002</c:v>
                </c:pt>
                <c:pt idx="507">
                  <c:v>0.40496233110000002</c:v>
                </c:pt>
                <c:pt idx="508">
                  <c:v>0.40989640360000001</c:v>
                </c:pt>
                <c:pt idx="509">
                  <c:v>0.41480720040000002</c:v>
                </c:pt>
                <c:pt idx="510">
                  <c:v>0.41993960740000003</c:v>
                </c:pt>
                <c:pt idx="511">
                  <c:v>0.42536702749999999</c:v>
                </c:pt>
                <c:pt idx="512">
                  <c:v>0.43097227809999999</c:v>
                </c:pt>
                <c:pt idx="513">
                  <c:v>0.43680259589999998</c:v>
                </c:pt>
                <c:pt idx="514">
                  <c:v>0.44233080740000003</c:v>
                </c:pt>
                <c:pt idx="515">
                  <c:v>0.44818678499999998</c:v>
                </c:pt>
                <c:pt idx="516">
                  <c:v>0.4527114928</c:v>
                </c:pt>
                <c:pt idx="517">
                  <c:v>0.45734533669999999</c:v>
                </c:pt>
                <c:pt idx="518">
                  <c:v>0.46196416019999997</c:v>
                </c:pt>
                <c:pt idx="519">
                  <c:v>0.46728569269999998</c:v>
                </c:pt>
                <c:pt idx="520">
                  <c:v>0.47380632160000002</c:v>
                </c:pt>
                <c:pt idx="521">
                  <c:v>0.48126292230000001</c:v>
                </c:pt>
                <c:pt idx="522">
                  <c:v>0.4891188145</c:v>
                </c:pt>
                <c:pt idx="523">
                  <c:v>0.49716472630000003</c:v>
                </c:pt>
                <c:pt idx="524">
                  <c:v>0.50402766470000004</c:v>
                </c:pt>
                <c:pt idx="525">
                  <c:v>0.51051402089999998</c:v>
                </c:pt>
                <c:pt idx="526">
                  <c:v>0.51547241210000005</c:v>
                </c:pt>
                <c:pt idx="527">
                  <c:v>0.52011770010000002</c:v>
                </c:pt>
                <c:pt idx="528">
                  <c:v>0.52528762819999997</c:v>
                </c:pt>
                <c:pt idx="529">
                  <c:v>0.53125357630000003</c:v>
                </c:pt>
                <c:pt idx="530">
                  <c:v>0.53859877590000005</c:v>
                </c:pt>
                <c:pt idx="531">
                  <c:v>0.54736185069999999</c:v>
                </c:pt>
                <c:pt idx="532">
                  <c:v>0.557767868</c:v>
                </c:pt>
                <c:pt idx="533">
                  <c:v>0.56940972810000001</c:v>
                </c:pt>
                <c:pt idx="534">
                  <c:v>0.58134037260000004</c:v>
                </c:pt>
                <c:pt idx="535">
                  <c:v>0.59446960689999995</c:v>
                </c:pt>
                <c:pt idx="536">
                  <c:v>0.60829955339999997</c:v>
                </c:pt>
                <c:pt idx="537">
                  <c:v>0.62296462060000002</c:v>
                </c:pt>
                <c:pt idx="538">
                  <c:v>0.63955861329999997</c:v>
                </c:pt>
                <c:pt idx="539">
                  <c:v>0.65701925750000001</c:v>
                </c:pt>
                <c:pt idx="540">
                  <c:v>0.67556059359999998</c:v>
                </c:pt>
                <c:pt idx="541">
                  <c:v>0.69538211819999995</c:v>
                </c:pt>
                <c:pt idx="542">
                  <c:v>0.71582436559999996</c:v>
                </c:pt>
                <c:pt idx="543">
                  <c:v>0.73747825619999996</c:v>
                </c:pt>
                <c:pt idx="544">
                  <c:v>0.75965893269999996</c:v>
                </c:pt>
                <c:pt idx="545">
                  <c:v>0.78229749199999998</c:v>
                </c:pt>
                <c:pt idx="546">
                  <c:v>0.80528908970000002</c:v>
                </c:pt>
                <c:pt idx="547">
                  <c:v>0.82875502109999999</c:v>
                </c:pt>
                <c:pt idx="548">
                  <c:v>0.85228437189999995</c:v>
                </c:pt>
                <c:pt idx="549">
                  <c:v>0.87578427790000002</c:v>
                </c:pt>
                <c:pt idx="550">
                  <c:v>0.89942330120000002</c:v>
                </c:pt>
                <c:pt idx="551">
                  <c:v>0.92252838609999999</c:v>
                </c:pt>
                <c:pt idx="552">
                  <c:v>0.94598150250000002</c:v>
                </c:pt>
                <c:pt idx="553">
                  <c:v>0.96865361930000005</c:v>
                </c:pt>
                <c:pt idx="554">
                  <c:v>0.99102437499999996</c:v>
                </c:pt>
                <c:pt idx="555">
                  <c:v>1.0138331650000001</c:v>
                </c:pt>
                <c:pt idx="556">
                  <c:v>1.0372834209999999</c:v>
                </c:pt>
                <c:pt idx="557">
                  <c:v>1.0608415600000001</c:v>
                </c:pt>
                <c:pt idx="558">
                  <c:v>1.0857485529999999</c:v>
                </c:pt>
                <c:pt idx="559">
                  <c:v>1.112089396</c:v>
                </c:pt>
                <c:pt idx="560">
                  <c:v>1.1397080420000001</c:v>
                </c:pt>
                <c:pt idx="561">
                  <c:v>1.170038819</c:v>
                </c:pt>
                <c:pt idx="562">
                  <c:v>1.203736782</c:v>
                </c:pt>
                <c:pt idx="563">
                  <c:v>1.242291689</c:v>
                </c:pt>
                <c:pt idx="564">
                  <c:v>1.2901600600000001</c:v>
                </c:pt>
                <c:pt idx="565">
                  <c:v>1.3503240350000001</c:v>
                </c:pt>
                <c:pt idx="566">
                  <c:v>1.430019259</c:v>
                </c:pt>
                <c:pt idx="567">
                  <c:v>1.534238338</c:v>
                </c:pt>
                <c:pt idx="568">
                  <c:v>1.6737504009999999</c:v>
                </c:pt>
                <c:pt idx="569">
                  <c:v>1.855582356</c:v>
                </c:pt>
                <c:pt idx="570">
                  <c:v>2.0911190510000002</c:v>
                </c:pt>
                <c:pt idx="571">
                  <c:v>2.386791229</c:v>
                </c:pt>
                <c:pt idx="572">
                  <c:v>2.735786676</c:v>
                </c:pt>
                <c:pt idx="573">
                  <c:v>3.081529856</c:v>
                </c:pt>
                <c:pt idx="574">
                  <c:v>3.3297531600000001</c:v>
                </c:pt>
                <c:pt idx="575">
                  <c:v>3.4335193629999998</c:v>
                </c:pt>
                <c:pt idx="576">
                  <c:v>3.4731695650000001</c:v>
                </c:pt>
                <c:pt idx="577">
                  <c:v>3.487226486</c:v>
                </c:pt>
                <c:pt idx="578">
                  <c:v>3.4987709520000001</c:v>
                </c:pt>
                <c:pt idx="579">
                  <c:v>3.5145914550000001</c:v>
                </c:pt>
                <c:pt idx="580">
                  <c:v>3.533642054</c:v>
                </c:pt>
                <c:pt idx="581">
                  <c:v>3.531533241</c:v>
                </c:pt>
                <c:pt idx="582">
                  <c:v>3.5272810460000001</c:v>
                </c:pt>
                <c:pt idx="583">
                  <c:v>3.53483963</c:v>
                </c:pt>
                <c:pt idx="584">
                  <c:v>3.5246710779999999</c:v>
                </c:pt>
                <c:pt idx="585">
                  <c:v>3.5122208600000002</c:v>
                </c:pt>
                <c:pt idx="586">
                  <c:v>3.4876775740000001</c:v>
                </c:pt>
                <c:pt idx="587">
                  <c:v>3.4721474649999999</c:v>
                </c:pt>
                <c:pt idx="588">
                  <c:v>3.4661290650000001</c:v>
                </c:pt>
                <c:pt idx="589">
                  <c:v>3.4610538480000002</c:v>
                </c:pt>
                <c:pt idx="590">
                  <c:v>3.4496896270000001</c:v>
                </c:pt>
                <c:pt idx="591">
                  <c:v>3.4364550110000001</c:v>
                </c:pt>
                <c:pt idx="592">
                  <c:v>3.4223876</c:v>
                </c:pt>
                <c:pt idx="593">
                  <c:v>3.4026563169999999</c:v>
                </c:pt>
                <c:pt idx="594">
                  <c:v>3.3857853410000001</c:v>
                </c:pt>
                <c:pt idx="595">
                  <c:v>3.3608765599999999</c:v>
                </c:pt>
                <c:pt idx="596">
                  <c:v>3.3712134360000001</c:v>
                </c:pt>
                <c:pt idx="597">
                  <c:v>3.354240656</c:v>
                </c:pt>
                <c:pt idx="598">
                  <c:v>3.3368754389999999</c:v>
                </c:pt>
                <c:pt idx="599">
                  <c:v>3.310289145</c:v>
                </c:pt>
                <c:pt idx="600">
                  <c:v>3.292909144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B66-D147-9B42-675919F5047A}"/>
            </c:ext>
          </c:extLst>
        </c:ser>
        <c:ser>
          <c:idx val="1"/>
          <c:order val="1"/>
          <c:spPr>
            <a:ln w="19050" cap="rnd">
              <a:solidFill>
                <a:srgbClr val="A2FC80"/>
              </a:solidFill>
              <a:round/>
            </a:ln>
            <a:effectLst/>
          </c:spPr>
          <c:marker>
            <c:symbol val="none"/>
          </c:marker>
          <c:xVal>
            <c:numRef>
              <c:f>'[Chart in Microsoft PowerPoint]Sheet1'!$A$6:$A$606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[Chart in Microsoft PowerPoint]Sheet1'!$C$6:$C$606</c:f>
              <c:numCache>
                <c:formatCode>General</c:formatCode>
                <c:ptCount val="601"/>
                <c:pt idx="0">
                  <c:v>0.1198201254</c:v>
                </c:pt>
                <c:pt idx="1">
                  <c:v>0.1208056659</c:v>
                </c:pt>
                <c:pt idx="2">
                  <c:v>0.1209315285</c:v>
                </c:pt>
                <c:pt idx="3">
                  <c:v>0.1210813075</c:v>
                </c:pt>
                <c:pt idx="4">
                  <c:v>0.12112670389999999</c:v>
                </c:pt>
                <c:pt idx="5">
                  <c:v>0.1211285517</c:v>
                </c:pt>
                <c:pt idx="6">
                  <c:v>0.12132203580000001</c:v>
                </c:pt>
                <c:pt idx="7">
                  <c:v>0.1215081438</c:v>
                </c:pt>
                <c:pt idx="8">
                  <c:v>0.12167599799999999</c:v>
                </c:pt>
                <c:pt idx="9">
                  <c:v>0.1219718382</c:v>
                </c:pt>
                <c:pt idx="10">
                  <c:v>0.1220216826</c:v>
                </c:pt>
                <c:pt idx="11">
                  <c:v>0.122276485</c:v>
                </c:pt>
                <c:pt idx="12">
                  <c:v>0.1223111972</c:v>
                </c:pt>
                <c:pt idx="13">
                  <c:v>0.1225471199</c:v>
                </c:pt>
                <c:pt idx="14">
                  <c:v>0.122571215</c:v>
                </c:pt>
                <c:pt idx="15">
                  <c:v>0.1227964908</c:v>
                </c:pt>
                <c:pt idx="16">
                  <c:v>0.1229057908</c:v>
                </c:pt>
                <c:pt idx="17">
                  <c:v>0.1231953204</c:v>
                </c:pt>
                <c:pt idx="18">
                  <c:v>0.1234164163</c:v>
                </c:pt>
                <c:pt idx="19">
                  <c:v>0.1234323755</c:v>
                </c:pt>
                <c:pt idx="20">
                  <c:v>0.12351296840000001</c:v>
                </c:pt>
                <c:pt idx="21">
                  <c:v>0.1235651225</c:v>
                </c:pt>
                <c:pt idx="22">
                  <c:v>0.1238301992</c:v>
                </c:pt>
                <c:pt idx="23">
                  <c:v>0.1241878271</c:v>
                </c:pt>
                <c:pt idx="24">
                  <c:v>0.1243855804</c:v>
                </c:pt>
                <c:pt idx="25">
                  <c:v>0.1244381517</c:v>
                </c:pt>
                <c:pt idx="26">
                  <c:v>0.12450627979999999</c:v>
                </c:pt>
                <c:pt idx="27">
                  <c:v>0.12470906969999999</c:v>
                </c:pt>
                <c:pt idx="28">
                  <c:v>0.1247486696</c:v>
                </c:pt>
                <c:pt idx="29">
                  <c:v>0.124905847</c:v>
                </c:pt>
                <c:pt idx="30">
                  <c:v>0.12512533370000001</c:v>
                </c:pt>
                <c:pt idx="31">
                  <c:v>0.12529192859999999</c:v>
                </c:pt>
                <c:pt idx="32">
                  <c:v>0.12541529539999999</c:v>
                </c:pt>
                <c:pt idx="33">
                  <c:v>0.12533238529999999</c:v>
                </c:pt>
                <c:pt idx="34">
                  <c:v>0.12568226460000001</c:v>
                </c:pt>
                <c:pt idx="35">
                  <c:v>0.1257552505</c:v>
                </c:pt>
                <c:pt idx="36">
                  <c:v>0.1257461309</c:v>
                </c:pt>
                <c:pt idx="37">
                  <c:v>0.12601658700000001</c:v>
                </c:pt>
                <c:pt idx="38">
                  <c:v>0.12598603959999999</c:v>
                </c:pt>
                <c:pt idx="39">
                  <c:v>0.1261911094</c:v>
                </c:pt>
                <c:pt idx="40">
                  <c:v>0.12599889929999999</c:v>
                </c:pt>
                <c:pt idx="41">
                  <c:v>0.1263086796</c:v>
                </c:pt>
                <c:pt idx="42">
                  <c:v>0.12666478749999999</c:v>
                </c:pt>
                <c:pt idx="43">
                  <c:v>0.12663759290000001</c:v>
                </c:pt>
                <c:pt idx="44">
                  <c:v>0.12682522830000001</c:v>
                </c:pt>
                <c:pt idx="45">
                  <c:v>0.12695571780000001</c:v>
                </c:pt>
                <c:pt idx="46">
                  <c:v>0.1270933598</c:v>
                </c:pt>
                <c:pt idx="47">
                  <c:v>0.1270141155</c:v>
                </c:pt>
                <c:pt idx="48">
                  <c:v>0.1273695976</c:v>
                </c:pt>
                <c:pt idx="49">
                  <c:v>0.12736497820000001</c:v>
                </c:pt>
                <c:pt idx="50">
                  <c:v>0.1275032461</c:v>
                </c:pt>
                <c:pt idx="51">
                  <c:v>0.1275632381</c:v>
                </c:pt>
                <c:pt idx="52">
                  <c:v>0.1278487593</c:v>
                </c:pt>
                <c:pt idx="53">
                  <c:v>0.12785546480000001</c:v>
                </c:pt>
                <c:pt idx="54">
                  <c:v>0.1281007528</c:v>
                </c:pt>
                <c:pt idx="55">
                  <c:v>0.1281532198</c:v>
                </c:pt>
                <c:pt idx="56">
                  <c:v>0.12811726330000001</c:v>
                </c:pt>
                <c:pt idx="57">
                  <c:v>0.12841613590000001</c:v>
                </c:pt>
                <c:pt idx="58">
                  <c:v>0.12857967619999999</c:v>
                </c:pt>
                <c:pt idx="59">
                  <c:v>0.12869076430000001</c:v>
                </c:pt>
                <c:pt idx="60">
                  <c:v>0.12854766849999999</c:v>
                </c:pt>
                <c:pt idx="61">
                  <c:v>0.12869232890000001</c:v>
                </c:pt>
                <c:pt idx="62">
                  <c:v>0.12875120340000001</c:v>
                </c:pt>
                <c:pt idx="63">
                  <c:v>0.12868553399999999</c:v>
                </c:pt>
                <c:pt idx="64">
                  <c:v>0.128534019</c:v>
                </c:pt>
                <c:pt idx="65">
                  <c:v>0.1282609552</c:v>
                </c:pt>
                <c:pt idx="66">
                  <c:v>0.1281511337</c:v>
                </c:pt>
                <c:pt idx="67">
                  <c:v>0.12794557209999999</c:v>
                </c:pt>
                <c:pt idx="68">
                  <c:v>0.12744808199999999</c:v>
                </c:pt>
                <c:pt idx="69">
                  <c:v>0.12723696230000001</c:v>
                </c:pt>
                <c:pt idx="70">
                  <c:v>0.1269141436</c:v>
                </c:pt>
                <c:pt idx="71">
                  <c:v>0.12653867899999999</c:v>
                </c:pt>
                <c:pt idx="72">
                  <c:v>0.1262004524</c:v>
                </c:pt>
                <c:pt idx="73">
                  <c:v>0.12612538039999999</c:v>
                </c:pt>
                <c:pt idx="74">
                  <c:v>0.12569837270000001</c:v>
                </c:pt>
                <c:pt idx="75">
                  <c:v>0.12557482719999999</c:v>
                </c:pt>
                <c:pt idx="76">
                  <c:v>0.1255642176</c:v>
                </c:pt>
                <c:pt idx="77">
                  <c:v>0.12521356340000001</c:v>
                </c:pt>
                <c:pt idx="78">
                  <c:v>0.1251041591</c:v>
                </c:pt>
                <c:pt idx="79">
                  <c:v>0.1248131916</c:v>
                </c:pt>
                <c:pt idx="80">
                  <c:v>0.1245310679</c:v>
                </c:pt>
                <c:pt idx="81">
                  <c:v>0.1243946105</c:v>
                </c:pt>
                <c:pt idx="82">
                  <c:v>0.1233863533</c:v>
                </c:pt>
                <c:pt idx="83">
                  <c:v>0.1239600033</c:v>
                </c:pt>
                <c:pt idx="84">
                  <c:v>0.1237985939</c:v>
                </c:pt>
                <c:pt idx="85">
                  <c:v>0.1234685928</c:v>
                </c:pt>
                <c:pt idx="86">
                  <c:v>0.1231462285</c:v>
                </c:pt>
                <c:pt idx="87">
                  <c:v>0.1227549762</c:v>
                </c:pt>
                <c:pt idx="88">
                  <c:v>0.122608155</c:v>
                </c:pt>
                <c:pt idx="89">
                  <c:v>0.1225486994</c:v>
                </c:pt>
                <c:pt idx="90">
                  <c:v>0.12216336279999999</c:v>
                </c:pt>
                <c:pt idx="91">
                  <c:v>0.1219809204</c:v>
                </c:pt>
                <c:pt idx="92">
                  <c:v>0.1218293905</c:v>
                </c:pt>
                <c:pt idx="93">
                  <c:v>0.1217138544</c:v>
                </c:pt>
                <c:pt idx="94">
                  <c:v>0.1215568408</c:v>
                </c:pt>
                <c:pt idx="95">
                  <c:v>0.1215202287</c:v>
                </c:pt>
                <c:pt idx="96">
                  <c:v>0.1214587986</c:v>
                </c:pt>
                <c:pt idx="97">
                  <c:v>0.12141127879999999</c:v>
                </c:pt>
                <c:pt idx="98">
                  <c:v>0.121262446</c:v>
                </c:pt>
                <c:pt idx="99">
                  <c:v>0.1212600172</c:v>
                </c:pt>
                <c:pt idx="100">
                  <c:v>0.12118182330000001</c:v>
                </c:pt>
                <c:pt idx="101">
                  <c:v>0.1210867092</c:v>
                </c:pt>
                <c:pt idx="102">
                  <c:v>0.1210805178</c:v>
                </c:pt>
                <c:pt idx="103">
                  <c:v>0.1210611239</c:v>
                </c:pt>
                <c:pt idx="104">
                  <c:v>0.1211248264</c:v>
                </c:pt>
                <c:pt idx="105">
                  <c:v>0.1210681051</c:v>
                </c:pt>
                <c:pt idx="106">
                  <c:v>0.12121118610000001</c:v>
                </c:pt>
                <c:pt idx="107">
                  <c:v>0.1210710108</c:v>
                </c:pt>
                <c:pt idx="108">
                  <c:v>0.1210701913</c:v>
                </c:pt>
                <c:pt idx="109">
                  <c:v>0.1212284341</c:v>
                </c:pt>
                <c:pt idx="110">
                  <c:v>0.1213669777</c:v>
                </c:pt>
                <c:pt idx="111">
                  <c:v>0.12125779690000001</c:v>
                </c:pt>
                <c:pt idx="112">
                  <c:v>0.1212815121</c:v>
                </c:pt>
                <c:pt idx="113">
                  <c:v>0.1213881373</c:v>
                </c:pt>
                <c:pt idx="114">
                  <c:v>0.1213239208</c:v>
                </c:pt>
                <c:pt idx="115">
                  <c:v>0.12145489449999999</c:v>
                </c:pt>
                <c:pt idx="116">
                  <c:v>0.1216029748</c:v>
                </c:pt>
                <c:pt idx="117">
                  <c:v>0.12153711170000001</c:v>
                </c:pt>
                <c:pt idx="118">
                  <c:v>0.1217835471</c:v>
                </c:pt>
                <c:pt idx="119">
                  <c:v>0.1215523854</c:v>
                </c:pt>
                <c:pt idx="120">
                  <c:v>0.12175578619999999</c:v>
                </c:pt>
                <c:pt idx="121">
                  <c:v>0.1218278483</c:v>
                </c:pt>
                <c:pt idx="122">
                  <c:v>0.1217630878</c:v>
                </c:pt>
                <c:pt idx="123">
                  <c:v>0.1219097227</c:v>
                </c:pt>
                <c:pt idx="124">
                  <c:v>0.1219928116</c:v>
                </c:pt>
                <c:pt idx="125">
                  <c:v>0.12196134779999999</c:v>
                </c:pt>
                <c:pt idx="126">
                  <c:v>0.12202935669999999</c:v>
                </c:pt>
                <c:pt idx="127">
                  <c:v>0.1221186444</c:v>
                </c:pt>
                <c:pt idx="128">
                  <c:v>0.12207335229999999</c:v>
                </c:pt>
                <c:pt idx="129">
                  <c:v>0.12224269660000001</c:v>
                </c:pt>
                <c:pt idx="130">
                  <c:v>0.12229325620000001</c:v>
                </c:pt>
                <c:pt idx="131">
                  <c:v>0.1223613918</c:v>
                </c:pt>
                <c:pt idx="132">
                  <c:v>0.1227669567</c:v>
                </c:pt>
                <c:pt idx="133">
                  <c:v>0.1231020987</c:v>
                </c:pt>
                <c:pt idx="134">
                  <c:v>0.12302831559999999</c:v>
                </c:pt>
                <c:pt idx="135">
                  <c:v>0.1229238287</c:v>
                </c:pt>
                <c:pt idx="136">
                  <c:v>0.1231987178</c:v>
                </c:pt>
                <c:pt idx="137">
                  <c:v>0.1232076958</c:v>
                </c:pt>
                <c:pt idx="138">
                  <c:v>0.1233547181</c:v>
                </c:pt>
                <c:pt idx="139">
                  <c:v>0.1232635975</c:v>
                </c:pt>
                <c:pt idx="140">
                  <c:v>0.1233330145</c:v>
                </c:pt>
                <c:pt idx="141">
                  <c:v>0.1233567074</c:v>
                </c:pt>
                <c:pt idx="142">
                  <c:v>0.1234382913</c:v>
                </c:pt>
                <c:pt idx="143">
                  <c:v>0.1235282794</c:v>
                </c:pt>
                <c:pt idx="144">
                  <c:v>0.1231468171</c:v>
                </c:pt>
                <c:pt idx="145">
                  <c:v>0.1234647036</c:v>
                </c:pt>
                <c:pt idx="146">
                  <c:v>0.12356437000000001</c:v>
                </c:pt>
                <c:pt idx="147">
                  <c:v>0.1235845312</c:v>
                </c:pt>
                <c:pt idx="148">
                  <c:v>0.123705484</c:v>
                </c:pt>
                <c:pt idx="149">
                  <c:v>0.1237508506</c:v>
                </c:pt>
                <c:pt idx="150">
                  <c:v>0.1238473058</c:v>
                </c:pt>
                <c:pt idx="151">
                  <c:v>0.12377762790000001</c:v>
                </c:pt>
                <c:pt idx="152">
                  <c:v>0.1237943918</c:v>
                </c:pt>
                <c:pt idx="153">
                  <c:v>0.1241249889</c:v>
                </c:pt>
                <c:pt idx="154">
                  <c:v>0.1240626425</c:v>
                </c:pt>
                <c:pt idx="155">
                  <c:v>0.1241542026</c:v>
                </c:pt>
                <c:pt idx="156">
                  <c:v>0.1241525859</c:v>
                </c:pt>
                <c:pt idx="157">
                  <c:v>0.1243327707</c:v>
                </c:pt>
                <c:pt idx="158">
                  <c:v>0.12442001699999999</c:v>
                </c:pt>
                <c:pt idx="159">
                  <c:v>0.12433446200000001</c:v>
                </c:pt>
                <c:pt idx="160">
                  <c:v>0.1244812459</c:v>
                </c:pt>
                <c:pt idx="161">
                  <c:v>0.1244630441</c:v>
                </c:pt>
                <c:pt idx="162">
                  <c:v>0.1245221049</c:v>
                </c:pt>
                <c:pt idx="163">
                  <c:v>0.1245497242</c:v>
                </c:pt>
                <c:pt idx="164">
                  <c:v>0.1247922108</c:v>
                </c:pt>
                <c:pt idx="165">
                  <c:v>0.12475960699999999</c:v>
                </c:pt>
                <c:pt idx="166">
                  <c:v>0.12471758569999999</c:v>
                </c:pt>
                <c:pt idx="167">
                  <c:v>0.12503030900000001</c:v>
                </c:pt>
                <c:pt idx="168">
                  <c:v>0.12510764599999999</c:v>
                </c:pt>
                <c:pt idx="169">
                  <c:v>0.12499161809999999</c:v>
                </c:pt>
                <c:pt idx="170">
                  <c:v>0.1250226498</c:v>
                </c:pt>
                <c:pt idx="171">
                  <c:v>0.1252153516</c:v>
                </c:pt>
                <c:pt idx="172">
                  <c:v>0.12535688280000001</c:v>
                </c:pt>
                <c:pt idx="173">
                  <c:v>0.12526816130000001</c:v>
                </c:pt>
                <c:pt idx="174">
                  <c:v>0.1254376173</c:v>
                </c:pt>
                <c:pt idx="175">
                  <c:v>0.12549187240000001</c:v>
                </c:pt>
                <c:pt idx="176">
                  <c:v>0.1256757379</c:v>
                </c:pt>
                <c:pt idx="177">
                  <c:v>0.1255871952</c:v>
                </c:pt>
                <c:pt idx="178">
                  <c:v>0.1255898178</c:v>
                </c:pt>
                <c:pt idx="179">
                  <c:v>0.1257226467</c:v>
                </c:pt>
                <c:pt idx="180">
                  <c:v>0.12583240870000001</c:v>
                </c:pt>
                <c:pt idx="181">
                  <c:v>0.125823766</c:v>
                </c:pt>
                <c:pt idx="182">
                  <c:v>0.1259661466</c:v>
                </c:pt>
                <c:pt idx="183">
                  <c:v>0.12599481639999999</c:v>
                </c:pt>
                <c:pt idx="184">
                  <c:v>0.12609904999999999</c:v>
                </c:pt>
                <c:pt idx="185">
                  <c:v>0.1260426342</c:v>
                </c:pt>
                <c:pt idx="186">
                  <c:v>0.12610891460000001</c:v>
                </c:pt>
                <c:pt idx="187">
                  <c:v>0.12633138899999999</c:v>
                </c:pt>
                <c:pt idx="188">
                  <c:v>0.12639060620000001</c:v>
                </c:pt>
                <c:pt idx="189">
                  <c:v>0.12647137050000001</c:v>
                </c:pt>
                <c:pt idx="190">
                  <c:v>0.1265537739</c:v>
                </c:pt>
                <c:pt idx="191">
                  <c:v>0.1265201718</c:v>
                </c:pt>
                <c:pt idx="192">
                  <c:v>0.1264445931</c:v>
                </c:pt>
                <c:pt idx="193">
                  <c:v>0.12645672259999999</c:v>
                </c:pt>
                <c:pt idx="194">
                  <c:v>0.12667009230000001</c:v>
                </c:pt>
                <c:pt idx="195">
                  <c:v>0.1269514561</c:v>
                </c:pt>
                <c:pt idx="196">
                  <c:v>0.12703360620000001</c:v>
                </c:pt>
                <c:pt idx="197">
                  <c:v>0.12700457870000001</c:v>
                </c:pt>
                <c:pt idx="198">
                  <c:v>0.12705855069999999</c:v>
                </c:pt>
                <c:pt idx="199">
                  <c:v>0.1272092313</c:v>
                </c:pt>
                <c:pt idx="200">
                  <c:v>0.12721659239999999</c:v>
                </c:pt>
                <c:pt idx="201">
                  <c:v>0.12717890740000001</c:v>
                </c:pt>
                <c:pt idx="202">
                  <c:v>0.12729275230000001</c:v>
                </c:pt>
                <c:pt idx="203">
                  <c:v>0.1273338497</c:v>
                </c:pt>
                <c:pt idx="204">
                  <c:v>0.12738913299999999</c:v>
                </c:pt>
                <c:pt idx="205">
                  <c:v>0.1273598671</c:v>
                </c:pt>
                <c:pt idx="206">
                  <c:v>0.1275371313</c:v>
                </c:pt>
                <c:pt idx="207">
                  <c:v>0.12745662029999999</c:v>
                </c:pt>
                <c:pt idx="208">
                  <c:v>0.12752951679999999</c:v>
                </c:pt>
                <c:pt idx="209">
                  <c:v>0.1277636439</c:v>
                </c:pt>
                <c:pt idx="210">
                  <c:v>0.1276452243</c:v>
                </c:pt>
                <c:pt idx="211">
                  <c:v>0.12787283960000001</c:v>
                </c:pt>
                <c:pt idx="212">
                  <c:v>0.127903983</c:v>
                </c:pt>
                <c:pt idx="213">
                  <c:v>0.1279933006</c:v>
                </c:pt>
                <c:pt idx="214">
                  <c:v>0.12796667219999999</c:v>
                </c:pt>
                <c:pt idx="215">
                  <c:v>0.12805534900000001</c:v>
                </c:pt>
                <c:pt idx="216">
                  <c:v>0.12825970349999999</c:v>
                </c:pt>
                <c:pt idx="217">
                  <c:v>0.12818910180000001</c:v>
                </c:pt>
                <c:pt idx="218">
                  <c:v>0.12829406560000001</c:v>
                </c:pt>
                <c:pt idx="219">
                  <c:v>0.1283949465</c:v>
                </c:pt>
                <c:pt idx="220">
                  <c:v>0.12856353819999999</c:v>
                </c:pt>
                <c:pt idx="221">
                  <c:v>0.12858511510000001</c:v>
                </c:pt>
                <c:pt idx="222">
                  <c:v>0.1288138777</c:v>
                </c:pt>
                <c:pt idx="223">
                  <c:v>0.12873612340000001</c:v>
                </c:pt>
                <c:pt idx="224">
                  <c:v>0.12901806830000001</c:v>
                </c:pt>
                <c:pt idx="225">
                  <c:v>0.12913855909999999</c:v>
                </c:pt>
                <c:pt idx="226">
                  <c:v>0.12913385029999999</c:v>
                </c:pt>
                <c:pt idx="227">
                  <c:v>0.1290582716</c:v>
                </c:pt>
                <c:pt idx="228">
                  <c:v>0.1292916834</c:v>
                </c:pt>
                <c:pt idx="229">
                  <c:v>0.1293811798</c:v>
                </c:pt>
                <c:pt idx="230">
                  <c:v>0.1295125932</c:v>
                </c:pt>
                <c:pt idx="231">
                  <c:v>0.12969373170000001</c:v>
                </c:pt>
                <c:pt idx="232">
                  <c:v>0.13001756370000001</c:v>
                </c:pt>
                <c:pt idx="233">
                  <c:v>0.13044963779999999</c:v>
                </c:pt>
                <c:pt idx="234">
                  <c:v>0.1307123452</c:v>
                </c:pt>
                <c:pt idx="235">
                  <c:v>0.1309074163</c:v>
                </c:pt>
                <c:pt idx="236">
                  <c:v>0.13071161510000001</c:v>
                </c:pt>
                <c:pt idx="237">
                  <c:v>0.1312538385</c:v>
                </c:pt>
                <c:pt idx="238">
                  <c:v>0.131060645</c:v>
                </c:pt>
                <c:pt idx="239">
                  <c:v>0.1312141567</c:v>
                </c:pt>
                <c:pt idx="240">
                  <c:v>0.13138388100000001</c:v>
                </c:pt>
                <c:pt idx="241">
                  <c:v>0.1315449923</c:v>
                </c:pt>
                <c:pt idx="242">
                  <c:v>0.1316349953</c:v>
                </c:pt>
                <c:pt idx="243">
                  <c:v>0.13172903659999999</c:v>
                </c:pt>
                <c:pt idx="244">
                  <c:v>0.1319990009</c:v>
                </c:pt>
                <c:pt idx="245">
                  <c:v>0.1321049333</c:v>
                </c:pt>
                <c:pt idx="246">
                  <c:v>0.13227668400000001</c:v>
                </c:pt>
                <c:pt idx="247">
                  <c:v>0.13245314359999999</c:v>
                </c:pt>
                <c:pt idx="248">
                  <c:v>0.1324655861</c:v>
                </c:pt>
                <c:pt idx="249">
                  <c:v>0.13282227520000001</c:v>
                </c:pt>
                <c:pt idx="250">
                  <c:v>0.13296918569999999</c:v>
                </c:pt>
                <c:pt idx="251">
                  <c:v>0.13284842669999999</c:v>
                </c:pt>
                <c:pt idx="252">
                  <c:v>0.13308684530000001</c:v>
                </c:pt>
                <c:pt idx="253">
                  <c:v>0.13317488129999999</c:v>
                </c:pt>
                <c:pt idx="254">
                  <c:v>0.1334183514</c:v>
                </c:pt>
                <c:pt idx="255">
                  <c:v>0.13343951109999999</c:v>
                </c:pt>
                <c:pt idx="256">
                  <c:v>0.13373377920000001</c:v>
                </c:pt>
                <c:pt idx="257">
                  <c:v>0.13369089370000001</c:v>
                </c:pt>
                <c:pt idx="258">
                  <c:v>0.1339081973</c:v>
                </c:pt>
                <c:pt idx="259">
                  <c:v>0.13410076500000001</c:v>
                </c:pt>
                <c:pt idx="260">
                  <c:v>0.1341346353</c:v>
                </c:pt>
                <c:pt idx="261">
                  <c:v>0.13430963460000001</c:v>
                </c:pt>
                <c:pt idx="262">
                  <c:v>0.134543106</c:v>
                </c:pt>
                <c:pt idx="263">
                  <c:v>0.13454690580000001</c:v>
                </c:pt>
                <c:pt idx="264">
                  <c:v>0.13469362260000001</c:v>
                </c:pt>
                <c:pt idx="265">
                  <c:v>0.1350127757</c:v>
                </c:pt>
                <c:pt idx="266">
                  <c:v>0.13502205910000001</c:v>
                </c:pt>
                <c:pt idx="267">
                  <c:v>0.13513143359999999</c:v>
                </c:pt>
                <c:pt idx="268">
                  <c:v>0.13554218409999999</c:v>
                </c:pt>
                <c:pt idx="269">
                  <c:v>0.13567925989999999</c:v>
                </c:pt>
                <c:pt idx="270">
                  <c:v>0.13581870500000001</c:v>
                </c:pt>
                <c:pt idx="271">
                  <c:v>0.13601346310000001</c:v>
                </c:pt>
                <c:pt idx="272">
                  <c:v>0.13622775670000001</c:v>
                </c:pt>
                <c:pt idx="273">
                  <c:v>0.1364281923</c:v>
                </c:pt>
                <c:pt idx="274">
                  <c:v>0.1367319524</c:v>
                </c:pt>
                <c:pt idx="275">
                  <c:v>0.1370776296</c:v>
                </c:pt>
                <c:pt idx="276">
                  <c:v>0.13704989849999999</c:v>
                </c:pt>
                <c:pt idx="277">
                  <c:v>0.13745440540000001</c:v>
                </c:pt>
                <c:pt idx="278">
                  <c:v>0.137749806</c:v>
                </c:pt>
                <c:pt idx="279">
                  <c:v>0.13831983510000001</c:v>
                </c:pt>
                <c:pt idx="280">
                  <c:v>0.13883288199999999</c:v>
                </c:pt>
                <c:pt idx="281">
                  <c:v>0.13932476939999999</c:v>
                </c:pt>
                <c:pt idx="282">
                  <c:v>0.13996376099999999</c:v>
                </c:pt>
                <c:pt idx="283">
                  <c:v>0.14074343440000001</c:v>
                </c:pt>
                <c:pt idx="284">
                  <c:v>0.14153465630000001</c:v>
                </c:pt>
                <c:pt idx="285">
                  <c:v>0.1426156163</c:v>
                </c:pt>
                <c:pt idx="286">
                  <c:v>0.1436052471</c:v>
                </c:pt>
                <c:pt idx="287">
                  <c:v>0.14490786189999999</c:v>
                </c:pt>
                <c:pt idx="288">
                  <c:v>0.14637702699999999</c:v>
                </c:pt>
                <c:pt idx="289">
                  <c:v>0.14838501809999999</c:v>
                </c:pt>
                <c:pt idx="290">
                  <c:v>0.1503754407</c:v>
                </c:pt>
                <c:pt idx="291">
                  <c:v>0.15276417140000001</c:v>
                </c:pt>
                <c:pt idx="292">
                  <c:v>0.1552304327</c:v>
                </c:pt>
                <c:pt idx="293">
                  <c:v>0.15829820929999999</c:v>
                </c:pt>
                <c:pt idx="294">
                  <c:v>0.1617117226</c:v>
                </c:pt>
                <c:pt idx="295">
                  <c:v>0.16550856829999999</c:v>
                </c:pt>
                <c:pt idx="296">
                  <c:v>0.16990900040000001</c:v>
                </c:pt>
                <c:pt idx="297">
                  <c:v>0.17483372990000001</c:v>
                </c:pt>
                <c:pt idx="298">
                  <c:v>0.1801897734</c:v>
                </c:pt>
                <c:pt idx="299">
                  <c:v>0.18629638849999999</c:v>
                </c:pt>
                <c:pt idx="300">
                  <c:v>0.19295270740000001</c:v>
                </c:pt>
                <c:pt idx="301">
                  <c:v>0.20001019540000001</c:v>
                </c:pt>
                <c:pt idx="302">
                  <c:v>0.20772948860000001</c:v>
                </c:pt>
                <c:pt idx="303">
                  <c:v>0.21608702839999999</c:v>
                </c:pt>
                <c:pt idx="304">
                  <c:v>0.22503648700000001</c:v>
                </c:pt>
                <c:pt idx="305">
                  <c:v>0.234292686</c:v>
                </c:pt>
                <c:pt idx="306">
                  <c:v>0.2441317737</c:v>
                </c:pt>
                <c:pt idx="307">
                  <c:v>0.25417083499999998</c:v>
                </c:pt>
                <c:pt idx="308">
                  <c:v>0.26469391580000001</c:v>
                </c:pt>
                <c:pt idx="309">
                  <c:v>0.27493613960000002</c:v>
                </c:pt>
                <c:pt idx="310">
                  <c:v>0.28544741870000001</c:v>
                </c:pt>
                <c:pt idx="311">
                  <c:v>0.29585185650000001</c:v>
                </c:pt>
                <c:pt idx="312">
                  <c:v>0.30577921870000002</c:v>
                </c:pt>
                <c:pt idx="313">
                  <c:v>0.31542822720000002</c:v>
                </c:pt>
                <c:pt idx="314">
                  <c:v>0.32460716369999998</c:v>
                </c:pt>
                <c:pt idx="315">
                  <c:v>0.3333097994</c:v>
                </c:pt>
                <c:pt idx="316">
                  <c:v>0.34114915130000001</c:v>
                </c:pt>
                <c:pt idx="317">
                  <c:v>0.34838557240000001</c:v>
                </c:pt>
                <c:pt idx="318">
                  <c:v>0.35463446380000002</c:v>
                </c:pt>
                <c:pt idx="319">
                  <c:v>0.36011293529999999</c:v>
                </c:pt>
                <c:pt idx="320">
                  <c:v>0.364821285</c:v>
                </c:pt>
                <c:pt idx="321">
                  <c:v>0.36850848790000001</c:v>
                </c:pt>
                <c:pt idx="322">
                  <c:v>0.37138003110000001</c:v>
                </c:pt>
                <c:pt idx="323">
                  <c:v>0.37352102990000002</c:v>
                </c:pt>
                <c:pt idx="324">
                  <c:v>0.37479433420000002</c:v>
                </c:pt>
                <c:pt idx="325">
                  <c:v>0.37554359440000001</c:v>
                </c:pt>
                <c:pt idx="326">
                  <c:v>0.37577393650000002</c:v>
                </c:pt>
                <c:pt idx="327">
                  <c:v>0.37543243170000001</c:v>
                </c:pt>
                <c:pt idx="328">
                  <c:v>0.37493404749999998</c:v>
                </c:pt>
                <c:pt idx="329">
                  <c:v>0.3740104139</c:v>
                </c:pt>
                <c:pt idx="330">
                  <c:v>0.37320348619999999</c:v>
                </c:pt>
                <c:pt idx="331">
                  <c:v>0.3724477887</c:v>
                </c:pt>
                <c:pt idx="332">
                  <c:v>0.37164911630000003</c:v>
                </c:pt>
                <c:pt idx="333">
                  <c:v>0.3712947667</c:v>
                </c:pt>
                <c:pt idx="334">
                  <c:v>0.37106892470000002</c:v>
                </c:pt>
                <c:pt idx="335">
                  <c:v>0.37123560909999997</c:v>
                </c:pt>
                <c:pt idx="336">
                  <c:v>0.37187248470000001</c:v>
                </c:pt>
                <c:pt idx="337">
                  <c:v>0.37270668150000003</c:v>
                </c:pt>
                <c:pt idx="338">
                  <c:v>0.37391608949999999</c:v>
                </c:pt>
                <c:pt idx="339">
                  <c:v>0.37537735700000002</c:v>
                </c:pt>
                <c:pt idx="340">
                  <c:v>0.37748348710000001</c:v>
                </c:pt>
                <c:pt idx="341">
                  <c:v>0.3793161511</c:v>
                </c:pt>
                <c:pt idx="342">
                  <c:v>0.38105031849999998</c:v>
                </c:pt>
                <c:pt idx="343">
                  <c:v>0.38296824689999998</c:v>
                </c:pt>
                <c:pt idx="344">
                  <c:v>0.38468089700000002</c:v>
                </c:pt>
                <c:pt idx="345">
                  <c:v>0.38583150510000003</c:v>
                </c:pt>
                <c:pt idx="346">
                  <c:v>0.38689672949999998</c:v>
                </c:pt>
                <c:pt idx="347">
                  <c:v>0.38711920379999998</c:v>
                </c:pt>
                <c:pt idx="348">
                  <c:v>0.38696634769999999</c:v>
                </c:pt>
                <c:pt idx="349">
                  <c:v>0.3862361312</c:v>
                </c:pt>
                <c:pt idx="350">
                  <c:v>0.3846657872</c:v>
                </c:pt>
                <c:pt idx="351">
                  <c:v>0.38243904709999998</c:v>
                </c:pt>
                <c:pt idx="352">
                  <c:v>0.3797075748</c:v>
                </c:pt>
                <c:pt idx="353">
                  <c:v>0.37609854339999998</c:v>
                </c:pt>
                <c:pt idx="354">
                  <c:v>0.3722089529</c:v>
                </c:pt>
                <c:pt idx="355">
                  <c:v>0.3679037094</c:v>
                </c:pt>
                <c:pt idx="356">
                  <c:v>0.36307322980000001</c:v>
                </c:pt>
                <c:pt idx="357">
                  <c:v>0.35793381930000001</c:v>
                </c:pt>
                <c:pt idx="358">
                  <c:v>0.35267293449999998</c:v>
                </c:pt>
                <c:pt idx="359">
                  <c:v>0.34772971270000003</c:v>
                </c:pt>
                <c:pt idx="360">
                  <c:v>0.34231564399999997</c:v>
                </c:pt>
                <c:pt idx="361">
                  <c:v>0.3372869194</c:v>
                </c:pt>
                <c:pt idx="362">
                  <c:v>0.33230391139999998</c:v>
                </c:pt>
                <c:pt idx="363">
                  <c:v>0.32754251359999997</c:v>
                </c:pt>
                <c:pt idx="364">
                  <c:v>0.32292482259999999</c:v>
                </c:pt>
                <c:pt idx="365">
                  <c:v>0.31882813570000001</c:v>
                </c:pt>
                <c:pt idx="366">
                  <c:v>0.31483820080000002</c:v>
                </c:pt>
                <c:pt idx="367">
                  <c:v>0.31138214469999997</c:v>
                </c:pt>
                <c:pt idx="368">
                  <c:v>0.30820655819999998</c:v>
                </c:pt>
                <c:pt idx="369">
                  <c:v>0.30537152290000003</c:v>
                </c:pt>
                <c:pt idx="370">
                  <c:v>0.30266493560000002</c:v>
                </c:pt>
                <c:pt idx="371">
                  <c:v>0.30004647369999998</c:v>
                </c:pt>
                <c:pt idx="372">
                  <c:v>0.29742839929999998</c:v>
                </c:pt>
                <c:pt idx="373">
                  <c:v>0.29516100880000001</c:v>
                </c:pt>
                <c:pt idx="374">
                  <c:v>0.2925909162</c:v>
                </c:pt>
                <c:pt idx="375">
                  <c:v>0.28998097779999998</c:v>
                </c:pt>
                <c:pt idx="376">
                  <c:v>0.28721669319999998</c:v>
                </c:pt>
                <c:pt idx="377">
                  <c:v>0.28460916879999998</c:v>
                </c:pt>
                <c:pt idx="378">
                  <c:v>0.2817592323</c:v>
                </c:pt>
                <c:pt idx="379">
                  <c:v>0.27892389890000002</c:v>
                </c:pt>
                <c:pt idx="380">
                  <c:v>0.27563560009999999</c:v>
                </c:pt>
                <c:pt idx="381">
                  <c:v>0.27258068320000001</c:v>
                </c:pt>
                <c:pt idx="382">
                  <c:v>0.26944562789999998</c:v>
                </c:pt>
                <c:pt idx="383">
                  <c:v>0.26630252599999998</c:v>
                </c:pt>
                <c:pt idx="384">
                  <c:v>0.26322802899999997</c:v>
                </c:pt>
                <c:pt idx="385">
                  <c:v>0.26024964449999999</c:v>
                </c:pt>
                <c:pt idx="386">
                  <c:v>0.257401824</c:v>
                </c:pt>
                <c:pt idx="387">
                  <c:v>0.25469830630000001</c:v>
                </c:pt>
                <c:pt idx="388">
                  <c:v>0.25244900580000001</c:v>
                </c:pt>
                <c:pt idx="389">
                  <c:v>0.25038784739999997</c:v>
                </c:pt>
                <c:pt idx="390">
                  <c:v>0.24833309649999999</c:v>
                </c:pt>
                <c:pt idx="391">
                  <c:v>0.24684587120000001</c:v>
                </c:pt>
                <c:pt idx="392">
                  <c:v>0.2456436306</c:v>
                </c:pt>
                <c:pt idx="393">
                  <c:v>0.24500684440000001</c:v>
                </c:pt>
                <c:pt idx="394">
                  <c:v>0.24436327820000001</c:v>
                </c:pt>
                <c:pt idx="395">
                  <c:v>0.24421580139999999</c:v>
                </c:pt>
                <c:pt idx="396">
                  <c:v>0.2442142665</c:v>
                </c:pt>
                <c:pt idx="397">
                  <c:v>0.24444952610000001</c:v>
                </c:pt>
                <c:pt idx="398">
                  <c:v>0.24495743219999999</c:v>
                </c:pt>
                <c:pt idx="399">
                  <c:v>0.24584652479999999</c:v>
                </c:pt>
                <c:pt idx="400">
                  <c:v>0.24671193960000001</c:v>
                </c:pt>
                <c:pt idx="401">
                  <c:v>0.24770829080000001</c:v>
                </c:pt>
                <c:pt idx="402">
                  <c:v>0.2490019202</c:v>
                </c:pt>
                <c:pt idx="403">
                  <c:v>0.25033196810000002</c:v>
                </c:pt>
                <c:pt idx="404">
                  <c:v>0.25178506969999997</c:v>
                </c:pt>
                <c:pt idx="405">
                  <c:v>0.2534109652</c:v>
                </c:pt>
                <c:pt idx="406">
                  <c:v>0.25526791809999999</c:v>
                </c:pt>
                <c:pt idx="407">
                  <c:v>0.2573831379</c:v>
                </c:pt>
                <c:pt idx="408">
                  <c:v>0.25931084160000001</c:v>
                </c:pt>
                <c:pt idx="409">
                  <c:v>0.26120841500000003</c:v>
                </c:pt>
                <c:pt idx="410">
                  <c:v>0.26346063609999998</c:v>
                </c:pt>
                <c:pt idx="411">
                  <c:v>0.26560023430000002</c:v>
                </c:pt>
                <c:pt idx="412">
                  <c:v>0.26769605279999997</c:v>
                </c:pt>
                <c:pt idx="413">
                  <c:v>0.26970398429999998</c:v>
                </c:pt>
                <c:pt idx="414">
                  <c:v>0.27184766529999999</c:v>
                </c:pt>
                <c:pt idx="415">
                  <c:v>0.27412223819999998</c:v>
                </c:pt>
                <c:pt idx="416">
                  <c:v>0.27632540459999999</c:v>
                </c:pt>
                <c:pt idx="417">
                  <c:v>0.27897438409999997</c:v>
                </c:pt>
                <c:pt idx="418">
                  <c:v>0.28034359219999999</c:v>
                </c:pt>
                <c:pt idx="419">
                  <c:v>0.2825477421</c:v>
                </c:pt>
                <c:pt idx="420">
                  <c:v>0.28451299670000002</c:v>
                </c:pt>
                <c:pt idx="421">
                  <c:v>0.28648582099999997</c:v>
                </c:pt>
                <c:pt idx="422">
                  <c:v>0.28825902939999998</c:v>
                </c:pt>
                <c:pt idx="423">
                  <c:v>0.29020866750000002</c:v>
                </c:pt>
                <c:pt idx="424">
                  <c:v>0.29232841729999998</c:v>
                </c:pt>
                <c:pt idx="425">
                  <c:v>0.29403147099999999</c:v>
                </c:pt>
                <c:pt idx="426">
                  <c:v>0.29560008650000003</c:v>
                </c:pt>
                <c:pt idx="427">
                  <c:v>0.29737734789999998</c:v>
                </c:pt>
                <c:pt idx="428">
                  <c:v>0.2986858785</c:v>
                </c:pt>
                <c:pt idx="429">
                  <c:v>0.30139124389999999</c:v>
                </c:pt>
                <c:pt idx="430">
                  <c:v>0.30137202140000002</c:v>
                </c:pt>
                <c:pt idx="431">
                  <c:v>0.3029310107</c:v>
                </c:pt>
                <c:pt idx="432">
                  <c:v>0.3111447692</c:v>
                </c:pt>
                <c:pt idx="433">
                  <c:v>0.30659207700000002</c:v>
                </c:pt>
                <c:pt idx="434">
                  <c:v>0.30801972750000001</c:v>
                </c:pt>
                <c:pt idx="435">
                  <c:v>0.30942305920000002</c:v>
                </c:pt>
                <c:pt idx="436">
                  <c:v>0.31083947420000002</c:v>
                </c:pt>
                <c:pt idx="437">
                  <c:v>0.31176626680000002</c:v>
                </c:pt>
                <c:pt idx="438">
                  <c:v>0.31256872419999998</c:v>
                </c:pt>
                <c:pt idx="439">
                  <c:v>0.31456702949999998</c:v>
                </c:pt>
                <c:pt idx="440">
                  <c:v>0.31387269499999998</c:v>
                </c:pt>
                <c:pt idx="441">
                  <c:v>0.31524667140000001</c:v>
                </c:pt>
                <c:pt idx="442">
                  <c:v>0.31563872100000001</c:v>
                </c:pt>
                <c:pt idx="443">
                  <c:v>0.31589421629999997</c:v>
                </c:pt>
                <c:pt idx="444">
                  <c:v>0.31766051049999999</c:v>
                </c:pt>
                <c:pt idx="445">
                  <c:v>0.3161720335</c:v>
                </c:pt>
                <c:pt idx="446">
                  <c:v>0.31701046230000002</c:v>
                </c:pt>
                <c:pt idx="447">
                  <c:v>0.31748947500000002</c:v>
                </c:pt>
                <c:pt idx="448">
                  <c:v>0.31828561430000002</c:v>
                </c:pt>
                <c:pt idx="449">
                  <c:v>0.3173705637</c:v>
                </c:pt>
                <c:pt idx="450">
                  <c:v>0.31738746169999998</c:v>
                </c:pt>
                <c:pt idx="451">
                  <c:v>0.3188337088</c:v>
                </c:pt>
                <c:pt idx="452">
                  <c:v>0.33053764699999999</c:v>
                </c:pt>
                <c:pt idx="453">
                  <c:v>0.33142012360000001</c:v>
                </c:pt>
                <c:pt idx="454">
                  <c:v>0.33305725460000002</c:v>
                </c:pt>
                <c:pt idx="455">
                  <c:v>0.3341650665</c:v>
                </c:pt>
                <c:pt idx="456">
                  <c:v>0.3352435231</c:v>
                </c:pt>
                <c:pt idx="457">
                  <c:v>0.336401701</c:v>
                </c:pt>
                <c:pt idx="458">
                  <c:v>0.33800303939999998</c:v>
                </c:pt>
                <c:pt idx="459">
                  <c:v>0.33898103239999999</c:v>
                </c:pt>
                <c:pt idx="460">
                  <c:v>0.34098425510000002</c:v>
                </c:pt>
                <c:pt idx="461">
                  <c:v>0.3423044086</c:v>
                </c:pt>
                <c:pt idx="462">
                  <c:v>0.34359052779999999</c:v>
                </c:pt>
                <c:pt idx="463">
                  <c:v>0.34574115280000001</c:v>
                </c:pt>
                <c:pt idx="464">
                  <c:v>0.34659588340000003</c:v>
                </c:pt>
                <c:pt idx="465">
                  <c:v>0.34809923170000001</c:v>
                </c:pt>
                <c:pt idx="466">
                  <c:v>0.35069411989999999</c:v>
                </c:pt>
                <c:pt idx="467">
                  <c:v>0.35203787679999998</c:v>
                </c:pt>
                <c:pt idx="468">
                  <c:v>0.35377866029999999</c:v>
                </c:pt>
                <c:pt idx="469">
                  <c:v>0.35601952669999998</c:v>
                </c:pt>
                <c:pt idx="470">
                  <c:v>0.35830783840000002</c:v>
                </c:pt>
                <c:pt idx="471">
                  <c:v>0.36013600229999998</c:v>
                </c:pt>
                <c:pt idx="472">
                  <c:v>0.36200261119999999</c:v>
                </c:pt>
                <c:pt idx="473">
                  <c:v>0.36428678040000001</c:v>
                </c:pt>
                <c:pt idx="474">
                  <c:v>0.36673194170000001</c:v>
                </c:pt>
                <c:pt idx="475">
                  <c:v>0.36869710680000001</c:v>
                </c:pt>
                <c:pt idx="476">
                  <c:v>0.37112995980000002</c:v>
                </c:pt>
                <c:pt idx="477">
                  <c:v>0.37383967639999999</c:v>
                </c:pt>
                <c:pt idx="478">
                  <c:v>0.37605488300000001</c:v>
                </c:pt>
                <c:pt idx="479">
                  <c:v>0.3780255616</c:v>
                </c:pt>
                <c:pt idx="480">
                  <c:v>0.38030689950000002</c:v>
                </c:pt>
                <c:pt idx="481">
                  <c:v>0.3827047348</c:v>
                </c:pt>
                <c:pt idx="482">
                  <c:v>0.38524001839999999</c:v>
                </c:pt>
                <c:pt idx="483">
                  <c:v>0.3870729208</c:v>
                </c:pt>
                <c:pt idx="484">
                  <c:v>0.38913178440000001</c:v>
                </c:pt>
                <c:pt idx="485">
                  <c:v>0.39159277079999999</c:v>
                </c:pt>
                <c:pt idx="486">
                  <c:v>0.3929635286</c:v>
                </c:pt>
                <c:pt idx="487">
                  <c:v>0.39520767330000001</c:v>
                </c:pt>
                <c:pt idx="488">
                  <c:v>0.39696618909999998</c:v>
                </c:pt>
                <c:pt idx="489">
                  <c:v>0.39850097890000002</c:v>
                </c:pt>
                <c:pt idx="490">
                  <c:v>0.39974132179999999</c:v>
                </c:pt>
                <c:pt idx="491">
                  <c:v>0.40110650660000002</c:v>
                </c:pt>
                <c:pt idx="492">
                  <c:v>0.40284001829999999</c:v>
                </c:pt>
                <c:pt idx="493">
                  <c:v>0.40433672069999999</c:v>
                </c:pt>
                <c:pt idx="494">
                  <c:v>0.40570354460000002</c:v>
                </c:pt>
                <c:pt idx="495">
                  <c:v>0.40745869280000002</c:v>
                </c:pt>
                <c:pt idx="496">
                  <c:v>0.40935736890000002</c:v>
                </c:pt>
                <c:pt idx="497">
                  <c:v>0.41172987220000001</c:v>
                </c:pt>
                <c:pt idx="498">
                  <c:v>0.41506326199999999</c:v>
                </c:pt>
                <c:pt idx="499">
                  <c:v>0.41857680679999998</c:v>
                </c:pt>
                <c:pt idx="500">
                  <c:v>0.42338496450000002</c:v>
                </c:pt>
                <c:pt idx="501">
                  <c:v>0.42877060169999998</c:v>
                </c:pt>
                <c:pt idx="502">
                  <c:v>0.43358430269999998</c:v>
                </c:pt>
                <c:pt idx="503">
                  <c:v>0.43831694129999998</c:v>
                </c:pt>
                <c:pt idx="504">
                  <c:v>0.44308894869999998</c:v>
                </c:pt>
                <c:pt idx="505">
                  <c:v>0.44720873239999998</c:v>
                </c:pt>
                <c:pt idx="506">
                  <c:v>0.4497872591</c:v>
                </c:pt>
                <c:pt idx="507">
                  <c:v>0.45277667049999998</c:v>
                </c:pt>
                <c:pt idx="508">
                  <c:v>0.45573502780000003</c:v>
                </c:pt>
                <c:pt idx="509">
                  <c:v>0.45975866910000002</c:v>
                </c:pt>
                <c:pt idx="510">
                  <c:v>0.46413320299999999</c:v>
                </c:pt>
                <c:pt idx="511">
                  <c:v>0.46921411159999998</c:v>
                </c:pt>
                <c:pt idx="512">
                  <c:v>0.47548741100000003</c:v>
                </c:pt>
                <c:pt idx="513">
                  <c:v>0.48216500880000002</c:v>
                </c:pt>
                <c:pt idx="514">
                  <c:v>0.49004572629999998</c:v>
                </c:pt>
                <c:pt idx="515">
                  <c:v>0.49885398149999999</c:v>
                </c:pt>
                <c:pt idx="516">
                  <c:v>0.50801688430000003</c:v>
                </c:pt>
                <c:pt idx="517">
                  <c:v>0.51837444310000003</c:v>
                </c:pt>
                <c:pt idx="518">
                  <c:v>0.52955490350000001</c:v>
                </c:pt>
                <c:pt idx="519">
                  <c:v>0.54225784539999999</c:v>
                </c:pt>
                <c:pt idx="520">
                  <c:v>0.55584341289999994</c:v>
                </c:pt>
                <c:pt idx="521">
                  <c:v>0.56987142560000004</c:v>
                </c:pt>
                <c:pt idx="522">
                  <c:v>0.58347457650000001</c:v>
                </c:pt>
                <c:pt idx="523">
                  <c:v>0.5955520272</c:v>
                </c:pt>
                <c:pt idx="524">
                  <c:v>0.60640776159999998</c:v>
                </c:pt>
                <c:pt idx="525">
                  <c:v>0.61393350359999999</c:v>
                </c:pt>
                <c:pt idx="526">
                  <c:v>0.61969971660000001</c:v>
                </c:pt>
                <c:pt idx="527">
                  <c:v>0.62342482809999999</c:v>
                </c:pt>
                <c:pt idx="528">
                  <c:v>0.62627184390000001</c:v>
                </c:pt>
                <c:pt idx="529">
                  <c:v>0.62940287589999999</c:v>
                </c:pt>
                <c:pt idx="530">
                  <c:v>0.63325810429999996</c:v>
                </c:pt>
                <c:pt idx="531">
                  <c:v>0.63777148719999999</c:v>
                </c:pt>
                <c:pt idx="532">
                  <c:v>0.64324325319999998</c:v>
                </c:pt>
                <c:pt idx="533">
                  <c:v>0.64873367550000005</c:v>
                </c:pt>
                <c:pt idx="534">
                  <c:v>0.65519517660000004</c:v>
                </c:pt>
                <c:pt idx="535">
                  <c:v>0.6616712213</c:v>
                </c:pt>
                <c:pt idx="536">
                  <c:v>0.66837996239999997</c:v>
                </c:pt>
                <c:pt idx="537">
                  <c:v>0.67574137450000005</c:v>
                </c:pt>
                <c:pt idx="538">
                  <c:v>0.68404555320000004</c:v>
                </c:pt>
                <c:pt idx="539">
                  <c:v>0.69382423159999995</c:v>
                </c:pt>
                <c:pt idx="540">
                  <c:v>0.70395094160000005</c:v>
                </c:pt>
                <c:pt idx="541">
                  <c:v>0.71496719119999996</c:v>
                </c:pt>
                <c:pt idx="542">
                  <c:v>0.72631555800000003</c:v>
                </c:pt>
                <c:pt idx="543">
                  <c:v>0.73889023070000004</c:v>
                </c:pt>
                <c:pt idx="544">
                  <c:v>0.75128823519999999</c:v>
                </c:pt>
                <c:pt idx="545">
                  <c:v>0.76470637320000001</c:v>
                </c:pt>
                <c:pt idx="546">
                  <c:v>0.77779573199999996</c:v>
                </c:pt>
                <c:pt idx="547">
                  <c:v>0.79089713100000003</c:v>
                </c:pt>
                <c:pt idx="548">
                  <c:v>0.80414545540000004</c:v>
                </c:pt>
                <c:pt idx="549">
                  <c:v>0.81659376620000002</c:v>
                </c:pt>
                <c:pt idx="550">
                  <c:v>0.82942008970000003</c:v>
                </c:pt>
                <c:pt idx="551">
                  <c:v>0.84188568590000001</c:v>
                </c:pt>
                <c:pt idx="552">
                  <c:v>0.85538429019999995</c:v>
                </c:pt>
                <c:pt idx="553">
                  <c:v>0.86875510219999996</c:v>
                </c:pt>
                <c:pt idx="554">
                  <c:v>0.88380879160000003</c:v>
                </c:pt>
                <c:pt idx="555">
                  <c:v>0.90051913260000005</c:v>
                </c:pt>
                <c:pt idx="556">
                  <c:v>0.91977667809999997</c:v>
                </c:pt>
                <c:pt idx="557">
                  <c:v>0.9429268837</c:v>
                </c:pt>
                <c:pt idx="558">
                  <c:v>0.96942144630000004</c:v>
                </c:pt>
                <c:pt idx="559">
                  <c:v>1.001052856</c:v>
                </c:pt>
                <c:pt idx="560">
                  <c:v>1.0395096539999999</c:v>
                </c:pt>
                <c:pt idx="561">
                  <c:v>1.084732652</c:v>
                </c:pt>
                <c:pt idx="562">
                  <c:v>1.1398303510000001</c:v>
                </c:pt>
                <c:pt idx="563">
                  <c:v>1.205385089</c:v>
                </c:pt>
                <c:pt idx="564">
                  <c:v>1.284362435</c:v>
                </c:pt>
                <c:pt idx="565">
                  <c:v>1.3772681950000001</c:v>
                </c:pt>
                <c:pt idx="566">
                  <c:v>1.489146471</c:v>
                </c:pt>
                <c:pt idx="567">
                  <c:v>1.6243958469999999</c:v>
                </c:pt>
                <c:pt idx="568">
                  <c:v>1.789028525</c:v>
                </c:pt>
                <c:pt idx="569">
                  <c:v>1.9959888459999999</c:v>
                </c:pt>
                <c:pt idx="570">
                  <c:v>2.2501084800000002</c:v>
                </c:pt>
                <c:pt idx="571">
                  <c:v>2.5571012500000001</c:v>
                </c:pt>
                <c:pt idx="572">
                  <c:v>2.8957028390000001</c:v>
                </c:pt>
                <c:pt idx="573">
                  <c:v>3.190798998</c:v>
                </c:pt>
                <c:pt idx="574">
                  <c:v>3.3741998670000002</c:v>
                </c:pt>
                <c:pt idx="575">
                  <c:v>3.440495968</c:v>
                </c:pt>
                <c:pt idx="576">
                  <c:v>3.4854612349999998</c:v>
                </c:pt>
                <c:pt idx="577">
                  <c:v>3.5099155899999999</c:v>
                </c:pt>
                <c:pt idx="578">
                  <c:v>3.5207128519999999</c:v>
                </c:pt>
                <c:pt idx="579">
                  <c:v>3.5426354409999998</c:v>
                </c:pt>
                <c:pt idx="580">
                  <c:v>3.547530413</c:v>
                </c:pt>
                <c:pt idx="581">
                  <c:v>3.5532965660000002</c:v>
                </c:pt>
                <c:pt idx="582">
                  <c:v>3.5537021160000002</c:v>
                </c:pt>
                <c:pt idx="583">
                  <c:v>3.555822611</c:v>
                </c:pt>
                <c:pt idx="584">
                  <c:v>3.5574305060000002</c:v>
                </c:pt>
                <c:pt idx="585">
                  <c:v>3.5434732439999999</c:v>
                </c:pt>
                <c:pt idx="586">
                  <c:v>3.5225200650000001</c:v>
                </c:pt>
                <c:pt idx="587">
                  <c:v>3.51587081</c:v>
                </c:pt>
                <c:pt idx="588">
                  <c:v>3.5047886369999999</c:v>
                </c:pt>
                <c:pt idx="589">
                  <c:v>3.4966096879999999</c:v>
                </c:pt>
                <c:pt idx="590">
                  <c:v>3.4811189169999999</c:v>
                </c:pt>
                <c:pt idx="591">
                  <c:v>3.4804170129999998</c:v>
                </c:pt>
                <c:pt idx="592">
                  <c:v>3.4697382449999998</c:v>
                </c:pt>
                <c:pt idx="593">
                  <c:v>3.4549143309999999</c:v>
                </c:pt>
                <c:pt idx="594">
                  <c:v>3.4357862469999998</c:v>
                </c:pt>
                <c:pt idx="595">
                  <c:v>3.4380700590000002</c:v>
                </c:pt>
                <c:pt idx="596">
                  <c:v>3.4242095950000002</c:v>
                </c:pt>
                <c:pt idx="597">
                  <c:v>3.4032583239999998</c:v>
                </c:pt>
                <c:pt idx="598">
                  <c:v>3.3990643020000002</c:v>
                </c:pt>
                <c:pt idx="599">
                  <c:v>3.3628125190000002</c:v>
                </c:pt>
                <c:pt idx="600">
                  <c:v>3.360153197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B66-D147-9B42-675919F504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564223"/>
        <c:axId val="33924127"/>
      </c:scatterChart>
      <c:valAx>
        <c:axId val="116564223"/>
        <c:scaling>
          <c:orientation val="minMax"/>
          <c:max val="650"/>
          <c:min val="28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924127"/>
        <c:crosses val="autoZero"/>
        <c:crossBetween val="midCat"/>
      </c:valAx>
      <c:valAx>
        <c:axId val="33924127"/>
        <c:scaling>
          <c:orientation val="minMax"/>
          <c:max val="0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656422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DAFCE6"/>
              </a:solidFill>
              <a:round/>
            </a:ln>
            <a:effectLst/>
          </c:spPr>
          <c:marker>
            <c:symbol val="none"/>
          </c:marker>
          <c:xVal>
            <c:numRef>
              <c:f>'[Chart 2 in Microsoft PowerPoint]Sheet1'!$A$5:$A$215</c:f>
              <c:numCache>
                <c:formatCode>General</c:formatCode>
                <c:ptCount val="211"/>
                <c:pt idx="0">
                  <c:v>490</c:v>
                </c:pt>
                <c:pt idx="1">
                  <c:v>491.05999759999997</c:v>
                </c:pt>
                <c:pt idx="2">
                  <c:v>491.9599915</c:v>
                </c:pt>
                <c:pt idx="3">
                  <c:v>493.02999879999999</c:v>
                </c:pt>
                <c:pt idx="4">
                  <c:v>493.92999270000001</c:v>
                </c:pt>
                <c:pt idx="5">
                  <c:v>495</c:v>
                </c:pt>
                <c:pt idx="6">
                  <c:v>496.05999759999997</c:v>
                </c:pt>
                <c:pt idx="7">
                  <c:v>496.9599915</c:v>
                </c:pt>
                <c:pt idx="8">
                  <c:v>498.02999879999999</c:v>
                </c:pt>
                <c:pt idx="9">
                  <c:v>498.92999270000001</c:v>
                </c:pt>
                <c:pt idx="10">
                  <c:v>500</c:v>
                </c:pt>
                <c:pt idx="11">
                  <c:v>501.0400085</c:v>
                </c:pt>
                <c:pt idx="12">
                  <c:v>501.94000240000003</c:v>
                </c:pt>
                <c:pt idx="13">
                  <c:v>502.98001099999999</c:v>
                </c:pt>
                <c:pt idx="14">
                  <c:v>504.01998900000001</c:v>
                </c:pt>
                <c:pt idx="15">
                  <c:v>505.07000729999999</c:v>
                </c:pt>
                <c:pt idx="16">
                  <c:v>505.97000120000001</c:v>
                </c:pt>
                <c:pt idx="17">
                  <c:v>507.01000979999998</c:v>
                </c:pt>
                <c:pt idx="18">
                  <c:v>508.0499878</c:v>
                </c:pt>
                <c:pt idx="19">
                  <c:v>508.9500122</c:v>
                </c:pt>
                <c:pt idx="20">
                  <c:v>510</c:v>
                </c:pt>
                <c:pt idx="21">
                  <c:v>511.0400085</c:v>
                </c:pt>
                <c:pt idx="22">
                  <c:v>511.94000240000003</c:v>
                </c:pt>
                <c:pt idx="23">
                  <c:v>512.97998050000001</c:v>
                </c:pt>
                <c:pt idx="24">
                  <c:v>514.02001949999999</c:v>
                </c:pt>
                <c:pt idx="25">
                  <c:v>515.07000730000004</c:v>
                </c:pt>
                <c:pt idx="26">
                  <c:v>515.96997069999998</c:v>
                </c:pt>
                <c:pt idx="27">
                  <c:v>517.01000980000003</c:v>
                </c:pt>
                <c:pt idx="28">
                  <c:v>518.04998780000005</c:v>
                </c:pt>
                <c:pt idx="29">
                  <c:v>518.95001219999995</c:v>
                </c:pt>
                <c:pt idx="30">
                  <c:v>520</c:v>
                </c:pt>
                <c:pt idx="31">
                  <c:v>521.03997800000002</c:v>
                </c:pt>
                <c:pt idx="32">
                  <c:v>521.94000240000003</c:v>
                </c:pt>
                <c:pt idx="33">
                  <c:v>522.97998050000001</c:v>
                </c:pt>
                <c:pt idx="34">
                  <c:v>524.02001949999999</c:v>
                </c:pt>
                <c:pt idx="35">
                  <c:v>525.07000730000004</c:v>
                </c:pt>
                <c:pt idx="36">
                  <c:v>525.96997069999998</c:v>
                </c:pt>
                <c:pt idx="37">
                  <c:v>527.01000980000003</c:v>
                </c:pt>
                <c:pt idx="38">
                  <c:v>528.04998780000005</c:v>
                </c:pt>
                <c:pt idx="39">
                  <c:v>528.95001219999995</c:v>
                </c:pt>
                <c:pt idx="40">
                  <c:v>530</c:v>
                </c:pt>
                <c:pt idx="41">
                  <c:v>531.03997800000002</c:v>
                </c:pt>
                <c:pt idx="42">
                  <c:v>531.94000240000003</c:v>
                </c:pt>
                <c:pt idx="43">
                  <c:v>532.97998050000001</c:v>
                </c:pt>
                <c:pt idx="44">
                  <c:v>534.02001949999999</c:v>
                </c:pt>
                <c:pt idx="45">
                  <c:v>535.07000730000004</c:v>
                </c:pt>
                <c:pt idx="46">
                  <c:v>535.96997069999998</c:v>
                </c:pt>
                <c:pt idx="47">
                  <c:v>537.01000980000003</c:v>
                </c:pt>
                <c:pt idx="48">
                  <c:v>538.04998780000005</c:v>
                </c:pt>
                <c:pt idx="49">
                  <c:v>538.95001219999995</c:v>
                </c:pt>
                <c:pt idx="50">
                  <c:v>540</c:v>
                </c:pt>
                <c:pt idx="51">
                  <c:v>541.02001949999999</c:v>
                </c:pt>
                <c:pt idx="52">
                  <c:v>542.04998780000005</c:v>
                </c:pt>
                <c:pt idx="53">
                  <c:v>542.94000240000003</c:v>
                </c:pt>
                <c:pt idx="54">
                  <c:v>543.96997069999998</c:v>
                </c:pt>
                <c:pt idx="55">
                  <c:v>545</c:v>
                </c:pt>
                <c:pt idx="56">
                  <c:v>546.02001949999999</c:v>
                </c:pt>
                <c:pt idx="57">
                  <c:v>547.04998780000005</c:v>
                </c:pt>
                <c:pt idx="58">
                  <c:v>547.94000240000003</c:v>
                </c:pt>
                <c:pt idx="59">
                  <c:v>548.96997069999998</c:v>
                </c:pt>
                <c:pt idx="60">
                  <c:v>550</c:v>
                </c:pt>
                <c:pt idx="61">
                  <c:v>551.03997800000002</c:v>
                </c:pt>
                <c:pt idx="62">
                  <c:v>551.94000240000003</c:v>
                </c:pt>
                <c:pt idx="63">
                  <c:v>552.97998050000001</c:v>
                </c:pt>
                <c:pt idx="64">
                  <c:v>554.02001949999999</c:v>
                </c:pt>
                <c:pt idx="65">
                  <c:v>555.07000730000004</c:v>
                </c:pt>
                <c:pt idx="66">
                  <c:v>555.96997069999998</c:v>
                </c:pt>
                <c:pt idx="67">
                  <c:v>557.01000980000003</c:v>
                </c:pt>
                <c:pt idx="68">
                  <c:v>558.04998780000005</c:v>
                </c:pt>
                <c:pt idx="69">
                  <c:v>558.95001219999995</c:v>
                </c:pt>
                <c:pt idx="70">
                  <c:v>560</c:v>
                </c:pt>
                <c:pt idx="71">
                  <c:v>561.02001949999999</c:v>
                </c:pt>
                <c:pt idx="72">
                  <c:v>562.04998780000005</c:v>
                </c:pt>
                <c:pt idx="73">
                  <c:v>562.94000240000003</c:v>
                </c:pt>
                <c:pt idx="74">
                  <c:v>563.96997069999998</c:v>
                </c:pt>
                <c:pt idx="75">
                  <c:v>565</c:v>
                </c:pt>
                <c:pt idx="76">
                  <c:v>566.02001949999999</c:v>
                </c:pt>
                <c:pt idx="77">
                  <c:v>567.04998780000005</c:v>
                </c:pt>
                <c:pt idx="78">
                  <c:v>567.94000240000003</c:v>
                </c:pt>
                <c:pt idx="79">
                  <c:v>568.96997069999998</c:v>
                </c:pt>
                <c:pt idx="80">
                  <c:v>570</c:v>
                </c:pt>
                <c:pt idx="81">
                  <c:v>571.02001949999999</c:v>
                </c:pt>
                <c:pt idx="82">
                  <c:v>572.04998780000005</c:v>
                </c:pt>
                <c:pt idx="83">
                  <c:v>572.94000240000003</c:v>
                </c:pt>
                <c:pt idx="84">
                  <c:v>573.96997069999998</c:v>
                </c:pt>
                <c:pt idx="85">
                  <c:v>575</c:v>
                </c:pt>
                <c:pt idx="86">
                  <c:v>576.02001949999999</c:v>
                </c:pt>
                <c:pt idx="87">
                  <c:v>577.04998780000005</c:v>
                </c:pt>
                <c:pt idx="88">
                  <c:v>577.94000240000003</c:v>
                </c:pt>
                <c:pt idx="89">
                  <c:v>578.96997069999998</c:v>
                </c:pt>
                <c:pt idx="90">
                  <c:v>580</c:v>
                </c:pt>
                <c:pt idx="91">
                  <c:v>581.02001949999999</c:v>
                </c:pt>
                <c:pt idx="92">
                  <c:v>582.04998780000005</c:v>
                </c:pt>
                <c:pt idx="93">
                  <c:v>582.94000240000003</c:v>
                </c:pt>
                <c:pt idx="94">
                  <c:v>583.96997069999998</c:v>
                </c:pt>
                <c:pt idx="95">
                  <c:v>585</c:v>
                </c:pt>
                <c:pt idx="96">
                  <c:v>586.02001949999999</c:v>
                </c:pt>
                <c:pt idx="97">
                  <c:v>587.04998780000005</c:v>
                </c:pt>
                <c:pt idx="98">
                  <c:v>587.94000240000003</c:v>
                </c:pt>
                <c:pt idx="99">
                  <c:v>588.96997069999998</c:v>
                </c:pt>
                <c:pt idx="100">
                  <c:v>590</c:v>
                </c:pt>
                <c:pt idx="101">
                  <c:v>591.02001949999999</c:v>
                </c:pt>
                <c:pt idx="102">
                  <c:v>592.04998780000005</c:v>
                </c:pt>
                <c:pt idx="103">
                  <c:v>592.94000240000003</c:v>
                </c:pt>
                <c:pt idx="104">
                  <c:v>593.96997069999998</c:v>
                </c:pt>
                <c:pt idx="105">
                  <c:v>595</c:v>
                </c:pt>
                <c:pt idx="106">
                  <c:v>596.02001949999999</c:v>
                </c:pt>
                <c:pt idx="107">
                  <c:v>597.04998780000005</c:v>
                </c:pt>
                <c:pt idx="108">
                  <c:v>597.94000240000003</c:v>
                </c:pt>
                <c:pt idx="109">
                  <c:v>598.96997069999998</c:v>
                </c:pt>
                <c:pt idx="110">
                  <c:v>600</c:v>
                </c:pt>
                <c:pt idx="111">
                  <c:v>601.02001949999999</c:v>
                </c:pt>
                <c:pt idx="112">
                  <c:v>602.04998780000005</c:v>
                </c:pt>
                <c:pt idx="113">
                  <c:v>602.94000240000003</c:v>
                </c:pt>
                <c:pt idx="114">
                  <c:v>603.96997069999998</c:v>
                </c:pt>
                <c:pt idx="115">
                  <c:v>605</c:v>
                </c:pt>
                <c:pt idx="116">
                  <c:v>606.02001949999999</c:v>
                </c:pt>
                <c:pt idx="117">
                  <c:v>607.04998780000005</c:v>
                </c:pt>
                <c:pt idx="118">
                  <c:v>607.94000240000003</c:v>
                </c:pt>
                <c:pt idx="119">
                  <c:v>608.96997069999998</c:v>
                </c:pt>
                <c:pt idx="120">
                  <c:v>610</c:v>
                </c:pt>
                <c:pt idx="121">
                  <c:v>611.01000980000003</c:v>
                </c:pt>
                <c:pt idx="122">
                  <c:v>612.02001949999999</c:v>
                </c:pt>
                <c:pt idx="123">
                  <c:v>613.03997800000002</c:v>
                </c:pt>
                <c:pt idx="124">
                  <c:v>614.04998780000005</c:v>
                </c:pt>
                <c:pt idx="125">
                  <c:v>615.07000730000004</c:v>
                </c:pt>
                <c:pt idx="126">
                  <c:v>615.94000240000003</c:v>
                </c:pt>
                <c:pt idx="127">
                  <c:v>616.95001219999995</c:v>
                </c:pt>
                <c:pt idx="128">
                  <c:v>617.96997069999998</c:v>
                </c:pt>
                <c:pt idx="129">
                  <c:v>618.97998050000001</c:v>
                </c:pt>
                <c:pt idx="130">
                  <c:v>620</c:v>
                </c:pt>
                <c:pt idx="131">
                  <c:v>621.01000980000003</c:v>
                </c:pt>
                <c:pt idx="132">
                  <c:v>622.02001949999999</c:v>
                </c:pt>
                <c:pt idx="133">
                  <c:v>623.03997800000002</c:v>
                </c:pt>
                <c:pt idx="134">
                  <c:v>624.04998780000005</c:v>
                </c:pt>
                <c:pt idx="135">
                  <c:v>625.07000730000004</c:v>
                </c:pt>
                <c:pt idx="136">
                  <c:v>625.94000240000003</c:v>
                </c:pt>
                <c:pt idx="137">
                  <c:v>626.95001219999995</c:v>
                </c:pt>
                <c:pt idx="138">
                  <c:v>627.96997069999998</c:v>
                </c:pt>
                <c:pt idx="139">
                  <c:v>628.97998050000001</c:v>
                </c:pt>
                <c:pt idx="140">
                  <c:v>630</c:v>
                </c:pt>
                <c:pt idx="141">
                  <c:v>631.01000980000003</c:v>
                </c:pt>
                <c:pt idx="142">
                  <c:v>632.02001949999999</c:v>
                </c:pt>
                <c:pt idx="143">
                  <c:v>633.03997800000002</c:v>
                </c:pt>
                <c:pt idx="144">
                  <c:v>634.04998780000005</c:v>
                </c:pt>
                <c:pt idx="145">
                  <c:v>635.07000730000004</c:v>
                </c:pt>
                <c:pt idx="146">
                  <c:v>635.94000240000003</c:v>
                </c:pt>
                <c:pt idx="147">
                  <c:v>636.95001219999995</c:v>
                </c:pt>
                <c:pt idx="148">
                  <c:v>637.96997069999998</c:v>
                </c:pt>
                <c:pt idx="149">
                  <c:v>638.97998050000001</c:v>
                </c:pt>
                <c:pt idx="150">
                  <c:v>640</c:v>
                </c:pt>
                <c:pt idx="151">
                  <c:v>641.01000980000003</c:v>
                </c:pt>
                <c:pt idx="152">
                  <c:v>642.02001949999999</c:v>
                </c:pt>
                <c:pt idx="153">
                  <c:v>643.03997800000002</c:v>
                </c:pt>
                <c:pt idx="154">
                  <c:v>644.04998780000005</c:v>
                </c:pt>
                <c:pt idx="155">
                  <c:v>645.07000730000004</c:v>
                </c:pt>
                <c:pt idx="156">
                  <c:v>645.94000240000003</c:v>
                </c:pt>
                <c:pt idx="157">
                  <c:v>646.95001219999995</c:v>
                </c:pt>
                <c:pt idx="158">
                  <c:v>647.96997069999998</c:v>
                </c:pt>
                <c:pt idx="159">
                  <c:v>648.97998050000001</c:v>
                </c:pt>
                <c:pt idx="160">
                  <c:v>650</c:v>
                </c:pt>
                <c:pt idx="161">
                  <c:v>651.01000980000003</c:v>
                </c:pt>
                <c:pt idx="162">
                  <c:v>652.02001949999999</c:v>
                </c:pt>
                <c:pt idx="163">
                  <c:v>653.03997800000002</c:v>
                </c:pt>
                <c:pt idx="164">
                  <c:v>654.04998780000005</c:v>
                </c:pt>
                <c:pt idx="165">
                  <c:v>655.07000730000004</c:v>
                </c:pt>
                <c:pt idx="166">
                  <c:v>655.94000240000003</c:v>
                </c:pt>
                <c:pt idx="167">
                  <c:v>656.95001219999995</c:v>
                </c:pt>
                <c:pt idx="168">
                  <c:v>657.96997069999998</c:v>
                </c:pt>
                <c:pt idx="169">
                  <c:v>658.97998050000001</c:v>
                </c:pt>
                <c:pt idx="170">
                  <c:v>660</c:v>
                </c:pt>
                <c:pt idx="171">
                  <c:v>661</c:v>
                </c:pt>
                <c:pt idx="172">
                  <c:v>662</c:v>
                </c:pt>
                <c:pt idx="173">
                  <c:v>663</c:v>
                </c:pt>
                <c:pt idx="174">
                  <c:v>664</c:v>
                </c:pt>
                <c:pt idx="175">
                  <c:v>665</c:v>
                </c:pt>
                <c:pt idx="176">
                  <c:v>666</c:v>
                </c:pt>
                <c:pt idx="177">
                  <c:v>667</c:v>
                </c:pt>
                <c:pt idx="178">
                  <c:v>668</c:v>
                </c:pt>
                <c:pt idx="179">
                  <c:v>669</c:v>
                </c:pt>
                <c:pt idx="180">
                  <c:v>670</c:v>
                </c:pt>
                <c:pt idx="181">
                  <c:v>671</c:v>
                </c:pt>
                <c:pt idx="182">
                  <c:v>672</c:v>
                </c:pt>
                <c:pt idx="183">
                  <c:v>673</c:v>
                </c:pt>
                <c:pt idx="184">
                  <c:v>674</c:v>
                </c:pt>
                <c:pt idx="185">
                  <c:v>675</c:v>
                </c:pt>
                <c:pt idx="186">
                  <c:v>676</c:v>
                </c:pt>
                <c:pt idx="187">
                  <c:v>677</c:v>
                </c:pt>
                <c:pt idx="188">
                  <c:v>678</c:v>
                </c:pt>
                <c:pt idx="189">
                  <c:v>679</c:v>
                </c:pt>
                <c:pt idx="190">
                  <c:v>680</c:v>
                </c:pt>
                <c:pt idx="191">
                  <c:v>681</c:v>
                </c:pt>
                <c:pt idx="192">
                  <c:v>682</c:v>
                </c:pt>
                <c:pt idx="193">
                  <c:v>683</c:v>
                </c:pt>
                <c:pt idx="194">
                  <c:v>684</c:v>
                </c:pt>
                <c:pt idx="195">
                  <c:v>685</c:v>
                </c:pt>
                <c:pt idx="196">
                  <c:v>686</c:v>
                </c:pt>
                <c:pt idx="197">
                  <c:v>687</c:v>
                </c:pt>
                <c:pt idx="198">
                  <c:v>688</c:v>
                </c:pt>
                <c:pt idx="199">
                  <c:v>689</c:v>
                </c:pt>
                <c:pt idx="200">
                  <c:v>690</c:v>
                </c:pt>
                <c:pt idx="201">
                  <c:v>691</c:v>
                </c:pt>
                <c:pt idx="202">
                  <c:v>692</c:v>
                </c:pt>
                <c:pt idx="203">
                  <c:v>693</c:v>
                </c:pt>
                <c:pt idx="204">
                  <c:v>694</c:v>
                </c:pt>
                <c:pt idx="205">
                  <c:v>695</c:v>
                </c:pt>
                <c:pt idx="206">
                  <c:v>696</c:v>
                </c:pt>
                <c:pt idx="207">
                  <c:v>697</c:v>
                </c:pt>
                <c:pt idx="208">
                  <c:v>698</c:v>
                </c:pt>
                <c:pt idx="209">
                  <c:v>699</c:v>
                </c:pt>
                <c:pt idx="210">
                  <c:v>700</c:v>
                </c:pt>
              </c:numCache>
            </c:numRef>
          </c:xVal>
          <c:yVal>
            <c:numRef>
              <c:f>'[Chart 2 in Microsoft PowerPoint]Sheet1'!$B$5:$B$215</c:f>
              <c:numCache>
                <c:formatCode>General</c:formatCode>
                <c:ptCount val="211"/>
                <c:pt idx="0">
                  <c:v>36.852916720000003</c:v>
                </c:pt>
                <c:pt idx="1">
                  <c:v>10.11247826</c:v>
                </c:pt>
                <c:pt idx="2">
                  <c:v>2.993222475</c:v>
                </c:pt>
                <c:pt idx="3">
                  <c:v>2.0361070630000002</c:v>
                </c:pt>
                <c:pt idx="4">
                  <c:v>1.7581377030000001</c:v>
                </c:pt>
                <c:pt idx="5">
                  <c:v>1.4820170399999999</c:v>
                </c:pt>
                <c:pt idx="6">
                  <c:v>1.5266842839999999</c:v>
                </c:pt>
                <c:pt idx="7">
                  <c:v>1.47005856</c:v>
                </c:pt>
                <c:pt idx="8">
                  <c:v>1.609669805</c:v>
                </c:pt>
                <c:pt idx="9">
                  <c:v>1.608210564</c:v>
                </c:pt>
                <c:pt idx="10">
                  <c:v>1.5208734269999999</c:v>
                </c:pt>
                <c:pt idx="11">
                  <c:v>1.5579838749999999</c:v>
                </c:pt>
                <c:pt idx="12">
                  <c:v>1.631642222</c:v>
                </c:pt>
                <c:pt idx="13">
                  <c:v>1.697965264</c:v>
                </c:pt>
                <c:pt idx="14">
                  <c:v>1.6019870039999999</c:v>
                </c:pt>
                <c:pt idx="15">
                  <c:v>1.652491927</c:v>
                </c:pt>
                <c:pt idx="16">
                  <c:v>1.737154603</c:v>
                </c:pt>
                <c:pt idx="17">
                  <c:v>1.7287350889999999</c:v>
                </c:pt>
                <c:pt idx="18">
                  <c:v>1.736798048</c:v>
                </c:pt>
                <c:pt idx="19">
                  <c:v>1.7929179669999999</c:v>
                </c:pt>
                <c:pt idx="20">
                  <c:v>1.8130643369999999</c:v>
                </c:pt>
                <c:pt idx="21">
                  <c:v>1.7614254949999999</c:v>
                </c:pt>
                <c:pt idx="22">
                  <c:v>1.766836047</c:v>
                </c:pt>
                <c:pt idx="23">
                  <c:v>1.7329375739999999</c:v>
                </c:pt>
                <c:pt idx="24">
                  <c:v>1.756049752</c:v>
                </c:pt>
                <c:pt idx="25">
                  <c:v>1.68178308</c:v>
                </c:pt>
                <c:pt idx="26">
                  <c:v>1.7440447809999999</c:v>
                </c:pt>
                <c:pt idx="27">
                  <c:v>1.6124776599999999</c:v>
                </c:pt>
                <c:pt idx="28">
                  <c:v>1.7463065390000001</c:v>
                </c:pt>
                <c:pt idx="29">
                  <c:v>1.752590179</c:v>
                </c:pt>
                <c:pt idx="30">
                  <c:v>1.6307436230000001</c:v>
                </c:pt>
                <c:pt idx="31">
                  <c:v>1.4976949690000001</c:v>
                </c:pt>
                <c:pt idx="32">
                  <c:v>1.6359014510000001</c:v>
                </c:pt>
                <c:pt idx="33">
                  <c:v>1.541793585</c:v>
                </c:pt>
                <c:pt idx="34">
                  <c:v>1.5927559140000001</c:v>
                </c:pt>
                <c:pt idx="35">
                  <c:v>1.607190967</c:v>
                </c:pt>
                <c:pt idx="36">
                  <c:v>1.46322453</c:v>
                </c:pt>
                <c:pt idx="37">
                  <c:v>1.429498792</c:v>
                </c:pt>
                <c:pt idx="38">
                  <c:v>1.6352990869999999</c:v>
                </c:pt>
                <c:pt idx="39">
                  <c:v>1.4282888170000001</c:v>
                </c:pt>
                <c:pt idx="40">
                  <c:v>1.577993274</c:v>
                </c:pt>
                <c:pt idx="41">
                  <c:v>1.380695343</c:v>
                </c:pt>
                <c:pt idx="42">
                  <c:v>1.508781672</c:v>
                </c:pt>
                <c:pt idx="43">
                  <c:v>1.4635396000000001</c:v>
                </c:pt>
                <c:pt idx="44">
                  <c:v>1.461499214</c:v>
                </c:pt>
                <c:pt idx="45">
                  <c:v>1.4278297419999999</c:v>
                </c:pt>
                <c:pt idx="46">
                  <c:v>1.3649300339999999</c:v>
                </c:pt>
                <c:pt idx="47">
                  <c:v>1.3923596140000001</c:v>
                </c:pt>
                <c:pt idx="48">
                  <c:v>1.2501006130000001</c:v>
                </c:pt>
                <c:pt idx="49">
                  <c:v>1.383634925</c:v>
                </c:pt>
                <c:pt idx="50">
                  <c:v>1.4137094020000001</c:v>
                </c:pt>
                <c:pt idx="51">
                  <c:v>1.3106838460000001</c:v>
                </c:pt>
                <c:pt idx="52">
                  <c:v>1.333698869</c:v>
                </c:pt>
                <c:pt idx="53">
                  <c:v>1.266751051</c:v>
                </c:pt>
                <c:pt idx="54">
                  <c:v>1.2803531889999999</c:v>
                </c:pt>
                <c:pt idx="55">
                  <c:v>1.3500623700000001</c:v>
                </c:pt>
                <c:pt idx="56">
                  <c:v>1.268291235</c:v>
                </c:pt>
                <c:pt idx="57">
                  <c:v>1.2831448320000001</c:v>
                </c:pt>
                <c:pt idx="58">
                  <c:v>1.2566342349999999</c:v>
                </c:pt>
                <c:pt idx="59">
                  <c:v>1.173409462</c:v>
                </c:pt>
                <c:pt idx="60">
                  <c:v>1.1897591350000001</c:v>
                </c:pt>
                <c:pt idx="61">
                  <c:v>1.1910662649999999</c:v>
                </c:pt>
                <c:pt idx="62">
                  <c:v>1.183062077</c:v>
                </c:pt>
                <c:pt idx="63">
                  <c:v>1.0363836289999999</c:v>
                </c:pt>
                <c:pt idx="64">
                  <c:v>1.039301872</c:v>
                </c:pt>
                <c:pt idx="65">
                  <c:v>1.097452283</c:v>
                </c:pt>
                <c:pt idx="66">
                  <c:v>1.14313519</c:v>
                </c:pt>
                <c:pt idx="67">
                  <c:v>1.1427025790000001</c:v>
                </c:pt>
                <c:pt idx="68">
                  <c:v>1.075268865</c:v>
                </c:pt>
                <c:pt idx="69">
                  <c:v>0.91219222550000001</c:v>
                </c:pt>
                <c:pt idx="70">
                  <c:v>0.9795845151</c:v>
                </c:pt>
                <c:pt idx="71">
                  <c:v>1.0021613840000001</c:v>
                </c:pt>
                <c:pt idx="72">
                  <c:v>0.98525816200000005</c:v>
                </c:pt>
                <c:pt idx="73">
                  <c:v>1.0078939200000001</c:v>
                </c:pt>
                <c:pt idx="74">
                  <c:v>0.99044561389999997</c:v>
                </c:pt>
                <c:pt idx="75">
                  <c:v>0.93729704619999998</c:v>
                </c:pt>
                <c:pt idx="76">
                  <c:v>0.93326771259999997</c:v>
                </c:pt>
                <c:pt idx="77">
                  <c:v>0.93657815460000005</c:v>
                </c:pt>
                <c:pt idx="78">
                  <c:v>1.0179693700000001</c:v>
                </c:pt>
                <c:pt idx="79">
                  <c:v>0.98285543919999996</c:v>
                </c:pt>
                <c:pt idx="80">
                  <c:v>0.91940832139999995</c:v>
                </c:pt>
                <c:pt idx="81">
                  <c:v>0.89336472749999996</c:v>
                </c:pt>
                <c:pt idx="82">
                  <c:v>0.79636031389999995</c:v>
                </c:pt>
                <c:pt idx="83">
                  <c:v>0.95249432329999995</c:v>
                </c:pt>
                <c:pt idx="84">
                  <c:v>0.88719338179999996</c:v>
                </c:pt>
                <c:pt idx="85">
                  <c:v>0.75951629880000004</c:v>
                </c:pt>
                <c:pt idx="86">
                  <c:v>0.84099286790000005</c:v>
                </c:pt>
                <c:pt idx="87">
                  <c:v>0.78287714720000001</c:v>
                </c:pt>
                <c:pt idx="88">
                  <c:v>0.80098766089999995</c:v>
                </c:pt>
                <c:pt idx="89">
                  <c:v>0.75717818739999998</c:v>
                </c:pt>
                <c:pt idx="90">
                  <c:v>0.78581643099999998</c:v>
                </c:pt>
                <c:pt idx="91">
                  <c:v>0.62113213540000001</c:v>
                </c:pt>
                <c:pt idx="92">
                  <c:v>0.72739684579999997</c:v>
                </c:pt>
                <c:pt idx="93">
                  <c:v>0.60559064149999997</c:v>
                </c:pt>
                <c:pt idx="94">
                  <c:v>0.60170710090000001</c:v>
                </c:pt>
                <c:pt idx="95">
                  <c:v>0.57279306649999995</c:v>
                </c:pt>
                <c:pt idx="96">
                  <c:v>0.58564937110000004</c:v>
                </c:pt>
                <c:pt idx="97">
                  <c:v>0.6013809443</c:v>
                </c:pt>
                <c:pt idx="98">
                  <c:v>0.66764092450000001</c:v>
                </c:pt>
                <c:pt idx="99">
                  <c:v>0.60121893879999999</c:v>
                </c:pt>
                <c:pt idx="100">
                  <c:v>0.55441385509999996</c:v>
                </c:pt>
                <c:pt idx="101">
                  <c:v>0.49628892540000002</c:v>
                </c:pt>
                <c:pt idx="102">
                  <c:v>0.53788745400000004</c:v>
                </c:pt>
                <c:pt idx="103">
                  <c:v>0.53732544179999997</c:v>
                </c:pt>
                <c:pt idx="104">
                  <c:v>0.482793957</c:v>
                </c:pt>
                <c:pt idx="105">
                  <c:v>0.5154716372</c:v>
                </c:pt>
                <c:pt idx="106">
                  <c:v>0.50513678790000005</c:v>
                </c:pt>
                <c:pt idx="107">
                  <c:v>0.44295957679999998</c:v>
                </c:pt>
                <c:pt idx="108">
                  <c:v>0.49837103490000001</c:v>
                </c:pt>
                <c:pt idx="109">
                  <c:v>0.41148260240000001</c:v>
                </c:pt>
                <c:pt idx="110">
                  <c:v>0.46650424600000001</c:v>
                </c:pt>
                <c:pt idx="111">
                  <c:v>0.47549724580000002</c:v>
                </c:pt>
                <c:pt idx="112">
                  <c:v>0.39339104289999999</c:v>
                </c:pt>
                <c:pt idx="113">
                  <c:v>0.36771327259999997</c:v>
                </c:pt>
                <c:pt idx="114">
                  <c:v>0.3290629685</c:v>
                </c:pt>
                <c:pt idx="115">
                  <c:v>0.39200603960000002</c:v>
                </c:pt>
                <c:pt idx="116">
                  <c:v>0.34409245849999998</c:v>
                </c:pt>
                <c:pt idx="117">
                  <c:v>0.3137137592</c:v>
                </c:pt>
                <c:pt idx="118">
                  <c:v>0.31785926219999999</c:v>
                </c:pt>
                <c:pt idx="119">
                  <c:v>0.37010446190000001</c:v>
                </c:pt>
                <c:pt idx="120">
                  <c:v>0.33500090240000002</c:v>
                </c:pt>
                <c:pt idx="121">
                  <c:v>0.328971982</c:v>
                </c:pt>
                <c:pt idx="122">
                  <c:v>0.40022531150000001</c:v>
                </c:pt>
                <c:pt idx="123">
                  <c:v>0.30968883629999999</c:v>
                </c:pt>
                <c:pt idx="124">
                  <c:v>0.31955054399999999</c:v>
                </c:pt>
                <c:pt idx="125">
                  <c:v>0.3038612604</c:v>
                </c:pt>
                <c:pt idx="126">
                  <c:v>0.33992239829999998</c:v>
                </c:pt>
                <c:pt idx="127">
                  <c:v>0.26704448460000002</c:v>
                </c:pt>
                <c:pt idx="128">
                  <c:v>0.31297272440000001</c:v>
                </c:pt>
                <c:pt idx="129">
                  <c:v>0.30324995519999998</c:v>
                </c:pt>
                <c:pt idx="130">
                  <c:v>0.31114566329999999</c:v>
                </c:pt>
                <c:pt idx="131">
                  <c:v>0.2150473893</c:v>
                </c:pt>
                <c:pt idx="132">
                  <c:v>0.221791774</c:v>
                </c:pt>
                <c:pt idx="133">
                  <c:v>0.2444353849</c:v>
                </c:pt>
                <c:pt idx="134">
                  <c:v>0.25343820449999999</c:v>
                </c:pt>
                <c:pt idx="135">
                  <c:v>0.26516601439999998</c:v>
                </c:pt>
                <c:pt idx="136">
                  <c:v>0.1846462935</c:v>
                </c:pt>
                <c:pt idx="137">
                  <c:v>0.25051024560000001</c:v>
                </c:pt>
                <c:pt idx="138">
                  <c:v>0.22044721249999999</c:v>
                </c:pt>
                <c:pt idx="139">
                  <c:v>0.15453448889999999</c:v>
                </c:pt>
                <c:pt idx="140">
                  <c:v>0.181569919</c:v>
                </c:pt>
                <c:pt idx="141">
                  <c:v>0.22544962169999999</c:v>
                </c:pt>
                <c:pt idx="142">
                  <c:v>0.17519782480000001</c:v>
                </c:pt>
                <c:pt idx="143">
                  <c:v>0.1391635537</c:v>
                </c:pt>
                <c:pt idx="144">
                  <c:v>0.19694803659999999</c:v>
                </c:pt>
                <c:pt idx="145">
                  <c:v>0.203793481</c:v>
                </c:pt>
                <c:pt idx="146">
                  <c:v>0.13864059749999999</c:v>
                </c:pt>
                <c:pt idx="147">
                  <c:v>0.16794572769999999</c:v>
                </c:pt>
                <c:pt idx="148">
                  <c:v>0.16154257950000001</c:v>
                </c:pt>
                <c:pt idx="149">
                  <c:v>9.5833458009999997E-2</c:v>
                </c:pt>
                <c:pt idx="150">
                  <c:v>0.17444522679999999</c:v>
                </c:pt>
                <c:pt idx="151">
                  <c:v>0.10902509840000001</c:v>
                </c:pt>
                <c:pt idx="152">
                  <c:v>0.1029290631</c:v>
                </c:pt>
                <c:pt idx="153">
                  <c:v>0.175815165</c:v>
                </c:pt>
                <c:pt idx="154">
                  <c:v>0.15331152079999999</c:v>
                </c:pt>
                <c:pt idx="155">
                  <c:v>0.14625869690000001</c:v>
                </c:pt>
                <c:pt idx="156">
                  <c:v>0.1528951824</c:v>
                </c:pt>
                <c:pt idx="157">
                  <c:v>0.17578296360000001</c:v>
                </c:pt>
                <c:pt idx="158">
                  <c:v>0.1103070974</c:v>
                </c:pt>
                <c:pt idx="159">
                  <c:v>0.13377428050000001</c:v>
                </c:pt>
                <c:pt idx="160">
                  <c:v>0.11869172009999999</c:v>
                </c:pt>
                <c:pt idx="161">
                  <c:v>0.13348659869999999</c:v>
                </c:pt>
                <c:pt idx="162">
                  <c:v>8.8435575370000005E-2</c:v>
                </c:pt>
                <c:pt idx="163">
                  <c:v>5.9515837580000001E-2</c:v>
                </c:pt>
                <c:pt idx="164">
                  <c:v>0.1477061361</c:v>
                </c:pt>
                <c:pt idx="165">
                  <c:v>0.1108418107</c:v>
                </c:pt>
                <c:pt idx="166">
                  <c:v>4.4671110809999998E-2</c:v>
                </c:pt>
                <c:pt idx="167">
                  <c:v>0.1617539972</c:v>
                </c:pt>
                <c:pt idx="168">
                  <c:v>0.1127327904</c:v>
                </c:pt>
                <c:pt idx="169">
                  <c:v>0.12543997170000001</c:v>
                </c:pt>
                <c:pt idx="170">
                  <c:v>0.12534563239999999</c:v>
                </c:pt>
                <c:pt idx="171">
                  <c:v>8.1584826109999994E-2</c:v>
                </c:pt>
                <c:pt idx="172">
                  <c:v>0.11084098370000001</c:v>
                </c:pt>
                <c:pt idx="173">
                  <c:v>8.9773319660000003E-2</c:v>
                </c:pt>
                <c:pt idx="174">
                  <c:v>8.9380815629999999E-2</c:v>
                </c:pt>
                <c:pt idx="175">
                  <c:v>0.1117951348</c:v>
                </c:pt>
                <c:pt idx="176">
                  <c:v>0.17801116410000001</c:v>
                </c:pt>
                <c:pt idx="177">
                  <c:v>9.5902740959999996E-2</c:v>
                </c:pt>
                <c:pt idx="178">
                  <c:v>0.1059731022</c:v>
                </c:pt>
                <c:pt idx="179">
                  <c:v>0.1268505305</c:v>
                </c:pt>
                <c:pt idx="180">
                  <c:v>0.12632267180000001</c:v>
                </c:pt>
                <c:pt idx="181">
                  <c:v>0.1482887417</c:v>
                </c:pt>
                <c:pt idx="182">
                  <c:v>0.1034271345</c:v>
                </c:pt>
                <c:pt idx="183">
                  <c:v>5.8779876680000002E-2</c:v>
                </c:pt>
                <c:pt idx="184">
                  <c:v>7.3769703510000006E-2</c:v>
                </c:pt>
                <c:pt idx="185">
                  <c:v>3.6781202999999998E-2</c:v>
                </c:pt>
                <c:pt idx="186">
                  <c:v>0.14604295789999999</c:v>
                </c:pt>
                <c:pt idx="187">
                  <c:v>-2.2141039370000001E-2</c:v>
                </c:pt>
                <c:pt idx="188">
                  <c:v>6.6015794870000005E-2</c:v>
                </c:pt>
                <c:pt idx="189">
                  <c:v>5.8981824670000002E-2</c:v>
                </c:pt>
                <c:pt idx="190">
                  <c:v>6.6606476900000003E-2</c:v>
                </c:pt>
                <c:pt idx="191">
                  <c:v>0.1103923321</c:v>
                </c:pt>
                <c:pt idx="192">
                  <c:v>6.7709900439999998E-2</c:v>
                </c:pt>
                <c:pt idx="193">
                  <c:v>0.11002149429999999</c:v>
                </c:pt>
                <c:pt idx="194">
                  <c:v>3.6992646749999997E-2</c:v>
                </c:pt>
                <c:pt idx="195">
                  <c:v>7.2739966210000007E-2</c:v>
                </c:pt>
                <c:pt idx="196">
                  <c:v>3.6717727780000001E-2</c:v>
                </c:pt>
                <c:pt idx="197">
                  <c:v>5.1666237410000003E-2</c:v>
                </c:pt>
                <c:pt idx="198">
                  <c:v>8.1582404669999997E-2</c:v>
                </c:pt>
                <c:pt idx="199">
                  <c:v>8.806110919E-2</c:v>
                </c:pt>
                <c:pt idx="200">
                  <c:v>0.12424266339999999</c:v>
                </c:pt>
                <c:pt idx="201">
                  <c:v>6.7051090300000005E-2</c:v>
                </c:pt>
                <c:pt idx="202">
                  <c:v>6.5650783480000002E-2</c:v>
                </c:pt>
                <c:pt idx="203">
                  <c:v>5.8602046220000002E-2</c:v>
                </c:pt>
                <c:pt idx="204">
                  <c:v>5.1332443950000001E-2</c:v>
                </c:pt>
                <c:pt idx="205">
                  <c:v>6.5593838690000003E-2</c:v>
                </c:pt>
                <c:pt idx="206">
                  <c:v>7.3184475299999996E-2</c:v>
                </c:pt>
                <c:pt idx="207">
                  <c:v>3.6937441680000002E-2</c:v>
                </c:pt>
                <c:pt idx="208">
                  <c:v>6.6116668279999999E-2</c:v>
                </c:pt>
                <c:pt idx="209">
                  <c:v>8.7886974219999997E-2</c:v>
                </c:pt>
                <c:pt idx="210">
                  <c:v>8.7886333469999994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D38-AA4A-ABFA-E207AACADD67}"/>
            </c:ext>
          </c:extLst>
        </c:ser>
        <c:ser>
          <c:idx val="1"/>
          <c:order val="1"/>
          <c:spPr>
            <a:ln w="19050" cap="rnd">
              <a:solidFill>
                <a:srgbClr val="D6F2CC"/>
              </a:solidFill>
              <a:round/>
            </a:ln>
            <a:effectLst/>
          </c:spPr>
          <c:marker>
            <c:symbol val="none"/>
          </c:marker>
          <c:xVal>
            <c:numRef>
              <c:f>'[Chart 2 in Microsoft PowerPoint]Sheet1'!$A$5:$A$215</c:f>
              <c:numCache>
                <c:formatCode>General</c:formatCode>
                <c:ptCount val="211"/>
                <c:pt idx="0">
                  <c:v>490</c:v>
                </c:pt>
                <c:pt idx="1">
                  <c:v>491.05999759999997</c:v>
                </c:pt>
                <c:pt idx="2">
                  <c:v>491.9599915</c:v>
                </c:pt>
                <c:pt idx="3">
                  <c:v>493.02999879999999</c:v>
                </c:pt>
                <c:pt idx="4">
                  <c:v>493.92999270000001</c:v>
                </c:pt>
                <c:pt idx="5">
                  <c:v>495</c:v>
                </c:pt>
                <c:pt idx="6">
                  <c:v>496.05999759999997</c:v>
                </c:pt>
                <c:pt idx="7">
                  <c:v>496.9599915</c:v>
                </c:pt>
                <c:pt idx="8">
                  <c:v>498.02999879999999</c:v>
                </c:pt>
                <c:pt idx="9">
                  <c:v>498.92999270000001</c:v>
                </c:pt>
                <c:pt idx="10">
                  <c:v>500</c:v>
                </c:pt>
                <c:pt idx="11">
                  <c:v>501.0400085</c:v>
                </c:pt>
                <c:pt idx="12">
                  <c:v>501.94000240000003</c:v>
                </c:pt>
                <c:pt idx="13">
                  <c:v>502.98001099999999</c:v>
                </c:pt>
                <c:pt idx="14">
                  <c:v>504.01998900000001</c:v>
                </c:pt>
                <c:pt idx="15">
                  <c:v>505.07000729999999</c:v>
                </c:pt>
                <c:pt idx="16">
                  <c:v>505.97000120000001</c:v>
                </c:pt>
                <c:pt idx="17">
                  <c:v>507.01000979999998</c:v>
                </c:pt>
                <c:pt idx="18">
                  <c:v>508.0499878</c:v>
                </c:pt>
                <c:pt idx="19">
                  <c:v>508.9500122</c:v>
                </c:pt>
                <c:pt idx="20">
                  <c:v>510</c:v>
                </c:pt>
                <c:pt idx="21">
                  <c:v>511.0400085</c:v>
                </c:pt>
                <c:pt idx="22">
                  <c:v>511.94000240000003</c:v>
                </c:pt>
                <c:pt idx="23">
                  <c:v>512.97998050000001</c:v>
                </c:pt>
                <c:pt idx="24">
                  <c:v>514.02001949999999</c:v>
                </c:pt>
                <c:pt idx="25">
                  <c:v>515.07000730000004</c:v>
                </c:pt>
                <c:pt idx="26">
                  <c:v>515.96997069999998</c:v>
                </c:pt>
                <c:pt idx="27">
                  <c:v>517.01000980000003</c:v>
                </c:pt>
                <c:pt idx="28">
                  <c:v>518.04998780000005</c:v>
                </c:pt>
                <c:pt idx="29">
                  <c:v>518.95001219999995</c:v>
                </c:pt>
                <c:pt idx="30">
                  <c:v>520</c:v>
                </c:pt>
                <c:pt idx="31">
                  <c:v>521.03997800000002</c:v>
                </c:pt>
                <c:pt idx="32">
                  <c:v>521.94000240000003</c:v>
                </c:pt>
                <c:pt idx="33">
                  <c:v>522.97998050000001</c:v>
                </c:pt>
                <c:pt idx="34">
                  <c:v>524.02001949999999</c:v>
                </c:pt>
                <c:pt idx="35">
                  <c:v>525.07000730000004</c:v>
                </c:pt>
                <c:pt idx="36">
                  <c:v>525.96997069999998</c:v>
                </c:pt>
                <c:pt idx="37">
                  <c:v>527.01000980000003</c:v>
                </c:pt>
                <c:pt idx="38">
                  <c:v>528.04998780000005</c:v>
                </c:pt>
                <c:pt idx="39">
                  <c:v>528.95001219999995</c:v>
                </c:pt>
                <c:pt idx="40">
                  <c:v>530</c:v>
                </c:pt>
                <c:pt idx="41">
                  <c:v>531.03997800000002</c:v>
                </c:pt>
                <c:pt idx="42">
                  <c:v>531.94000240000003</c:v>
                </c:pt>
                <c:pt idx="43">
                  <c:v>532.97998050000001</c:v>
                </c:pt>
                <c:pt idx="44">
                  <c:v>534.02001949999999</c:v>
                </c:pt>
                <c:pt idx="45">
                  <c:v>535.07000730000004</c:v>
                </c:pt>
                <c:pt idx="46">
                  <c:v>535.96997069999998</c:v>
                </c:pt>
                <c:pt idx="47">
                  <c:v>537.01000980000003</c:v>
                </c:pt>
                <c:pt idx="48">
                  <c:v>538.04998780000005</c:v>
                </c:pt>
                <c:pt idx="49">
                  <c:v>538.95001219999995</c:v>
                </c:pt>
                <c:pt idx="50">
                  <c:v>540</c:v>
                </c:pt>
                <c:pt idx="51">
                  <c:v>541.02001949999999</c:v>
                </c:pt>
                <c:pt idx="52">
                  <c:v>542.04998780000005</c:v>
                </c:pt>
                <c:pt idx="53">
                  <c:v>542.94000240000003</c:v>
                </c:pt>
                <c:pt idx="54">
                  <c:v>543.96997069999998</c:v>
                </c:pt>
                <c:pt idx="55">
                  <c:v>545</c:v>
                </c:pt>
                <c:pt idx="56">
                  <c:v>546.02001949999999</c:v>
                </c:pt>
                <c:pt idx="57">
                  <c:v>547.04998780000005</c:v>
                </c:pt>
                <c:pt idx="58">
                  <c:v>547.94000240000003</c:v>
                </c:pt>
                <c:pt idx="59">
                  <c:v>548.96997069999998</c:v>
                </c:pt>
                <c:pt idx="60">
                  <c:v>550</c:v>
                </c:pt>
                <c:pt idx="61">
                  <c:v>551.03997800000002</c:v>
                </c:pt>
                <c:pt idx="62">
                  <c:v>551.94000240000003</c:v>
                </c:pt>
                <c:pt idx="63">
                  <c:v>552.97998050000001</c:v>
                </c:pt>
                <c:pt idx="64">
                  <c:v>554.02001949999999</c:v>
                </c:pt>
                <c:pt idx="65">
                  <c:v>555.07000730000004</c:v>
                </c:pt>
                <c:pt idx="66">
                  <c:v>555.96997069999998</c:v>
                </c:pt>
                <c:pt idx="67">
                  <c:v>557.01000980000003</c:v>
                </c:pt>
                <c:pt idx="68">
                  <c:v>558.04998780000005</c:v>
                </c:pt>
                <c:pt idx="69">
                  <c:v>558.95001219999995</c:v>
                </c:pt>
                <c:pt idx="70">
                  <c:v>560</c:v>
                </c:pt>
                <c:pt idx="71">
                  <c:v>561.02001949999999</c:v>
                </c:pt>
                <c:pt idx="72">
                  <c:v>562.04998780000005</c:v>
                </c:pt>
                <c:pt idx="73">
                  <c:v>562.94000240000003</c:v>
                </c:pt>
                <c:pt idx="74">
                  <c:v>563.96997069999998</c:v>
                </c:pt>
                <c:pt idx="75">
                  <c:v>565</c:v>
                </c:pt>
                <c:pt idx="76">
                  <c:v>566.02001949999999</c:v>
                </c:pt>
                <c:pt idx="77">
                  <c:v>567.04998780000005</c:v>
                </c:pt>
                <c:pt idx="78">
                  <c:v>567.94000240000003</c:v>
                </c:pt>
                <c:pt idx="79">
                  <c:v>568.96997069999998</c:v>
                </c:pt>
                <c:pt idx="80">
                  <c:v>570</c:v>
                </c:pt>
                <c:pt idx="81">
                  <c:v>571.02001949999999</c:v>
                </c:pt>
                <c:pt idx="82">
                  <c:v>572.04998780000005</c:v>
                </c:pt>
                <c:pt idx="83">
                  <c:v>572.94000240000003</c:v>
                </c:pt>
                <c:pt idx="84">
                  <c:v>573.96997069999998</c:v>
                </c:pt>
                <c:pt idx="85">
                  <c:v>575</c:v>
                </c:pt>
                <c:pt idx="86">
                  <c:v>576.02001949999999</c:v>
                </c:pt>
                <c:pt idx="87">
                  <c:v>577.04998780000005</c:v>
                </c:pt>
                <c:pt idx="88">
                  <c:v>577.94000240000003</c:v>
                </c:pt>
                <c:pt idx="89">
                  <c:v>578.96997069999998</c:v>
                </c:pt>
                <c:pt idx="90">
                  <c:v>580</c:v>
                </c:pt>
                <c:pt idx="91">
                  <c:v>581.02001949999999</c:v>
                </c:pt>
                <c:pt idx="92">
                  <c:v>582.04998780000005</c:v>
                </c:pt>
                <c:pt idx="93">
                  <c:v>582.94000240000003</c:v>
                </c:pt>
                <c:pt idx="94">
                  <c:v>583.96997069999998</c:v>
                </c:pt>
                <c:pt idx="95">
                  <c:v>585</c:v>
                </c:pt>
                <c:pt idx="96">
                  <c:v>586.02001949999999</c:v>
                </c:pt>
                <c:pt idx="97">
                  <c:v>587.04998780000005</c:v>
                </c:pt>
                <c:pt idx="98">
                  <c:v>587.94000240000003</c:v>
                </c:pt>
                <c:pt idx="99">
                  <c:v>588.96997069999998</c:v>
                </c:pt>
                <c:pt idx="100">
                  <c:v>590</c:v>
                </c:pt>
                <c:pt idx="101">
                  <c:v>591.02001949999999</c:v>
                </c:pt>
                <c:pt idx="102">
                  <c:v>592.04998780000005</c:v>
                </c:pt>
                <c:pt idx="103">
                  <c:v>592.94000240000003</c:v>
                </c:pt>
                <c:pt idx="104">
                  <c:v>593.96997069999998</c:v>
                </c:pt>
                <c:pt idx="105">
                  <c:v>595</c:v>
                </c:pt>
                <c:pt idx="106">
                  <c:v>596.02001949999999</c:v>
                </c:pt>
                <c:pt idx="107">
                  <c:v>597.04998780000005</c:v>
                </c:pt>
                <c:pt idx="108">
                  <c:v>597.94000240000003</c:v>
                </c:pt>
                <c:pt idx="109">
                  <c:v>598.96997069999998</c:v>
                </c:pt>
                <c:pt idx="110">
                  <c:v>600</c:v>
                </c:pt>
                <c:pt idx="111">
                  <c:v>601.02001949999999</c:v>
                </c:pt>
                <c:pt idx="112">
                  <c:v>602.04998780000005</c:v>
                </c:pt>
                <c:pt idx="113">
                  <c:v>602.94000240000003</c:v>
                </c:pt>
                <c:pt idx="114">
                  <c:v>603.96997069999998</c:v>
                </c:pt>
                <c:pt idx="115">
                  <c:v>605</c:v>
                </c:pt>
                <c:pt idx="116">
                  <c:v>606.02001949999999</c:v>
                </c:pt>
                <c:pt idx="117">
                  <c:v>607.04998780000005</c:v>
                </c:pt>
                <c:pt idx="118">
                  <c:v>607.94000240000003</c:v>
                </c:pt>
                <c:pt idx="119">
                  <c:v>608.96997069999998</c:v>
                </c:pt>
                <c:pt idx="120">
                  <c:v>610</c:v>
                </c:pt>
                <c:pt idx="121">
                  <c:v>611.01000980000003</c:v>
                </c:pt>
                <c:pt idx="122">
                  <c:v>612.02001949999999</c:v>
                </c:pt>
                <c:pt idx="123">
                  <c:v>613.03997800000002</c:v>
                </c:pt>
                <c:pt idx="124">
                  <c:v>614.04998780000005</c:v>
                </c:pt>
                <c:pt idx="125">
                  <c:v>615.07000730000004</c:v>
                </c:pt>
                <c:pt idx="126">
                  <c:v>615.94000240000003</c:v>
                </c:pt>
                <c:pt idx="127">
                  <c:v>616.95001219999995</c:v>
                </c:pt>
                <c:pt idx="128">
                  <c:v>617.96997069999998</c:v>
                </c:pt>
                <c:pt idx="129">
                  <c:v>618.97998050000001</c:v>
                </c:pt>
                <c:pt idx="130">
                  <c:v>620</c:v>
                </c:pt>
                <c:pt idx="131">
                  <c:v>621.01000980000003</c:v>
                </c:pt>
                <c:pt idx="132">
                  <c:v>622.02001949999999</c:v>
                </c:pt>
                <c:pt idx="133">
                  <c:v>623.03997800000002</c:v>
                </c:pt>
                <c:pt idx="134">
                  <c:v>624.04998780000005</c:v>
                </c:pt>
                <c:pt idx="135">
                  <c:v>625.07000730000004</c:v>
                </c:pt>
                <c:pt idx="136">
                  <c:v>625.94000240000003</c:v>
                </c:pt>
                <c:pt idx="137">
                  <c:v>626.95001219999995</c:v>
                </c:pt>
                <c:pt idx="138">
                  <c:v>627.96997069999998</c:v>
                </c:pt>
                <c:pt idx="139">
                  <c:v>628.97998050000001</c:v>
                </c:pt>
                <c:pt idx="140">
                  <c:v>630</c:v>
                </c:pt>
                <c:pt idx="141">
                  <c:v>631.01000980000003</c:v>
                </c:pt>
                <c:pt idx="142">
                  <c:v>632.02001949999999</c:v>
                </c:pt>
                <c:pt idx="143">
                  <c:v>633.03997800000002</c:v>
                </c:pt>
                <c:pt idx="144">
                  <c:v>634.04998780000005</c:v>
                </c:pt>
                <c:pt idx="145">
                  <c:v>635.07000730000004</c:v>
                </c:pt>
                <c:pt idx="146">
                  <c:v>635.94000240000003</c:v>
                </c:pt>
                <c:pt idx="147">
                  <c:v>636.95001219999995</c:v>
                </c:pt>
                <c:pt idx="148">
                  <c:v>637.96997069999998</c:v>
                </c:pt>
                <c:pt idx="149">
                  <c:v>638.97998050000001</c:v>
                </c:pt>
                <c:pt idx="150">
                  <c:v>640</c:v>
                </c:pt>
                <c:pt idx="151">
                  <c:v>641.01000980000003</c:v>
                </c:pt>
                <c:pt idx="152">
                  <c:v>642.02001949999999</c:v>
                </c:pt>
                <c:pt idx="153">
                  <c:v>643.03997800000002</c:v>
                </c:pt>
                <c:pt idx="154">
                  <c:v>644.04998780000005</c:v>
                </c:pt>
                <c:pt idx="155">
                  <c:v>645.07000730000004</c:v>
                </c:pt>
                <c:pt idx="156">
                  <c:v>645.94000240000003</c:v>
                </c:pt>
                <c:pt idx="157">
                  <c:v>646.95001219999995</c:v>
                </c:pt>
                <c:pt idx="158">
                  <c:v>647.96997069999998</c:v>
                </c:pt>
                <c:pt idx="159">
                  <c:v>648.97998050000001</c:v>
                </c:pt>
                <c:pt idx="160">
                  <c:v>650</c:v>
                </c:pt>
                <c:pt idx="161">
                  <c:v>651.01000980000003</c:v>
                </c:pt>
                <c:pt idx="162">
                  <c:v>652.02001949999999</c:v>
                </c:pt>
                <c:pt idx="163">
                  <c:v>653.03997800000002</c:v>
                </c:pt>
                <c:pt idx="164">
                  <c:v>654.04998780000005</c:v>
                </c:pt>
                <c:pt idx="165">
                  <c:v>655.07000730000004</c:v>
                </c:pt>
                <c:pt idx="166">
                  <c:v>655.94000240000003</c:v>
                </c:pt>
                <c:pt idx="167">
                  <c:v>656.95001219999995</c:v>
                </c:pt>
                <c:pt idx="168">
                  <c:v>657.96997069999998</c:v>
                </c:pt>
                <c:pt idx="169">
                  <c:v>658.97998050000001</c:v>
                </c:pt>
                <c:pt idx="170">
                  <c:v>660</c:v>
                </c:pt>
                <c:pt idx="171">
                  <c:v>661</c:v>
                </c:pt>
                <c:pt idx="172">
                  <c:v>662</c:v>
                </c:pt>
                <c:pt idx="173">
                  <c:v>663</c:v>
                </c:pt>
                <c:pt idx="174">
                  <c:v>664</c:v>
                </c:pt>
                <c:pt idx="175">
                  <c:v>665</c:v>
                </c:pt>
                <c:pt idx="176">
                  <c:v>666</c:v>
                </c:pt>
                <c:pt idx="177">
                  <c:v>667</c:v>
                </c:pt>
                <c:pt idx="178">
                  <c:v>668</c:v>
                </c:pt>
                <c:pt idx="179">
                  <c:v>669</c:v>
                </c:pt>
                <c:pt idx="180">
                  <c:v>670</c:v>
                </c:pt>
                <c:pt idx="181">
                  <c:v>671</c:v>
                </c:pt>
                <c:pt idx="182">
                  <c:v>672</c:v>
                </c:pt>
                <c:pt idx="183">
                  <c:v>673</c:v>
                </c:pt>
                <c:pt idx="184">
                  <c:v>674</c:v>
                </c:pt>
                <c:pt idx="185">
                  <c:v>675</c:v>
                </c:pt>
                <c:pt idx="186">
                  <c:v>676</c:v>
                </c:pt>
                <c:pt idx="187">
                  <c:v>677</c:v>
                </c:pt>
                <c:pt idx="188">
                  <c:v>678</c:v>
                </c:pt>
                <c:pt idx="189">
                  <c:v>679</c:v>
                </c:pt>
                <c:pt idx="190">
                  <c:v>680</c:v>
                </c:pt>
                <c:pt idx="191">
                  <c:v>681</c:v>
                </c:pt>
                <c:pt idx="192">
                  <c:v>682</c:v>
                </c:pt>
                <c:pt idx="193">
                  <c:v>683</c:v>
                </c:pt>
                <c:pt idx="194">
                  <c:v>684</c:v>
                </c:pt>
                <c:pt idx="195">
                  <c:v>685</c:v>
                </c:pt>
                <c:pt idx="196">
                  <c:v>686</c:v>
                </c:pt>
                <c:pt idx="197">
                  <c:v>687</c:v>
                </c:pt>
                <c:pt idx="198">
                  <c:v>688</c:v>
                </c:pt>
                <c:pt idx="199">
                  <c:v>689</c:v>
                </c:pt>
                <c:pt idx="200">
                  <c:v>690</c:v>
                </c:pt>
                <c:pt idx="201">
                  <c:v>691</c:v>
                </c:pt>
                <c:pt idx="202">
                  <c:v>692</c:v>
                </c:pt>
                <c:pt idx="203">
                  <c:v>693</c:v>
                </c:pt>
                <c:pt idx="204">
                  <c:v>694</c:v>
                </c:pt>
                <c:pt idx="205">
                  <c:v>695</c:v>
                </c:pt>
                <c:pt idx="206">
                  <c:v>696</c:v>
                </c:pt>
                <c:pt idx="207">
                  <c:v>697</c:v>
                </c:pt>
                <c:pt idx="208">
                  <c:v>698</c:v>
                </c:pt>
                <c:pt idx="209">
                  <c:v>699</c:v>
                </c:pt>
                <c:pt idx="210">
                  <c:v>700</c:v>
                </c:pt>
              </c:numCache>
            </c:numRef>
          </c:xVal>
          <c:yVal>
            <c:numRef>
              <c:f>'[Chart 2 in Microsoft PowerPoint]Sheet1'!$C$5:$C$215</c:f>
              <c:numCache>
                <c:formatCode>General</c:formatCode>
                <c:ptCount val="211"/>
                <c:pt idx="0">
                  <c:v>40.124408719999998</c:v>
                </c:pt>
                <c:pt idx="1">
                  <c:v>28.501279830000001</c:v>
                </c:pt>
                <c:pt idx="2">
                  <c:v>28.405065539999999</c:v>
                </c:pt>
                <c:pt idx="3">
                  <c:v>30.322004320000001</c:v>
                </c:pt>
                <c:pt idx="4">
                  <c:v>33.668891909999999</c:v>
                </c:pt>
                <c:pt idx="5">
                  <c:v>36.722702030000001</c:v>
                </c:pt>
                <c:pt idx="6">
                  <c:v>39.909217830000003</c:v>
                </c:pt>
                <c:pt idx="7">
                  <c:v>42.991294859999996</c:v>
                </c:pt>
                <c:pt idx="8">
                  <c:v>46.272808070000004</c:v>
                </c:pt>
                <c:pt idx="9">
                  <c:v>49.719093319999999</c:v>
                </c:pt>
                <c:pt idx="10">
                  <c:v>53.166458130000002</c:v>
                </c:pt>
                <c:pt idx="11">
                  <c:v>56.317958830000002</c:v>
                </c:pt>
                <c:pt idx="12">
                  <c:v>59.31756592</c:v>
                </c:pt>
                <c:pt idx="13">
                  <c:v>61.865688319999997</c:v>
                </c:pt>
                <c:pt idx="14">
                  <c:v>64.773735049999999</c:v>
                </c:pt>
                <c:pt idx="15">
                  <c:v>66.180068969999994</c:v>
                </c:pt>
                <c:pt idx="16">
                  <c:v>68.937286380000003</c:v>
                </c:pt>
                <c:pt idx="17">
                  <c:v>70.495384220000005</c:v>
                </c:pt>
                <c:pt idx="18">
                  <c:v>72.312263490000007</c:v>
                </c:pt>
                <c:pt idx="19">
                  <c:v>73.171615599999996</c:v>
                </c:pt>
                <c:pt idx="20">
                  <c:v>74.153823849999995</c:v>
                </c:pt>
                <c:pt idx="21">
                  <c:v>75.100952149999998</c:v>
                </c:pt>
                <c:pt idx="22">
                  <c:v>75.761001590000006</c:v>
                </c:pt>
                <c:pt idx="23">
                  <c:v>76.17983246</c:v>
                </c:pt>
                <c:pt idx="24">
                  <c:v>76.502891539999993</c:v>
                </c:pt>
                <c:pt idx="25">
                  <c:v>76.651298519999997</c:v>
                </c:pt>
                <c:pt idx="26">
                  <c:v>75.599060059999999</c:v>
                </c:pt>
                <c:pt idx="27">
                  <c:v>75.212341309999999</c:v>
                </c:pt>
                <c:pt idx="28">
                  <c:v>74.477935790000004</c:v>
                </c:pt>
                <c:pt idx="29">
                  <c:v>73.995445250000003</c:v>
                </c:pt>
                <c:pt idx="30">
                  <c:v>73.263389590000003</c:v>
                </c:pt>
                <c:pt idx="31">
                  <c:v>72.212921140000006</c:v>
                </c:pt>
                <c:pt idx="32">
                  <c:v>71.920158389999997</c:v>
                </c:pt>
                <c:pt idx="33">
                  <c:v>70.492164610000003</c:v>
                </c:pt>
                <c:pt idx="34">
                  <c:v>69.612419130000006</c:v>
                </c:pt>
                <c:pt idx="35">
                  <c:v>68.773315429999997</c:v>
                </c:pt>
                <c:pt idx="36">
                  <c:v>67.935462950000002</c:v>
                </c:pt>
                <c:pt idx="37">
                  <c:v>66.130859380000004</c:v>
                </c:pt>
                <c:pt idx="38">
                  <c:v>66.165771480000004</c:v>
                </c:pt>
                <c:pt idx="39">
                  <c:v>65.199913019999997</c:v>
                </c:pt>
                <c:pt idx="40">
                  <c:v>64.855110170000003</c:v>
                </c:pt>
                <c:pt idx="41">
                  <c:v>63.995532990000001</c:v>
                </c:pt>
                <c:pt idx="42">
                  <c:v>63.31454849</c:v>
                </c:pt>
                <c:pt idx="43">
                  <c:v>61.981994630000003</c:v>
                </c:pt>
                <c:pt idx="44">
                  <c:v>62.014884950000003</c:v>
                </c:pt>
                <c:pt idx="45">
                  <c:v>61.813117980000001</c:v>
                </c:pt>
                <c:pt idx="46">
                  <c:v>60.740142820000003</c:v>
                </c:pt>
                <c:pt idx="47">
                  <c:v>60.105823520000001</c:v>
                </c:pt>
                <c:pt idx="48">
                  <c:v>59.840957639999999</c:v>
                </c:pt>
                <c:pt idx="49">
                  <c:v>59.685646060000003</c:v>
                </c:pt>
                <c:pt idx="50">
                  <c:v>59.278072360000003</c:v>
                </c:pt>
                <c:pt idx="51">
                  <c:v>58.40880585</c:v>
                </c:pt>
                <c:pt idx="52">
                  <c:v>59.027576449999998</c:v>
                </c:pt>
                <c:pt idx="53">
                  <c:v>57.345970149999999</c:v>
                </c:pt>
                <c:pt idx="54">
                  <c:v>57.124866490000002</c:v>
                </c:pt>
                <c:pt idx="55">
                  <c:v>56.81028748</c:v>
                </c:pt>
                <c:pt idx="56">
                  <c:v>56.593235020000002</c:v>
                </c:pt>
                <c:pt idx="57">
                  <c:v>55.57624817</c:v>
                </c:pt>
                <c:pt idx="58">
                  <c:v>55.279289249999998</c:v>
                </c:pt>
                <c:pt idx="59">
                  <c:v>54.400783539999999</c:v>
                </c:pt>
                <c:pt idx="60">
                  <c:v>53.845020290000001</c:v>
                </c:pt>
                <c:pt idx="61">
                  <c:v>52.779487609999997</c:v>
                </c:pt>
                <c:pt idx="62">
                  <c:v>51.822128300000003</c:v>
                </c:pt>
                <c:pt idx="63">
                  <c:v>52.13021088</c:v>
                </c:pt>
                <c:pt idx="64">
                  <c:v>50.651294710000002</c:v>
                </c:pt>
                <c:pt idx="65">
                  <c:v>50.087055210000003</c:v>
                </c:pt>
                <c:pt idx="66">
                  <c:v>49.084697720000001</c:v>
                </c:pt>
                <c:pt idx="67">
                  <c:v>48.33516693</c:v>
                </c:pt>
                <c:pt idx="68">
                  <c:v>47.001758580000001</c:v>
                </c:pt>
                <c:pt idx="69">
                  <c:v>46.223373410000001</c:v>
                </c:pt>
                <c:pt idx="70">
                  <c:v>45.95935059</c:v>
                </c:pt>
                <c:pt idx="71">
                  <c:v>45.028919219999999</c:v>
                </c:pt>
                <c:pt idx="72">
                  <c:v>43.23198318</c:v>
                </c:pt>
                <c:pt idx="73">
                  <c:v>42.44162369</c:v>
                </c:pt>
                <c:pt idx="74">
                  <c:v>41.444149019999998</c:v>
                </c:pt>
                <c:pt idx="75">
                  <c:v>40.587955469999997</c:v>
                </c:pt>
                <c:pt idx="76">
                  <c:v>39.704986570000003</c:v>
                </c:pt>
                <c:pt idx="77">
                  <c:v>38.561119079999997</c:v>
                </c:pt>
                <c:pt idx="78">
                  <c:v>38.014335629999998</c:v>
                </c:pt>
                <c:pt idx="79">
                  <c:v>36.773952479999998</c:v>
                </c:pt>
                <c:pt idx="80">
                  <c:v>35.937141420000003</c:v>
                </c:pt>
                <c:pt idx="81">
                  <c:v>34.948528289999999</c:v>
                </c:pt>
                <c:pt idx="82">
                  <c:v>34.352584839999999</c:v>
                </c:pt>
                <c:pt idx="83">
                  <c:v>32.997318270000001</c:v>
                </c:pt>
                <c:pt idx="84">
                  <c:v>32.424011229999998</c:v>
                </c:pt>
                <c:pt idx="85">
                  <c:v>31.159608840000001</c:v>
                </c:pt>
                <c:pt idx="86">
                  <c:v>30.24606133</c:v>
                </c:pt>
                <c:pt idx="87">
                  <c:v>29.091691969999999</c:v>
                </c:pt>
                <c:pt idx="88">
                  <c:v>28.910787580000001</c:v>
                </c:pt>
                <c:pt idx="89">
                  <c:v>28.621461870000001</c:v>
                </c:pt>
                <c:pt idx="90">
                  <c:v>27.560077669999998</c:v>
                </c:pt>
                <c:pt idx="91">
                  <c:v>27.523929599999999</c:v>
                </c:pt>
                <c:pt idx="92">
                  <c:v>25.972627639999999</c:v>
                </c:pt>
                <c:pt idx="93">
                  <c:v>25.823564529999999</c:v>
                </c:pt>
                <c:pt idx="94">
                  <c:v>25.20947838</c:v>
                </c:pt>
                <c:pt idx="95">
                  <c:v>24.326696399999999</c:v>
                </c:pt>
                <c:pt idx="96">
                  <c:v>23.829492569999999</c:v>
                </c:pt>
                <c:pt idx="97">
                  <c:v>22.930730820000001</c:v>
                </c:pt>
                <c:pt idx="98">
                  <c:v>22.84289742</c:v>
                </c:pt>
                <c:pt idx="99">
                  <c:v>22.333919529999999</c:v>
                </c:pt>
                <c:pt idx="100">
                  <c:v>21.94859314</c:v>
                </c:pt>
                <c:pt idx="101">
                  <c:v>21.254699710000001</c:v>
                </c:pt>
                <c:pt idx="102">
                  <c:v>20.61781311</c:v>
                </c:pt>
                <c:pt idx="103">
                  <c:v>20.863010410000001</c:v>
                </c:pt>
                <c:pt idx="104">
                  <c:v>19.79885483</c:v>
                </c:pt>
                <c:pt idx="105">
                  <c:v>19.323249820000001</c:v>
                </c:pt>
                <c:pt idx="106">
                  <c:v>19.205989840000001</c:v>
                </c:pt>
                <c:pt idx="107">
                  <c:v>18.482986449999999</c:v>
                </c:pt>
                <c:pt idx="108">
                  <c:v>18.369682310000002</c:v>
                </c:pt>
                <c:pt idx="109">
                  <c:v>18.027280810000001</c:v>
                </c:pt>
                <c:pt idx="110">
                  <c:v>17.393297199999999</c:v>
                </c:pt>
                <c:pt idx="111">
                  <c:v>16.97890091</c:v>
                </c:pt>
                <c:pt idx="112">
                  <c:v>16.708419800000001</c:v>
                </c:pt>
                <c:pt idx="113">
                  <c:v>16.38077736</c:v>
                </c:pt>
                <c:pt idx="114">
                  <c:v>15.976408960000001</c:v>
                </c:pt>
                <c:pt idx="115">
                  <c:v>15.583077429999999</c:v>
                </c:pt>
                <c:pt idx="116">
                  <c:v>14.914038659999999</c:v>
                </c:pt>
                <c:pt idx="117">
                  <c:v>14.494536399999999</c:v>
                </c:pt>
                <c:pt idx="118">
                  <c:v>14.322803499999999</c:v>
                </c:pt>
                <c:pt idx="119">
                  <c:v>13.766203880000001</c:v>
                </c:pt>
                <c:pt idx="120">
                  <c:v>13.67905045</c:v>
                </c:pt>
                <c:pt idx="121">
                  <c:v>13.136856079999999</c:v>
                </c:pt>
                <c:pt idx="122">
                  <c:v>12.88245869</c:v>
                </c:pt>
                <c:pt idx="123">
                  <c:v>12.180662160000001</c:v>
                </c:pt>
                <c:pt idx="124">
                  <c:v>12.21943188</c:v>
                </c:pt>
                <c:pt idx="125">
                  <c:v>11.72579956</c:v>
                </c:pt>
                <c:pt idx="126">
                  <c:v>11.397854799999999</c:v>
                </c:pt>
                <c:pt idx="127">
                  <c:v>11.15708733</c:v>
                </c:pt>
                <c:pt idx="128">
                  <c:v>10.73154736</c:v>
                </c:pt>
                <c:pt idx="129">
                  <c:v>10.389797209999999</c:v>
                </c:pt>
                <c:pt idx="130">
                  <c:v>10.1907692</c:v>
                </c:pt>
                <c:pt idx="131">
                  <c:v>9.9055557249999993</c:v>
                </c:pt>
                <c:pt idx="132">
                  <c:v>9.6216077799999997</c:v>
                </c:pt>
                <c:pt idx="133">
                  <c:v>9.2413825989999996</c:v>
                </c:pt>
                <c:pt idx="134">
                  <c:v>8.7566051480000002</c:v>
                </c:pt>
                <c:pt idx="135">
                  <c:v>8.8930892939999993</c:v>
                </c:pt>
                <c:pt idx="136">
                  <c:v>8.3204126360000004</c:v>
                </c:pt>
                <c:pt idx="137">
                  <c:v>8.1817464829999995</c:v>
                </c:pt>
                <c:pt idx="138">
                  <c:v>8.0403900149999998</c:v>
                </c:pt>
                <c:pt idx="139">
                  <c:v>7.7118039129999998</c:v>
                </c:pt>
                <c:pt idx="140">
                  <c:v>7.2852816579999997</c:v>
                </c:pt>
                <c:pt idx="141">
                  <c:v>7.142701626</c:v>
                </c:pt>
                <c:pt idx="142">
                  <c:v>6.891643524</c:v>
                </c:pt>
                <c:pt idx="143">
                  <c:v>6.5854153630000001</c:v>
                </c:pt>
                <c:pt idx="144">
                  <c:v>6.624002934</c:v>
                </c:pt>
                <c:pt idx="145">
                  <c:v>6.3253536219999997</c:v>
                </c:pt>
                <c:pt idx="146">
                  <c:v>6.1340765949999998</c:v>
                </c:pt>
                <c:pt idx="147">
                  <c:v>5.9482588769999998</c:v>
                </c:pt>
                <c:pt idx="148">
                  <c:v>5.8614511489999996</c:v>
                </c:pt>
                <c:pt idx="149">
                  <c:v>5.6493892670000001</c:v>
                </c:pt>
                <c:pt idx="150">
                  <c:v>5.2862091060000003</c:v>
                </c:pt>
                <c:pt idx="151">
                  <c:v>5.3951926229999998</c:v>
                </c:pt>
                <c:pt idx="152">
                  <c:v>5.0912327770000001</c:v>
                </c:pt>
                <c:pt idx="153">
                  <c:v>4.9924030300000002</c:v>
                </c:pt>
                <c:pt idx="154">
                  <c:v>4.796284676</c:v>
                </c:pt>
                <c:pt idx="155">
                  <c:v>4.6685676569999996</c:v>
                </c:pt>
                <c:pt idx="156">
                  <c:v>4.505781174</c:v>
                </c:pt>
                <c:pt idx="157">
                  <c:v>4.2702202800000002</c:v>
                </c:pt>
                <c:pt idx="158">
                  <c:v>4.2434253689999997</c:v>
                </c:pt>
                <c:pt idx="159">
                  <c:v>4.0249447820000004</c:v>
                </c:pt>
                <c:pt idx="160">
                  <c:v>4.0489068030000004</c:v>
                </c:pt>
                <c:pt idx="161">
                  <c:v>4.0743679999999998</c:v>
                </c:pt>
                <c:pt idx="162">
                  <c:v>3.6290643220000001</c:v>
                </c:pt>
                <c:pt idx="163">
                  <c:v>3.488914013</c:v>
                </c:pt>
                <c:pt idx="164">
                  <c:v>3.6009120939999999</c:v>
                </c:pt>
                <c:pt idx="165">
                  <c:v>3.3527388569999999</c:v>
                </c:pt>
                <c:pt idx="166">
                  <c:v>3.4207277299999999</c:v>
                </c:pt>
                <c:pt idx="167">
                  <c:v>3.2309467789999999</c:v>
                </c:pt>
                <c:pt idx="168">
                  <c:v>3.172051191</c:v>
                </c:pt>
                <c:pt idx="169">
                  <c:v>3.015338898</c:v>
                </c:pt>
                <c:pt idx="170">
                  <c:v>3.093274117</c:v>
                </c:pt>
                <c:pt idx="171">
                  <c:v>2.8251044749999998</c:v>
                </c:pt>
                <c:pt idx="172">
                  <c:v>2.652634859</c:v>
                </c:pt>
                <c:pt idx="173">
                  <c:v>2.6909260750000001</c:v>
                </c:pt>
                <c:pt idx="174">
                  <c:v>2.516227722</c:v>
                </c:pt>
                <c:pt idx="175">
                  <c:v>2.5356369019999998</c:v>
                </c:pt>
                <c:pt idx="176">
                  <c:v>2.3741414550000002</c:v>
                </c:pt>
                <c:pt idx="177">
                  <c:v>2.4146358970000001</c:v>
                </c:pt>
                <c:pt idx="178">
                  <c:v>2.3623597620000001</c:v>
                </c:pt>
                <c:pt idx="179">
                  <c:v>2.3035318849999999</c:v>
                </c:pt>
                <c:pt idx="180">
                  <c:v>2.195627451</c:v>
                </c:pt>
                <c:pt idx="181">
                  <c:v>2.0676457880000001</c:v>
                </c:pt>
                <c:pt idx="182">
                  <c:v>1.985622287</c:v>
                </c:pt>
                <c:pt idx="183">
                  <c:v>1.9593417639999999</c:v>
                </c:pt>
                <c:pt idx="184">
                  <c:v>1.8863354919999999</c:v>
                </c:pt>
                <c:pt idx="185">
                  <c:v>1.7757077219999999</c:v>
                </c:pt>
                <c:pt idx="186">
                  <c:v>1.834464788</c:v>
                </c:pt>
                <c:pt idx="187">
                  <c:v>1.744693279</c:v>
                </c:pt>
                <c:pt idx="188">
                  <c:v>1.7008904220000001</c:v>
                </c:pt>
                <c:pt idx="189">
                  <c:v>1.6523317099999999</c:v>
                </c:pt>
                <c:pt idx="190">
                  <c:v>1.619909644</c:v>
                </c:pt>
                <c:pt idx="191">
                  <c:v>1.418347359</c:v>
                </c:pt>
                <c:pt idx="192">
                  <c:v>1.4048317669999999</c:v>
                </c:pt>
                <c:pt idx="193">
                  <c:v>1.417865038</c:v>
                </c:pt>
                <c:pt idx="194">
                  <c:v>1.417198658</c:v>
                </c:pt>
                <c:pt idx="195">
                  <c:v>1.417188406</c:v>
                </c:pt>
                <c:pt idx="196">
                  <c:v>1.1971938609999999</c:v>
                </c:pt>
                <c:pt idx="197">
                  <c:v>1.233833194</c:v>
                </c:pt>
                <c:pt idx="198">
                  <c:v>1.1513897179999999</c:v>
                </c:pt>
                <c:pt idx="199">
                  <c:v>1.0896626709999999</c:v>
                </c:pt>
                <c:pt idx="200">
                  <c:v>1.1409966949999999</c:v>
                </c:pt>
                <c:pt idx="201">
                  <c:v>1.0059261319999999</c:v>
                </c:pt>
                <c:pt idx="202">
                  <c:v>1.1015609500000001</c:v>
                </c:pt>
                <c:pt idx="203">
                  <c:v>1.076325178</c:v>
                </c:pt>
                <c:pt idx="204">
                  <c:v>0.92996895310000005</c:v>
                </c:pt>
                <c:pt idx="205">
                  <c:v>0.93541264530000001</c:v>
                </c:pt>
                <c:pt idx="206">
                  <c:v>0.88840991260000002</c:v>
                </c:pt>
                <c:pt idx="207">
                  <c:v>0.93340277670000005</c:v>
                </c:pt>
                <c:pt idx="208">
                  <c:v>0.90454167129999996</c:v>
                </c:pt>
                <c:pt idx="209">
                  <c:v>0.86775428060000004</c:v>
                </c:pt>
                <c:pt idx="210">
                  <c:v>0.7723301648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D38-AA4A-ABFA-E207AACADD67}"/>
            </c:ext>
          </c:extLst>
        </c:ser>
        <c:ser>
          <c:idx val="2"/>
          <c:order val="2"/>
          <c:spPr>
            <a:ln w="19050" cap="rnd">
              <a:solidFill>
                <a:srgbClr val="A2FC80"/>
              </a:solidFill>
              <a:round/>
            </a:ln>
            <a:effectLst/>
          </c:spPr>
          <c:marker>
            <c:symbol val="none"/>
          </c:marker>
          <c:xVal>
            <c:numRef>
              <c:f>'[Chart 2 in Microsoft PowerPoint]Sheet1'!$A$5:$A$215</c:f>
              <c:numCache>
                <c:formatCode>General</c:formatCode>
                <c:ptCount val="211"/>
                <c:pt idx="0">
                  <c:v>490</c:v>
                </c:pt>
                <c:pt idx="1">
                  <c:v>491.05999759999997</c:v>
                </c:pt>
                <c:pt idx="2">
                  <c:v>491.9599915</c:v>
                </c:pt>
                <c:pt idx="3">
                  <c:v>493.02999879999999</c:v>
                </c:pt>
                <c:pt idx="4">
                  <c:v>493.92999270000001</c:v>
                </c:pt>
                <c:pt idx="5">
                  <c:v>495</c:v>
                </c:pt>
                <c:pt idx="6">
                  <c:v>496.05999759999997</c:v>
                </c:pt>
                <c:pt idx="7">
                  <c:v>496.9599915</c:v>
                </c:pt>
                <c:pt idx="8">
                  <c:v>498.02999879999999</c:v>
                </c:pt>
                <c:pt idx="9">
                  <c:v>498.92999270000001</c:v>
                </c:pt>
                <c:pt idx="10">
                  <c:v>500</c:v>
                </c:pt>
                <c:pt idx="11">
                  <c:v>501.0400085</c:v>
                </c:pt>
                <c:pt idx="12">
                  <c:v>501.94000240000003</c:v>
                </c:pt>
                <c:pt idx="13">
                  <c:v>502.98001099999999</c:v>
                </c:pt>
                <c:pt idx="14">
                  <c:v>504.01998900000001</c:v>
                </c:pt>
                <c:pt idx="15">
                  <c:v>505.07000729999999</c:v>
                </c:pt>
                <c:pt idx="16">
                  <c:v>505.97000120000001</c:v>
                </c:pt>
                <c:pt idx="17">
                  <c:v>507.01000979999998</c:v>
                </c:pt>
                <c:pt idx="18">
                  <c:v>508.0499878</c:v>
                </c:pt>
                <c:pt idx="19">
                  <c:v>508.9500122</c:v>
                </c:pt>
                <c:pt idx="20">
                  <c:v>510</c:v>
                </c:pt>
                <c:pt idx="21">
                  <c:v>511.0400085</c:v>
                </c:pt>
                <c:pt idx="22">
                  <c:v>511.94000240000003</c:v>
                </c:pt>
                <c:pt idx="23">
                  <c:v>512.97998050000001</c:v>
                </c:pt>
                <c:pt idx="24">
                  <c:v>514.02001949999999</c:v>
                </c:pt>
                <c:pt idx="25">
                  <c:v>515.07000730000004</c:v>
                </c:pt>
                <c:pt idx="26">
                  <c:v>515.96997069999998</c:v>
                </c:pt>
                <c:pt idx="27">
                  <c:v>517.01000980000003</c:v>
                </c:pt>
                <c:pt idx="28">
                  <c:v>518.04998780000005</c:v>
                </c:pt>
                <c:pt idx="29">
                  <c:v>518.95001219999995</c:v>
                </c:pt>
                <c:pt idx="30">
                  <c:v>520</c:v>
                </c:pt>
                <c:pt idx="31">
                  <c:v>521.03997800000002</c:v>
                </c:pt>
                <c:pt idx="32">
                  <c:v>521.94000240000003</c:v>
                </c:pt>
                <c:pt idx="33">
                  <c:v>522.97998050000001</c:v>
                </c:pt>
                <c:pt idx="34">
                  <c:v>524.02001949999999</c:v>
                </c:pt>
                <c:pt idx="35">
                  <c:v>525.07000730000004</c:v>
                </c:pt>
                <c:pt idx="36">
                  <c:v>525.96997069999998</c:v>
                </c:pt>
                <c:pt idx="37">
                  <c:v>527.01000980000003</c:v>
                </c:pt>
                <c:pt idx="38">
                  <c:v>528.04998780000005</c:v>
                </c:pt>
                <c:pt idx="39">
                  <c:v>528.95001219999995</c:v>
                </c:pt>
                <c:pt idx="40">
                  <c:v>530</c:v>
                </c:pt>
                <c:pt idx="41">
                  <c:v>531.03997800000002</c:v>
                </c:pt>
                <c:pt idx="42">
                  <c:v>531.94000240000003</c:v>
                </c:pt>
                <c:pt idx="43">
                  <c:v>532.97998050000001</c:v>
                </c:pt>
                <c:pt idx="44">
                  <c:v>534.02001949999999</c:v>
                </c:pt>
                <c:pt idx="45">
                  <c:v>535.07000730000004</c:v>
                </c:pt>
                <c:pt idx="46">
                  <c:v>535.96997069999998</c:v>
                </c:pt>
                <c:pt idx="47">
                  <c:v>537.01000980000003</c:v>
                </c:pt>
                <c:pt idx="48">
                  <c:v>538.04998780000005</c:v>
                </c:pt>
                <c:pt idx="49">
                  <c:v>538.95001219999995</c:v>
                </c:pt>
                <c:pt idx="50">
                  <c:v>540</c:v>
                </c:pt>
                <c:pt idx="51">
                  <c:v>541.02001949999999</c:v>
                </c:pt>
                <c:pt idx="52">
                  <c:v>542.04998780000005</c:v>
                </c:pt>
                <c:pt idx="53">
                  <c:v>542.94000240000003</c:v>
                </c:pt>
                <c:pt idx="54">
                  <c:v>543.96997069999998</c:v>
                </c:pt>
                <c:pt idx="55">
                  <c:v>545</c:v>
                </c:pt>
                <c:pt idx="56">
                  <c:v>546.02001949999999</c:v>
                </c:pt>
                <c:pt idx="57">
                  <c:v>547.04998780000005</c:v>
                </c:pt>
                <c:pt idx="58">
                  <c:v>547.94000240000003</c:v>
                </c:pt>
                <c:pt idx="59">
                  <c:v>548.96997069999998</c:v>
                </c:pt>
                <c:pt idx="60">
                  <c:v>550</c:v>
                </c:pt>
                <c:pt idx="61">
                  <c:v>551.03997800000002</c:v>
                </c:pt>
                <c:pt idx="62">
                  <c:v>551.94000240000003</c:v>
                </c:pt>
                <c:pt idx="63">
                  <c:v>552.97998050000001</c:v>
                </c:pt>
                <c:pt idx="64">
                  <c:v>554.02001949999999</c:v>
                </c:pt>
                <c:pt idx="65">
                  <c:v>555.07000730000004</c:v>
                </c:pt>
                <c:pt idx="66">
                  <c:v>555.96997069999998</c:v>
                </c:pt>
                <c:pt idx="67">
                  <c:v>557.01000980000003</c:v>
                </c:pt>
                <c:pt idx="68">
                  <c:v>558.04998780000005</c:v>
                </c:pt>
                <c:pt idx="69">
                  <c:v>558.95001219999995</c:v>
                </c:pt>
                <c:pt idx="70">
                  <c:v>560</c:v>
                </c:pt>
                <c:pt idx="71">
                  <c:v>561.02001949999999</c:v>
                </c:pt>
                <c:pt idx="72">
                  <c:v>562.04998780000005</c:v>
                </c:pt>
                <c:pt idx="73">
                  <c:v>562.94000240000003</c:v>
                </c:pt>
                <c:pt idx="74">
                  <c:v>563.96997069999998</c:v>
                </c:pt>
                <c:pt idx="75">
                  <c:v>565</c:v>
                </c:pt>
                <c:pt idx="76">
                  <c:v>566.02001949999999</c:v>
                </c:pt>
                <c:pt idx="77">
                  <c:v>567.04998780000005</c:v>
                </c:pt>
                <c:pt idx="78">
                  <c:v>567.94000240000003</c:v>
                </c:pt>
                <c:pt idx="79">
                  <c:v>568.96997069999998</c:v>
                </c:pt>
                <c:pt idx="80">
                  <c:v>570</c:v>
                </c:pt>
                <c:pt idx="81">
                  <c:v>571.02001949999999</c:v>
                </c:pt>
                <c:pt idx="82">
                  <c:v>572.04998780000005</c:v>
                </c:pt>
                <c:pt idx="83">
                  <c:v>572.94000240000003</c:v>
                </c:pt>
                <c:pt idx="84">
                  <c:v>573.96997069999998</c:v>
                </c:pt>
                <c:pt idx="85">
                  <c:v>575</c:v>
                </c:pt>
                <c:pt idx="86">
                  <c:v>576.02001949999999</c:v>
                </c:pt>
                <c:pt idx="87">
                  <c:v>577.04998780000005</c:v>
                </c:pt>
                <c:pt idx="88">
                  <c:v>577.94000240000003</c:v>
                </c:pt>
                <c:pt idx="89">
                  <c:v>578.96997069999998</c:v>
                </c:pt>
                <c:pt idx="90">
                  <c:v>580</c:v>
                </c:pt>
                <c:pt idx="91">
                  <c:v>581.02001949999999</c:v>
                </c:pt>
                <c:pt idx="92">
                  <c:v>582.04998780000005</c:v>
                </c:pt>
                <c:pt idx="93">
                  <c:v>582.94000240000003</c:v>
                </c:pt>
                <c:pt idx="94">
                  <c:v>583.96997069999998</c:v>
                </c:pt>
                <c:pt idx="95">
                  <c:v>585</c:v>
                </c:pt>
                <c:pt idx="96">
                  <c:v>586.02001949999999</c:v>
                </c:pt>
                <c:pt idx="97">
                  <c:v>587.04998780000005</c:v>
                </c:pt>
                <c:pt idx="98">
                  <c:v>587.94000240000003</c:v>
                </c:pt>
                <c:pt idx="99">
                  <c:v>588.96997069999998</c:v>
                </c:pt>
                <c:pt idx="100">
                  <c:v>590</c:v>
                </c:pt>
                <c:pt idx="101">
                  <c:v>591.02001949999999</c:v>
                </c:pt>
                <c:pt idx="102">
                  <c:v>592.04998780000005</c:v>
                </c:pt>
                <c:pt idx="103">
                  <c:v>592.94000240000003</c:v>
                </c:pt>
                <c:pt idx="104">
                  <c:v>593.96997069999998</c:v>
                </c:pt>
                <c:pt idx="105">
                  <c:v>595</c:v>
                </c:pt>
                <c:pt idx="106">
                  <c:v>596.02001949999999</c:v>
                </c:pt>
                <c:pt idx="107">
                  <c:v>597.04998780000005</c:v>
                </c:pt>
                <c:pt idx="108">
                  <c:v>597.94000240000003</c:v>
                </c:pt>
                <c:pt idx="109">
                  <c:v>598.96997069999998</c:v>
                </c:pt>
                <c:pt idx="110">
                  <c:v>600</c:v>
                </c:pt>
                <c:pt idx="111">
                  <c:v>601.02001949999999</c:v>
                </c:pt>
                <c:pt idx="112">
                  <c:v>602.04998780000005</c:v>
                </c:pt>
                <c:pt idx="113">
                  <c:v>602.94000240000003</c:v>
                </c:pt>
                <c:pt idx="114">
                  <c:v>603.96997069999998</c:v>
                </c:pt>
                <c:pt idx="115">
                  <c:v>605</c:v>
                </c:pt>
                <c:pt idx="116">
                  <c:v>606.02001949999999</c:v>
                </c:pt>
                <c:pt idx="117">
                  <c:v>607.04998780000005</c:v>
                </c:pt>
                <c:pt idx="118">
                  <c:v>607.94000240000003</c:v>
                </c:pt>
                <c:pt idx="119">
                  <c:v>608.96997069999998</c:v>
                </c:pt>
                <c:pt idx="120">
                  <c:v>610</c:v>
                </c:pt>
                <c:pt idx="121">
                  <c:v>611.01000980000003</c:v>
                </c:pt>
                <c:pt idx="122">
                  <c:v>612.02001949999999</c:v>
                </c:pt>
                <c:pt idx="123">
                  <c:v>613.03997800000002</c:v>
                </c:pt>
                <c:pt idx="124">
                  <c:v>614.04998780000005</c:v>
                </c:pt>
                <c:pt idx="125">
                  <c:v>615.07000730000004</c:v>
                </c:pt>
                <c:pt idx="126">
                  <c:v>615.94000240000003</c:v>
                </c:pt>
                <c:pt idx="127">
                  <c:v>616.95001219999995</c:v>
                </c:pt>
                <c:pt idx="128">
                  <c:v>617.96997069999998</c:v>
                </c:pt>
                <c:pt idx="129">
                  <c:v>618.97998050000001</c:v>
                </c:pt>
                <c:pt idx="130">
                  <c:v>620</c:v>
                </c:pt>
                <c:pt idx="131">
                  <c:v>621.01000980000003</c:v>
                </c:pt>
                <c:pt idx="132">
                  <c:v>622.02001949999999</c:v>
                </c:pt>
                <c:pt idx="133">
                  <c:v>623.03997800000002</c:v>
                </c:pt>
                <c:pt idx="134">
                  <c:v>624.04998780000005</c:v>
                </c:pt>
                <c:pt idx="135">
                  <c:v>625.07000730000004</c:v>
                </c:pt>
                <c:pt idx="136">
                  <c:v>625.94000240000003</c:v>
                </c:pt>
                <c:pt idx="137">
                  <c:v>626.95001219999995</c:v>
                </c:pt>
                <c:pt idx="138">
                  <c:v>627.96997069999998</c:v>
                </c:pt>
                <c:pt idx="139">
                  <c:v>628.97998050000001</c:v>
                </c:pt>
                <c:pt idx="140">
                  <c:v>630</c:v>
                </c:pt>
                <c:pt idx="141">
                  <c:v>631.01000980000003</c:v>
                </c:pt>
                <c:pt idx="142">
                  <c:v>632.02001949999999</c:v>
                </c:pt>
                <c:pt idx="143">
                  <c:v>633.03997800000002</c:v>
                </c:pt>
                <c:pt idx="144">
                  <c:v>634.04998780000005</c:v>
                </c:pt>
                <c:pt idx="145">
                  <c:v>635.07000730000004</c:v>
                </c:pt>
                <c:pt idx="146">
                  <c:v>635.94000240000003</c:v>
                </c:pt>
                <c:pt idx="147">
                  <c:v>636.95001219999995</c:v>
                </c:pt>
                <c:pt idx="148">
                  <c:v>637.96997069999998</c:v>
                </c:pt>
                <c:pt idx="149">
                  <c:v>638.97998050000001</c:v>
                </c:pt>
                <c:pt idx="150">
                  <c:v>640</c:v>
                </c:pt>
                <c:pt idx="151">
                  <c:v>641.01000980000003</c:v>
                </c:pt>
                <c:pt idx="152">
                  <c:v>642.02001949999999</c:v>
                </c:pt>
                <c:pt idx="153">
                  <c:v>643.03997800000002</c:v>
                </c:pt>
                <c:pt idx="154">
                  <c:v>644.04998780000005</c:v>
                </c:pt>
                <c:pt idx="155">
                  <c:v>645.07000730000004</c:v>
                </c:pt>
                <c:pt idx="156">
                  <c:v>645.94000240000003</c:v>
                </c:pt>
                <c:pt idx="157">
                  <c:v>646.95001219999995</c:v>
                </c:pt>
                <c:pt idx="158">
                  <c:v>647.96997069999998</c:v>
                </c:pt>
                <c:pt idx="159">
                  <c:v>648.97998050000001</c:v>
                </c:pt>
                <c:pt idx="160">
                  <c:v>650</c:v>
                </c:pt>
                <c:pt idx="161">
                  <c:v>651.01000980000003</c:v>
                </c:pt>
                <c:pt idx="162">
                  <c:v>652.02001949999999</c:v>
                </c:pt>
                <c:pt idx="163">
                  <c:v>653.03997800000002</c:v>
                </c:pt>
                <c:pt idx="164">
                  <c:v>654.04998780000005</c:v>
                </c:pt>
                <c:pt idx="165">
                  <c:v>655.07000730000004</c:v>
                </c:pt>
                <c:pt idx="166">
                  <c:v>655.94000240000003</c:v>
                </c:pt>
                <c:pt idx="167">
                  <c:v>656.95001219999995</c:v>
                </c:pt>
                <c:pt idx="168">
                  <c:v>657.96997069999998</c:v>
                </c:pt>
                <c:pt idx="169">
                  <c:v>658.97998050000001</c:v>
                </c:pt>
                <c:pt idx="170">
                  <c:v>660</c:v>
                </c:pt>
                <c:pt idx="171">
                  <c:v>661</c:v>
                </c:pt>
                <c:pt idx="172">
                  <c:v>662</c:v>
                </c:pt>
                <c:pt idx="173">
                  <c:v>663</c:v>
                </c:pt>
                <c:pt idx="174">
                  <c:v>664</c:v>
                </c:pt>
                <c:pt idx="175">
                  <c:v>665</c:v>
                </c:pt>
                <c:pt idx="176">
                  <c:v>666</c:v>
                </c:pt>
                <c:pt idx="177">
                  <c:v>667</c:v>
                </c:pt>
                <c:pt idx="178">
                  <c:v>668</c:v>
                </c:pt>
                <c:pt idx="179">
                  <c:v>669</c:v>
                </c:pt>
                <c:pt idx="180">
                  <c:v>670</c:v>
                </c:pt>
                <c:pt idx="181">
                  <c:v>671</c:v>
                </c:pt>
                <c:pt idx="182">
                  <c:v>672</c:v>
                </c:pt>
                <c:pt idx="183">
                  <c:v>673</c:v>
                </c:pt>
                <c:pt idx="184">
                  <c:v>674</c:v>
                </c:pt>
                <c:pt idx="185">
                  <c:v>675</c:v>
                </c:pt>
                <c:pt idx="186">
                  <c:v>676</c:v>
                </c:pt>
                <c:pt idx="187">
                  <c:v>677</c:v>
                </c:pt>
                <c:pt idx="188">
                  <c:v>678</c:v>
                </c:pt>
                <c:pt idx="189">
                  <c:v>679</c:v>
                </c:pt>
                <c:pt idx="190">
                  <c:v>680</c:v>
                </c:pt>
                <c:pt idx="191">
                  <c:v>681</c:v>
                </c:pt>
                <c:pt idx="192">
                  <c:v>682</c:v>
                </c:pt>
                <c:pt idx="193">
                  <c:v>683</c:v>
                </c:pt>
                <c:pt idx="194">
                  <c:v>684</c:v>
                </c:pt>
                <c:pt idx="195">
                  <c:v>685</c:v>
                </c:pt>
                <c:pt idx="196">
                  <c:v>686</c:v>
                </c:pt>
                <c:pt idx="197">
                  <c:v>687</c:v>
                </c:pt>
                <c:pt idx="198">
                  <c:v>688</c:v>
                </c:pt>
                <c:pt idx="199">
                  <c:v>689</c:v>
                </c:pt>
                <c:pt idx="200">
                  <c:v>690</c:v>
                </c:pt>
                <c:pt idx="201">
                  <c:v>691</c:v>
                </c:pt>
                <c:pt idx="202">
                  <c:v>692</c:v>
                </c:pt>
                <c:pt idx="203">
                  <c:v>693</c:v>
                </c:pt>
                <c:pt idx="204">
                  <c:v>694</c:v>
                </c:pt>
                <c:pt idx="205">
                  <c:v>695</c:v>
                </c:pt>
                <c:pt idx="206">
                  <c:v>696</c:v>
                </c:pt>
                <c:pt idx="207">
                  <c:v>697</c:v>
                </c:pt>
                <c:pt idx="208">
                  <c:v>698</c:v>
                </c:pt>
                <c:pt idx="209">
                  <c:v>699</c:v>
                </c:pt>
                <c:pt idx="210">
                  <c:v>700</c:v>
                </c:pt>
              </c:numCache>
            </c:numRef>
          </c:xVal>
          <c:yVal>
            <c:numRef>
              <c:f>'[Chart 2 in Microsoft PowerPoint]Sheet1'!$D$5:$D$215</c:f>
              <c:numCache>
                <c:formatCode>General</c:formatCode>
                <c:ptCount val="211"/>
                <c:pt idx="0">
                  <c:v>61.14849091</c:v>
                </c:pt>
                <c:pt idx="1">
                  <c:v>50.377815249999998</c:v>
                </c:pt>
                <c:pt idx="2">
                  <c:v>50.797451019999997</c:v>
                </c:pt>
                <c:pt idx="3">
                  <c:v>55.77066422</c:v>
                </c:pt>
                <c:pt idx="4">
                  <c:v>62.263309479999997</c:v>
                </c:pt>
                <c:pt idx="5">
                  <c:v>67.356918329999999</c:v>
                </c:pt>
                <c:pt idx="6">
                  <c:v>73.966400149999998</c:v>
                </c:pt>
                <c:pt idx="7">
                  <c:v>80.038093570000001</c:v>
                </c:pt>
                <c:pt idx="8">
                  <c:v>86.488731380000004</c:v>
                </c:pt>
                <c:pt idx="9">
                  <c:v>92.270057679999994</c:v>
                </c:pt>
                <c:pt idx="10">
                  <c:v>98.644767759999993</c:v>
                </c:pt>
                <c:pt idx="11">
                  <c:v>105.0785904</c:v>
                </c:pt>
                <c:pt idx="12">
                  <c:v>108.6875</c:v>
                </c:pt>
                <c:pt idx="13">
                  <c:v>114.8764954</c:v>
                </c:pt>
                <c:pt idx="14">
                  <c:v>120.3836975</c:v>
                </c:pt>
                <c:pt idx="15">
                  <c:v>123.900032</c:v>
                </c:pt>
                <c:pt idx="16">
                  <c:v>128.63046259999999</c:v>
                </c:pt>
                <c:pt idx="17">
                  <c:v>131.13743590000001</c:v>
                </c:pt>
                <c:pt idx="18">
                  <c:v>134.4447021</c:v>
                </c:pt>
                <c:pt idx="19">
                  <c:v>137.1867676</c:v>
                </c:pt>
                <c:pt idx="20">
                  <c:v>138.29077150000001</c:v>
                </c:pt>
                <c:pt idx="21">
                  <c:v>139.40826419999999</c:v>
                </c:pt>
                <c:pt idx="22">
                  <c:v>140.77110289999999</c:v>
                </c:pt>
                <c:pt idx="23">
                  <c:v>141.2634888</c:v>
                </c:pt>
                <c:pt idx="24">
                  <c:v>141.61148069999999</c:v>
                </c:pt>
                <c:pt idx="25">
                  <c:v>141.9775238</c:v>
                </c:pt>
                <c:pt idx="26">
                  <c:v>141.18243409999999</c:v>
                </c:pt>
                <c:pt idx="27">
                  <c:v>140.0789642</c:v>
                </c:pt>
                <c:pt idx="28">
                  <c:v>138.57733150000001</c:v>
                </c:pt>
                <c:pt idx="29">
                  <c:v>138.2842407</c:v>
                </c:pt>
                <c:pt idx="30">
                  <c:v>136.26643369999999</c:v>
                </c:pt>
                <c:pt idx="31">
                  <c:v>134.07000729999999</c:v>
                </c:pt>
                <c:pt idx="32">
                  <c:v>132.2753601</c:v>
                </c:pt>
                <c:pt idx="33">
                  <c:v>130.80342099999999</c:v>
                </c:pt>
                <c:pt idx="34">
                  <c:v>129.68417360000001</c:v>
                </c:pt>
                <c:pt idx="35">
                  <c:v>126.9977112</c:v>
                </c:pt>
                <c:pt idx="36">
                  <c:v>125.6051025</c:v>
                </c:pt>
                <c:pt idx="37">
                  <c:v>123.9268417</c:v>
                </c:pt>
                <c:pt idx="38">
                  <c:v>122.4959793</c:v>
                </c:pt>
                <c:pt idx="39">
                  <c:v>120.77594759999999</c:v>
                </c:pt>
                <c:pt idx="40">
                  <c:v>119.4000168</c:v>
                </c:pt>
                <c:pt idx="41">
                  <c:v>118.4128571</c:v>
                </c:pt>
                <c:pt idx="42">
                  <c:v>117.05062100000001</c:v>
                </c:pt>
                <c:pt idx="43">
                  <c:v>115.4308624</c:v>
                </c:pt>
                <c:pt idx="44">
                  <c:v>114.5821152</c:v>
                </c:pt>
                <c:pt idx="45">
                  <c:v>113.6144867</c:v>
                </c:pt>
                <c:pt idx="46">
                  <c:v>113.2986069</c:v>
                </c:pt>
                <c:pt idx="47">
                  <c:v>112.0455551</c:v>
                </c:pt>
                <c:pt idx="48">
                  <c:v>111.2943344</c:v>
                </c:pt>
                <c:pt idx="49">
                  <c:v>110.7939758</c:v>
                </c:pt>
                <c:pt idx="50">
                  <c:v>109.81541439999999</c:v>
                </c:pt>
                <c:pt idx="51">
                  <c:v>108.46944430000001</c:v>
                </c:pt>
                <c:pt idx="52">
                  <c:v>108.4309998</c:v>
                </c:pt>
                <c:pt idx="53">
                  <c:v>107.30543520000001</c:v>
                </c:pt>
                <c:pt idx="54">
                  <c:v>105.68962860000001</c:v>
                </c:pt>
                <c:pt idx="55">
                  <c:v>104.4685669</c:v>
                </c:pt>
                <c:pt idx="56">
                  <c:v>104.1552963</c:v>
                </c:pt>
                <c:pt idx="57">
                  <c:v>102.6484528</c:v>
                </c:pt>
                <c:pt idx="58">
                  <c:v>101.4900818</c:v>
                </c:pt>
                <c:pt idx="59">
                  <c:v>101.1569824</c:v>
                </c:pt>
                <c:pt idx="60">
                  <c:v>99.378242490000005</c:v>
                </c:pt>
                <c:pt idx="61">
                  <c:v>98.95206451</c:v>
                </c:pt>
                <c:pt idx="62">
                  <c:v>97.327049259999995</c:v>
                </c:pt>
                <c:pt idx="63">
                  <c:v>95.817283630000006</c:v>
                </c:pt>
                <c:pt idx="64">
                  <c:v>93.941749569999999</c:v>
                </c:pt>
                <c:pt idx="65">
                  <c:v>92.031959529999995</c:v>
                </c:pt>
                <c:pt idx="66">
                  <c:v>90.917037960000002</c:v>
                </c:pt>
                <c:pt idx="67">
                  <c:v>89.170532230000006</c:v>
                </c:pt>
                <c:pt idx="68">
                  <c:v>87.788757320000002</c:v>
                </c:pt>
                <c:pt idx="69">
                  <c:v>86.217720029999995</c:v>
                </c:pt>
                <c:pt idx="70">
                  <c:v>83.860496519999998</c:v>
                </c:pt>
                <c:pt idx="71">
                  <c:v>82.335693359999993</c:v>
                </c:pt>
                <c:pt idx="72">
                  <c:v>80.242141720000006</c:v>
                </c:pt>
                <c:pt idx="73">
                  <c:v>78.831077579999999</c:v>
                </c:pt>
                <c:pt idx="74">
                  <c:v>76.996322629999995</c:v>
                </c:pt>
                <c:pt idx="75">
                  <c:v>74.142982480000001</c:v>
                </c:pt>
                <c:pt idx="76">
                  <c:v>72.79340363</c:v>
                </c:pt>
                <c:pt idx="77">
                  <c:v>71.316635129999995</c:v>
                </c:pt>
                <c:pt idx="78">
                  <c:v>69.642173769999999</c:v>
                </c:pt>
                <c:pt idx="79">
                  <c:v>68.317062379999996</c:v>
                </c:pt>
                <c:pt idx="80">
                  <c:v>65.593727110000003</c:v>
                </c:pt>
                <c:pt idx="81">
                  <c:v>63.790225980000002</c:v>
                </c:pt>
                <c:pt idx="82">
                  <c:v>62.485401150000001</c:v>
                </c:pt>
                <c:pt idx="83">
                  <c:v>60.640243529999999</c:v>
                </c:pt>
                <c:pt idx="84">
                  <c:v>59.565341949999997</c:v>
                </c:pt>
                <c:pt idx="85">
                  <c:v>57.820491789999998</c:v>
                </c:pt>
                <c:pt idx="86">
                  <c:v>56.234718319999999</c:v>
                </c:pt>
                <c:pt idx="87">
                  <c:v>55.271781920000002</c:v>
                </c:pt>
                <c:pt idx="88">
                  <c:v>53.166362759999998</c:v>
                </c:pt>
                <c:pt idx="89">
                  <c:v>52.093471530000002</c:v>
                </c:pt>
                <c:pt idx="90">
                  <c:v>50.607566830000003</c:v>
                </c:pt>
                <c:pt idx="91">
                  <c:v>49.81915283</c:v>
                </c:pt>
                <c:pt idx="92">
                  <c:v>48.364566799999999</c:v>
                </c:pt>
                <c:pt idx="93">
                  <c:v>47.188480380000001</c:v>
                </c:pt>
                <c:pt idx="94">
                  <c:v>46.221317290000002</c:v>
                </c:pt>
                <c:pt idx="95">
                  <c:v>45.555671689999997</c:v>
                </c:pt>
                <c:pt idx="96">
                  <c:v>43.555397030000002</c:v>
                </c:pt>
                <c:pt idx="97">
                  <c:v>43.123886110000001</c:v>
                </c:pt>
                <c:pt idx="98">
                  <c:v>41.723079679999998</c:v>
                </c:pt>
                <c:pt idx="99">
                  <c:v>41.224143980000001</c:v>
                </c:pt>
                <c:pt idx="100">
                  <c:v>40.090969090000002</c:v>
                </c:pt>
                <c:pt idx="101">
                  <c:v>38.741745000000002</c:v>
                </c:pt>
                <c:pt idx="102">
                  <c:v>38.180713650000001</c:v>
                </c:pt>
                <c:pt idx="103">
                  <c:v>37.564662929999997</c:v>
                </c:pt>
                <c:pt idx="104">
                  <c:v>36.469306950000004</c:v>
                </c:pt>
                <c:pt idx="105">
                  <c:v>36.135181430000003</c:v>
                </c:pt>
                <c:pt idx="106">
                  <c:v>34.865558620000002</c:v>
                </c:pt>
                <c:pt idx="107">
                  <c:v>34.241184230000002</c:v>
                </c:pt>
                <c:pt idx="108">
                  <c:v>33.497104640000003</c:v>
                </c:pt>
                <c:pt idx="109">
                  <c:v>32.424537659999999</c:v>
                </c:pt>
                <c:pt idx="110">
                  <c:v>32.185722349999999</c:v>
                </c:pt>
                <c:pt idx="111">
                  <c:v>31.142044070000001</c:v>
                </c:pt>
                <c:pt idx="112">
                  <c:v>30.335926059999998</c:v>
                </c:pt>
                <c:pt idx="113">
                  <c:v>29.979070660000001</c:v>
                </c:pt>
                <c:pt idx="114">
                  <c:v>28.936519619999999</c:v>
                </c:pt>
                <c:pt idx="115">
                  <c:v>28.059671399999999</c:v>
                </c:pt>
                <c:pt idx="116">
                  <c:v>27.742879869999999</c:v>
                </c:pt>
                <c:pt idx="117">
                  <c:v>26.82240105</c:v>
                </c:pt>
                <c:pt idx="118">
                  <c:v>26.121837620000001</c:v>
                </c:pt>
                <c:pt idx="119">
                  <c:v>25.475450519999999</c:v>
                </c:pt>
                <c:pt idx="120">
                  <c:v>24.476264950000001</c:v>
                </c:pt>
                <c:pt idx="121">
                  <c:v>24.045640949999999</c:v>
                </c:pt>
                <c:pt idx="122">
                  <c:v>23.31666946</c:v>
                </c:pt>
                <c:pt idx="123">
                  <c:v>22.810232160000002</c:v>
                </c:pt>
                <c:pt idx="124">
                  <c:v>22.134351729999999</c:v>
                </c:pt>
                <c:pt idx="125">
                  <c:v>21.311689380000001</c:v>
                </c:pt>
                <c:pt idx="126">
                  <c:v>21.07875443</c:v>
                </c:pt>
                <c:pt idx="127">
                  <c:v>20.266260150000001</c:v>
                </c:pt>
                <c:pt idx="128">
                  <c:v>19.884908679999999</c:v>
                </c:pt>
                <c:pt idx="129">
                  <c:v>18.990238189999999</c:v>
                </c:pt>
                <c:pt idx="130">
                  <c:v>18.236589429999999</c:v>
                </c:pt>
                <c:pt idx="131">
                  <c:v>17.907661439999998</c:v>
                </c:pt>
                <c:pt idx="132">
                  <c:v>17.49350548</c:v>
                </c:pt>
                <c:pt idx="133">
                  <c:v>16.632520679999999</c:v>
                </c:pt>
                <c:pt idx="134">
                  <c:v>16.00634384</c:v>
                </c:pt>
                <c:pt idx="135">
                  <c:v>15.579736710000001</c:v>
                </c:pt>
                <c:pt idx="136">
                  <c:v>15.27684307</c:v>
                </c:pt>
                <c:pt idx="137">
                  <c:v>15.001555440000001</c:v>
                </c:pt>
                <c:pt idx="138">
                  <c:v>14.87295246</c:v>
                </c:pt>
                <c:pt idx="139">
                  <c:v>13.845134740000001</c:v>
                </c:pt>
                <c:pt idx="140">
                  <c:v>13.580809589999999</c:v>
                </c:pt>
                <c:pt idx="141">
                  <c:v>13.08620739</c:v>
                </c:pt>
                <c:pt idx="142">
                  <c:v>12.788289069999999</c:v>
                </c:pt>
                <c:pt idx="143">
                  <c:v>12.113862040000001</c:v>
                </c:pt>
                <c:pt idx="144">
                  <c:v>11.857246399999999</c:v>
                </c:pt>
                <c:pt idx="145">
                  <c:v>11.42041397</c:v>
                </c:pt>
                <c:pt idx="146">
                  <c:v>11.24193764</c:v>
                </c:pt>
                <c:pt idx="147">
                  <c:v>10.968188290000001</c:v>
                </c:pt>
                <c:pt idx="148">
                  <c:v>10.518467899999999</c:v>
                </c:pt>
                <c:pt idx="149">
                  <c:v>9.9805126190000006</c:v>
                </c:pt>
                <c:pt idx="150">
                  <c:v>9.9608631130000003</c:v>
                </c:pt>
                <c:pt idx="151">
                  <c:v>9.538459778</c:v>
                </c:pt>
                <c:pt idx="152">
                  <c:v>9.0924463269999993</c:v>
                </c:pt>
                <c:pt idx="153">
                  <c:v>9.2541389469999995</c:v>
                </c:pt>
                <c:pt idx="154">
                  <c:v>8.6527862550000005</c:v>
                </c:pt>
                <c:pt idx="155">
                  <c:v>8.6366081240000003</c:v>
                </c:pt>
                <c:pt idx="156">
                  <c:v>8.2543201449999994</c:v>
                </c:pt>
                <c:pt idx="157">
                  <c:v>8.1447362900000009</c:v>
                </c:pt>
                <c:pt idx="158">
                  <c:v>7.6379899980000001</c:v>
                </c:pt>
                <c:pt idx="159">
                  <c:v>7.4602160450000001</c:v>
                </c:pt>
                <c:pt idx="160">
                  <c:v>7.6494421959999999</c:v>
                </c:pt>
                <c:pt idx="161">
                  <c:v>7.1798434259999997</c:v>
                </c:pt>
                <c:pt idx="162">
                  <c:v>6.8976659769999999</c:v>
                </c:pt>
                <c:pt idx="163">
                  <c:v>6.6698603629999997</c:v>
                </c:pt>
                <c:pt idx="164">
                  <c:v>6.3625707629999999</c:v>
                </c:pt>
                <c:pt idx="165">
                  <c:v>6.3259592060000003</c:v>
                </c:pt>
                <c:pt idx="166">
                  <c:v>5.9749460220000001</c:v>
                </c:pt>
                <c:pt idx="167">
                  <c:v>5.7426490780000004</c:v>
                </c:pt>
                <c:pt idx="168">
                  <c:v>5.7225866319999996</c:v>
                </c:pt>
                <c:pt idx="169">
                  <c:v>5.4113669399999997</c:v>
                </c:pt>
                <c:pt idx="170">
                  <c:v>5.2705245019999998</c:v>
                </c:pt>
                <c:pt idx="171">
                  <c:v>5.1241998669999997</c:v>
                </c:pt>
                <c:pt idx="172">
                  <c:v>4.9886651039999999</c:v>
                </c:pt>
                <c:pt idx="173">
                  <c:v>4.9743900300000004</c:v>
                </c:pt>
                <c:pt idx="174">
                  <c:v>4.8163976670000004</c:v>
                </c:pt>
                <c:pt idx="175">
                  <c:v>4.4963436129999996</c:v>
                </c:pt>
                <c:pt idx="176">
                  <c:v>4.4439911839999997</c:v>
                </c:pt>
                <c:pt idx="177">
                  <c:v>4.3083996769999997</c:v>
                </c:pt>
                <c:pt idx="178">
                  <c:v>4.08988905</c:v>
                </c:pt>
                <c:pt idx="179">
                  <c:v>4.0940980910000002</c:v>
                </c:pt>
                <c:pt idx="180">
                  <c:v>3.9799823760000002</c:v>
                </c:pt>
                <c:pt idx="181">
                  <c:v>3.8531575199999999</c:v>
                </c:pt>
                <c:pt idx="182">
                  <c:v>3.695318699</c:v>
                </c:pt>
                <c:pt idx="183">
                  <c:v>3.5396275519999998</c:v>
                </c:pt>
                <c:pt idx="184">
                  <c:v>3.4334137440000001</c:v>
                </c:pt>
                <c:pt idx="185">
                  <c:v>3.4898896220000002</c:v>
                </c:pt>
                <c:pt idx="186">
                  <c:v>3.45711565</c:v>
                </c:pt>
                <c:pt idx="187">
                  <c:v>3.1237165930000002</c:v>
                </c:pt>
                <c:pt idx="188">
                  <c:v>3.0534574989999999</c:v>
                </c:pt>
                <c:pt idx="189">
                  <c:v>2.9228014949999999</c:v>
                </c:pt>
                <c:pt idx="190">
                  <c:v>2.8641510010000002</c:v>
                </c:pt>
                <c:pt idx="191">
                  <c:v>2.6691040990000001</c:v>
                </c:pt>
                <c:pt idx="192">
                  <c:v>2.6012363430000001</c:v>
                </c:pt>
                <c:pt idx="193">
                  <c:v>2.5889205930000001</c:v>
                </c:pt>
                <c:pt idx="194">
                  <c:v>2.505469084</c:v>
                </c:pt>
                <c:pt idx="195">
                  <c:v>2.444382906</c:v>
                </c:pt>
                <c:pt idx="196">
                  <c:v>2.3471603390000002</c:v>
                </c:pt>
                <c:pt idx="197">
                  <c:v>2.307856321</c:v>
                </c:pt>
                <c:pt idx="198">
                  <c:v>2.1603157519999998</c:v>
                </c:pt>
                <c:pt idx="199">
                  <c:v>2.1058173180000002</c:v>
                </c:pt>
                <c:pt idx="200">
                  <c:v>2.0520582200000002</c:v>
                </c:pt>
                <c:pt idx="201">
                  <c:v>1.996213794</c:v>
                </c:pt>
                <c:pt idx="202">
                  <c:v>1.823551178</c:v>
                </c:pt>
                <c:pt idx="203">
                  <c:v>1.748018622</c:v>
                </c:pt>
                <c:pt idx="204">
                  <c:v>1.8026336430000001</c:v>
                </c:pt>
                <c:pt idx="205">
                  <c:v>1.5884104969999999</c:v>
                </c:pt>
                <c:pt idx="206">
                  <c:v>1.7009192710000001</c:v>
                </c:pt>
                <c:pt idx="207">
                  <c:v>1.6021537779999999</c:v>
                </c:pt>
                <c:pt idx="208">
                  <c:v>1.5897676940000001</c:v>
                </c:pt>
                <c:pt idx="209">
                  <c:v>1.6219826939999999</c:v>
                </c:pt>
                <c:pt idx="210">
                  <c:v>1.330647469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D38-AA4A-ABFA-E207AACADD67}"/>
            </c:ext>
          </c:extLst>
        </c:ser>
        <c:ser>
          <c:idx val="3"/>
          <c:order val="3"/>
          <c:spPr>
            <a:ln w="19050" cap="rnd">
              <a:solidFill>
                <a:srgbClr val="4BE27A"/>
              </a:solidFill>
              <a:round/>
            </a:ln>
            <a:effectLst/>
          </c:spPr>
          <c:marker>
            <c:symbol val="none"/>
          </c:marker>
          <c:xVal>
            <c:numRef>
              <c:f>'[Chart 2 in Microsoft PowerPoint]Sheet1'!$A$5:$A$215</c:f>
              <c:numCache>
                <c:formatCode>General</c:formatCode>
                <c:ptCount val="211"/>
                <c:pt idx="0">
                  <c:v>490</c:v>
                </c:pt>
                <c:pt idx="1">
                  <c:v>491.05999759999997</c:v>
                </c:pt>
                <c:pt idx="2">
                  <c:v>491.9599915</c:v>
                </c:pt>
                <c:pt idx="3">
                  <c:v>493.02999879999999</c:v>
                </c:pt>
                <c:pt idx="4">
                  <c:v>493.92999270000001</c:v>
                </c:pt>
                <c:pt idx="5">
                  <c:v>495</c:v>
                </c:pt>
                <c:pt idx="6">
                  <c:v>496.05999759999997</c:v>
                </c:pt>
                <c:pt idx="7">
                  <c:v>496.9599915</c:v>
                </c:pt>
                <c:pt idx="8">
                  <c:v>498.02999879999999</c:v>
                </c:pt>
                <c:pt idx="9">
                  <c:v>498.92999270000001</c:v>
                </c:pt>
                <c:pt idx="10">
                  <c:v>500</c:v>
                </c:pt>
                <c:pt idx="11">
                  <c:v>501.0400085</c:v>
                </c:pt>
                <c:pt idx="12">
                  <c:v>501.94000240000003</c:v>
                </c:pt>
                <c:pt idx="13">
                  <c:v>502.98001099999999</c:v>
                </c:pt>
                <c:pt idx="14">
                  <c:v>504.01998900000001</c:v>
                </c:pt>
                <c:pt idx="15">
                  <c:v>505.07000729999999</c:v>
                </c:pt>
                <c:pt idx="16">
                  <c:v>505.97000120000001</c:v>
                </c:pt>
                <c:pt idx="17">
                  <c:v>507.01000979999998</c:v>
                </c:pt>
                <c:pt idx="18">
                  <c:v>508.0499878</c:v>
                </c:pt>
                <c:pt idx="19">
                  <c:v>508.9500122</c:v>
                </c:pt>
                <c:pt idx="20">
                  <c:v>510</c:v>
                </c:pt>
                <c:pt idx="21">
                  <c:v>511.0400085</c:v>
                </c:pt>
                <c:pt idx="22">
                  <c:v>511.94000240000003</c:v>
                </c:pt>
                <c:pt idx="23">
                  <c:v>512.97998050000001</c:v>
                </c:pt>
                <c:pt idx="24">
                  <c:v>514.02001949999999</c:v>
                </c:pt>
                <c:pt idx="25">
                  <c:v>515.07000730000004</c:v>
                </c:pt>
                <c:pt idx="26">
                  <c:v>515.96997069999998</c:v>
                </c:pt>
                <c:pt idx="27">
                  <c:v>517.01000980000003</c:v>
                </c:pt>
                <c:pt idx="28">
                  <c:v>518.04998780000005</c:v>
                </c:pt>
                <c:pt idx="29">
                  <c:v>518.95001219999995</c:v>
                </c:pt>
                <c:pt idx="30">
                  <c:v>520</c:v>
                </c:pt>
                <c:pt idx="31">
                  <c:v>521.03997800000002</c:v>
                </c:pt>
                <c:pt idx="32">
                  <c:v>521.94000240000003</c:v>
                </c:pt>
                <c:pt idx="33">
                  <c:v>522.97998050000001</c:v>
                </c:pt>
                <c:pt idx="34">
                  <c:v>524.02001949999999</c:v>
                </c:pt>
                <c:pt idx="35">
                  <c:v>525.07000730000004</c:v>
                </c:pt>
                <c:pt idx="36">
                  <c:v>525.96997069999998</c:v>
                </c:pt>
                <c:pt idx="37">
                  <c:v>527.01000980000003</c:v>
                </c:pt>
                <c:pt idx="38">
                  <c:v>528.04998780000005</c:v>
                </c:pt>
                <c:pt idx="39">
                  <c:v>528.95001219999995</c:v>
                </c:pt>
                <c:pt idx="40">
                  <c:v>530</c:v>
                </c:pt>
                <c:pt idx="41">
                  <c:v>531.03997800000002</c:v>
                </c:pt>
                <c:pt idx="42">
                  <c:v>531.94000240000003</c:v>
                </c:pt>
                <c:pt idx="43">
                  <c:v>532.97998050000001</c:v>
                </c:pt>
                <c:pt idx="44">
                  <c:v>534.02001949999999</c:v>
                </c:pt>
                <c:pt idx="45">
                  <c:v>535.07000730000004</c:v>
                </c:pt>
                <c:pt idx="46">
                  <c:v>535.96997069999998</c:v>
                </c:pt>
                <c:pt idx="47">
                  <c:v>537.01000980000003</c:v>
                </c:pt>
                <c:pt idx="48">
                  <c:v>538.04998780000005</c:v>
                </c:pt>
                <c:pt idx="49">
                  <c:v>538.95001219999995</c:v>
                </c:pt>
                <c:pt idx="50">
                  <c:v>540</c:v>
                </c:pt>
                <c:pt idx="51">
                  <c:v>541.02001949999999</c:v>
                </c:pt>
                <c:pt idx="52">
                  <c:v>542.04998780000005</c:v>
                </c:pt>
                <c:pt idx="53">
                  <c:v>542.94000240000003</c:v>
                </c:pt>
                <c:pt idx="54">
                  <c:v>543.96997069999998</c:v>
                </c:pt>
                <c:pt idx="55">
                  <c:v>545</c:v>
                </c:pt>
                <c:pt idx="56">
                  <c:v>546.02001949999999</c:v>
                </c:pt>
                <c:pt idx="57">
                  <c:v>547.04998780000005</c:v>
                </c:pt>
                <c:pt idx="58">
                  <c:v>547.94000240000003</c:v>
                </c:pt>
                <c:pt idx="59">
                  <c:v>548.96997069999998</c:v>
                </c:pt>
                <c:pt idx="60">
                  <c:v>550</c:v>
                </c:pt>
                <c:pt idx="61">
                  <c:v>551.03997800000002</c:v>
                </c:pt>
                <c:pt idx="62">
                  <c:v>551.94000240000003</c:v>
                </c:pt>
                <c:pt idx="63">
                  <c:v>552.97998050000001</c:v>
                </c:pt>
                <c:pt idx="64">
                  <c:v>554.02001949999999</c:v>
                </c:pt>
                <c:pt idx="65">
                  <c:v>555.07000730000004</c:v>
                </c:pt>
                <c:pt idx="66">
                  <c:v>555.96997069999998</c:v>
                </c:pt>
                <c:pt idx="67">
                  <c:v>557.01000980000003</c:v>
                </c:pt>
                <c:pt idx="68">
                  <c:v>558.04998780000005</c:v>
                </c:pt>
                <c:pt idx="69">
                  <c:v>558.95001219999995</c:v>
                </c:pt>
                <c:pt idx="70">
                  <c:v>560</c:v>
                </c:pt>
                <c:pt idx="71">
                  <c:v>561.02001949999999</c:v>
                </c:pt>
                <c:pt idx="72">
                  <c:v>562.04998780000005</c:v>
                </c:pt>
                <c:pt idx="73">
                  <c:v>562.94000240000003</c:v>
                </c:pt>
                <c:pt idx="74">
                  <c:v>563.96997069999998</c:v>
                </c:pt>
                <c:pt idx="75">
                  <c:v>565</c:v>
                </c:pt>
                <c:pt idx="76">
                  <c:v>566.02001949999999</c:v>
                </c:pt>
                <c:pt idx="77">
                  <c:v>567.04998780000005</c:v>
                </c:pt>
                <c:pt idx="78">
                  <c:v>567.94000240000003</c:v>
                </c:pt>
                <c:pt idx="79">
                  <c:v>568.96997069999998</c:v>
                </c:pt>
                <c:pt idx="80">
                  <c:v>570</c:v>
                </c:pt>
                <c:pt idx="81">
                  <c:v>571.02001949999999</c:v>
                </c:pt>
                <c:pt idx="82">
                  <c:v>572.04998780000005</c:v>
                </c:pt>
                <c:pt idx="83">
                  <c:v>572.94000240000003</c:v>
                </c:pt>
                <c:pt idx="84">
                  <c:v>573.96997069999998</c:v>
                </c:pt>
                <c:pt idx="85">
                  <c:v>575</c:v>
                </c:pt>
                <c:pt idx="86">
                  <c:v>576.02001949999999</c:v>
                </c:pt>
                <c:pt idx="87">
                  <c:v>577.04998780000005</c:v>
                </c:pt>
                <c:pt idx="88">
                  <c:v>577.94000240000003</c:v>
                </c:pt>
                <c:pt idx="89">
                  <c:v>578.96997069999998</c:v>
                </c:pt>
                <c:pt idx="90">
                  <c:v>580</c:v>
                </c:pt>
                <c:pt idx="91">
                  <c:v>581.02001949999999</c:v>
                </c:pt>
                <c:pt idx="92">
                  <c:v>582.04998780000005</c:v>
                </c:pt>
                <c:pt idx="93">
                  <c:v>582.94000240000003</c:v>
                </c:pt>
                <c:pt idx="94">
                  <c:v>583.96997069999998</c:v>
                </c:pt>
                <c:pt idx="95">
                  <c:v>585</c:v>
                </c:pt>
                <c:pt idx="96">
                  <c:v>586.02001949999999</c:v>
                </c:pt>
                <c:pt idx="97">
                  <c:v>587.04998780000005</c:v>
                </c:pt>
                <c:pt idx="98">
                  <c:v>587.94000240000003</c:v>
                </c:pt>
                <c:pt idx="99">
                  <c:v>588.96997069999998</c:v>
                </c:pt>
                <c:pt idx="100">
                  <c:v>590</c:v>
                </c:pt>
                <c:pt idx="101">
                  <c:v>591.02001949999999</c:v>
                </c:pt>
                <c:pt idx="102">
                  <c:v>592.04998780000005</c:v>
                </c:pt>
                <c:pt idx="103">
                  <c:v>592.94000240000003</c:v>
                </c:pt>
                <c:pt idx="104">
                  <c:v>593.96997069999998</c:v>
                </c:pt>
                <c:pt idx="105">
                  <c:v>595</c:v>
                </c:pt>
                <c:pt idx="106">
                  <c:v>596.02001949999999</c:v>
                </c:pt>
                <c:pt idx="107">
                  <c:v>597.04998780000005</c:v>
                </c:pt>
                <c:pt idx="108">
                  <c:v>597.94000240000003</c:v>
                </c:pt>
                <c:pt idx="109">
                  <c:v>598.96997069999998</c:v>
                </c:pt>
                <c:pt idx="110">
                  <c:v>600</c:v>
                </c:pt>
                <c:pt idx="111">
                  <c:v>601.02001949999999</c:v>
                </c:pt>
                <c:pt idx="112">
                  <c:v>602.04998780000005</c:v>
                </c:pt>
                <c:pt idx="113">
                  <c:v>602.94000240000003</c:v>
                </c:pt>
                <c:pt idx="114">
                  <c:v>603.96997069999998</c:v>
                </c:pt>
                <c:pt idx="115">
                  <c:v>605</c:v>
                </c:pt>
                <c:pt idx="116">
                  <c:v>606.02001949999999</c:v>
                </c:pt>
                <c:pt idx="117">
                  <c:v>607.04998780000005</c:v>
                </c:pt>
                <c:pt idx="118">
                  <c:v>607.94000240000003</c:v>
                </c:pt>
                <c:pt idx="119">
                  <c:v>608.96997069999998</c:v>
                </c:pt>
                <c:pt idx="120">
                  <c:v>610</c:v>
                </c:pt>
                <c:pt idx="121">
                  <c:v>611.01000980000003</c:v>
                </c:pt>
                <c:pt idx="122">
                  <c:v>612.02001949999999</c:v>
                </c:pt>
                <c:pt idx="123">
                  <c:v>613.03997800000002</c:v>
                </c:pt>
                <c:pt idx="124">
                  <c:v>614.04998780000005</c:v>
                </c:pt>
                <c:pt idx="125">
                  <c:v>615.07000730000004</c:v>
                </c:pt>
                <c:pt idx="126">
                  <c:v>615.94000240000003</c:v>
                </c:pt>
                <c:pt idx="127">
                  <c:v>616.95001219999995</c:v>
                </c:pt>
                <c:pt idx="128">
                  <c:v>617.96997069999998</c:v>
                </c:pt>
                <c:pt idx="129">
                  <c:v>618.97998050000001</c:v>
                </c:pt>
                <c:pt idx="130">
                  <c:v>620</c:v>
                </c:pt>
                <c:pt idx="131">
                  <c:v>621.01000980000003</c:v>
                </c:pt>
                <c:pt idx="132">
                  <c:v>622.02001949999999</c:v>
                </c:pt>
                <c:pt idx="133">
                  <c:v>623.03997800000002</c:v>
                </c:pt>
                <c:pt idx="134">
                  <c:v>624.04998780000005</c:v>
                </c:pt>
                <c:pt idx="135">
                  <c:v>625.07000730000004</c:v>
                </c:pt>
                <c:pt idx="136">
                  <c:v>625.94000240000003</c:v>
                </c:pt>
                <c:pt idx="137">
                  <c:v>626.95001219999995</c:v>
                </c:pt>
                <c:pt idx="138">
                  <c:v>627.96997069999998</c:v>
                </c:pt>
                <c:pt idx="139">
                  <c:v>628.97998050000001</c:v>
                </c:pt>
                <c:pt idx="140">
                  <c:v>630</c:v>
                </c:pt>
                <c:pt idx="141">
                  <c:v>631.01000980000003</c:v>
                </c:pt>
                <c:pt idx="142">
                  <c:v>632.02001949999999</c:v>
                </c:pt>
                <c:pt idx="143">
                  <c:v>633.03997800000002</c:v>
                </c:pt>
                <c:pt idx="144">
                  <c:v>634.04998780000005</c:v>
                </c:pt>
                <c:pt idx="145">
                  <c:v>635.07000730000004</c:v>
                </c:pt>
                <c:pt idx="146">
                  <c:v>635.94000240000003</c:v>
                </c:pt>
                <c:pt idx="147">
                  <c:v>636.95001219999995</c:v>
                </c:pt>
                <c:pt idx="148">
                  <c:v>637.96997069999998</c:v>
                </c:pt>
                <c:pt idx="149">
                  <c:v>638.97998050000001</c:v>
                </c:pt>
                <c:pt idx="150">
                  <c:v>640</c:v>
                </c:pt>
                <c:pt idx="151">
                  <c:v>641.01000980000003</c:v>
                </c:pt>
                <c:pt idx="152">
                  <c:v>642.02001949999999</c:v>
                </c:pt>
                <c:pt idx="153">
                  <c:v>643.03997800000002</c:v>
                </c:pt>
                <c:pt idx="154">
                  <c:v>644.04998780000005</c:v>
                </c:pt>
                <c:pt idx="155">
                  <c:v>645.07000730000004</c:v>
                </c:pt>
                <c:pt idx="156">
                  <c:v>645.94000240000003</c:v>
                </c:pt>
                <c:pt idx="157">
                  <c:v>646.95001219999995</c:v>
                </c:pt>
                <c:pt idx="158">
                  <c:v>647.96997069999998</c:v>
                </c:pt>
                <c:pt idx="159">
                  <c:v>648.97998050000001</c:v>
                </c:pt>
                <c:pt idx="160">
                  <c:v>650</c:v>
                </c:pt>
                <c:pt idx="161">
                  <c:v>651.01000980000003</c:v>
                </c:pt>
                <c:pt idx="162">
                  <c:v>652.02001949999999</c:v>
                </c:pt>
                <c:pt idx="163">
                  <c:v>653.03997800000002</c:v>
                </c:pt>
                <c:pt idx="164">
                  <c:v>654.04998780000005</c:v>
                </c:pt>
                <c:pt idx="165">
                  <c:v>655.07000730000004</c:v>
                </c:pt>
                <c:pt idx="166">
                  <c:v>655.94000240000003</c:v>
                </c:pt>
                <c:pt idx="167">
                  <c:v>656.95001219999995</c:v>
                </c:pt>
                <c:pt idx="168">
                  <c:v>657.96997069999998</c:v>
                </c:pt>
                <c:pt idx="169">
                  <c:v>658.97998050000001</c:v>
                </c:pt>
                <c:pt idx="170">
                  <c:v>660</c:v>
                </c:pt>
                <c:pt idx="171">
                  <c:v>661</c:v>
                </c:pt>
                <c:pt idx="172">
                  <c:v>662</c:v>
                </c:pt>
                <c:pt idx="173">
                  <c:v>663</c:v>
                </c:pt>
                <c:pt idx="174">
                  <c:v>664</c:v>
                </c:pt>
                <c:pt idx="175">
                  <c:v>665</c:v>
                </c:pt>
                <c:pt idx="176">
                  <c:v>666</c:v>
                </c:pt>
                <c:pt idx="177">
                  <c:v>667</c:v>
                </c:pt>
                <c:pt idx="178">
                  <c:v>668</c:v>
                </c:pt>
                <c:pt idx="179">
                  <c:v>669</c:v>
                </c:pt>
                <c:pt idx="180">
                  <c:v>670</c:v>
                </c:pt>
                <c:pt idx="181">
                  <c:v>671</c:v>
                </c:pt>
                <c:pt idx="182">
                  <c:v>672</c:v>
                </c:pt>
                <c:pt idx="183">
                  <c:v>673</c:v>
                </c:pt>
                <c:pt idx="184">
                  <c:v>674</c:v>
                </c:pt>
                <c:pt idx="185">
                  <c:v>675</c:v>
                </c:pt>
                <c:pt idx="186">
                  <c:v>676</c:v>
                </c:pt>
                <c:pt idx="187">
                  <c:v>677</c:v>
                </c:pt>
                <c:pt idx="188">
                  <c:v>678</c:v>
                </c:pt>
                <c:pt idx="189">
                  <c:v>679</c:v>
                </c:pt>
                <c:pt idx="190">
                  <c:v>680</c:v>
                </c:pt>
                <c:pt idx="191">
                  <c:v>681</c:v>
                </c:pt>
                <c:pt idx="192">
                  <c:v>682</c:v>
                </c:pt>
                <c:pt idx="193">
                  <c:v>683</c:v>
                </c:pt>
                <c:pt idx="194">
                  <c:v>684</c:v>
                </c:pt>
                <c:pt idx="195">
                  <c:v>685</c:v>
                </c:pt>
                <c:pt idx="196">
                  <c:v>686</c:v>
                </c:pt>
                <c:pt idx="197">
                  <c:v>687</c:v>
                </c:pt>
                <c:pt idx="198">
                  <c:v>688</c:v>
                </c:pt>
                <c:pt idx="199">
                  <c:v>689</c:v>
                </c:pt>
                <c:pt idx="200">
                  <c:v>690</c:v>
                </c:pt>
                <c:pt idx="201">
                  <c:v>691</c:v>
                </c:pt>
                <c:pt idx="202">
                  <c:v>692</c:v>
                </c:pt>
                <c:pt idx="203">
                  <c:v>693</c:v>
                </c:pt>
                <c:pt idx="204">
                  <c:v>694</c:v>
                </c:pt>
                <c:pt idx="205">
                  <c:v>695</c:v>
                </c:pt>
                <c:pt idx="206">
                  <c:v>696</c:v>
                </c:pt>
                <c:pt idx="207">
                  <c:v>697</c:v>
                </c:pt>
                <c:pt idx="208">
                  <c:v>698</c:v>
                </c:pt>
                <c:pt idx="209">
                  <c:v>699</c:v>
                </c:pt>
                <c:pt idx="210">
                  <c:v>700</c:v>
                </c:pt>
              </c:numCache>
            </c:numRef>
          </c:xVal>
          <c:yVal>
            <c:numRef>
              <c:f>'[Chart 2 in Microsoft PowerPoint]Sheet1'!$E$5:$E$215</c:f>
              <c:numCache>
                <c:formatCode>General</c:formatCode>
                <c:ptCount val="211"/>
                <c:pt idx="0">
                  <c:v>87.508506769999997</c:v>
                </c:pt>
                <c:pt idx="1">
                  <c:v>80.429382320000002</c:v>
                </c:pt>
                <c:pt idx="2">
                  <c:v>85.389389039999998</c:v>
                </c:pt>
                <c:pt idx="3">
                  <c:v>94.507965089999999</c:v>
                </c:pt>
                <c:pt idx="4">
                  <c:v>105.1472931</c:v>
                </c:pt>
                <c:pt idx="5">
                  <c:v>114.95369719999999</c:v>
                </c:pt>
                <c:pt idx="6">
                  <c:v>125.30602260000001</c:v>
                </c:pt>
                <c:pt idx="7">
                  <c:v>135.3807831</c:v>
                </c:pt>
                <c:pt idx="8">
                  <c:v>147.0137939</c:v>
                </c:pt>
                <c:pt idx="9">
                  <c:v>156.9586487</c:v>
                </c:pt>
                <c:pt idx="10">
                  <c:v>166.7729645</c:v>
                </c:pt>
                <c:pt idx="11">
                  <c:v>177.0111694</c:v>
                </c:pt>
                <c:pt idx="12">
                  <c:v>185.2045593</c:v>
                </c:pt>
                <c:pt idx="13">
                  <c:v>194.25125120000001</c:v>
                </c:pt>
                <c:pt idx="14">
                  <c:v>202.22508239999999</c:v>
                </c:pt>
                <c:pt idx="15">
                  <c:v>210.98277279999999</c:v>
                </c:pt>
                <c:pt idx="16">
                  <c:v>216.6974945</c:v>
                </c:pt>
                <c:pt idx="17">
                  <c:v>222.18238830000001</c:v>
                </c:pt>
                <c:pt idx="18">
                  <c:v>228.21156310000001</c:v>
                </c:pt>
                <c:pt idx="19">
                  <c:v>231.2570801</c:v>
                </c:pt>
                <c:pt idx="20">
                  <c:v>234.928009</c:v>
                </c:pt>
                <c:pt idx="21">
                  <c:v>237.82904049999999</c:v>
                </c:pt>
                <c:pt idx="22">
                  <c:v>238.61752319999999</c:v>
                </c:pt>
                <c:pt idx="23">
                  <c:v>238.5257416</c:v>
                </c:pt>
                <c:pt idx="24">
                  <c:v>238.66494750000001</c:v>
                </c:pt>
                <c:pt idx="25">
                  <c:v>239.36770630000001</c:v>
                </c:pt>
                <c:pt idx="26">
                  <c:v>239.2409668</c:v>
                </c:pt>
                <c:pt idx="27">
                  <c:v>237.88591</c:v>
                </c:pt>
                <c:pt idx="28">
                  <c:v>236.1120148</c:v>
                </c:pt>
                <c:pt idx="29">
                  <c:v>234.02268979999999</c:v>
                </c:pt>
                <c:pt idx="30">
                  <c:v>230.7897644</c:v>
                </c:pt>
                <c:pt idx="31">
                  <c:v>228.4525299</c:v>
                </c:pt>
                <c:pt idx="32">
                  <c:v>226.76762389999999</c:v>
                </c:pt>
                <c:pt idx="33">
                  <c:v>224.26460270000001</c:v>
                </c:pt>
                <c:pt idx="34">
                  <c:v>220.8536072</c:v>
                </c:pt>
                <c:pt idx="35">
                  <c:v>217.71252440000001</c:v>
                </c:pt>
                <c:pt idx="36">
                  <c:v>214.72061160000001</c:v>
                </c:pt>
                <c:pt idx="37">
                  <c:v>211.10693359999999</c:v>
                </c:pt>
                <c:pt idx="38">
                  <c:v>208.6017761</c:v>
                </c:pt>
                <c:pt idx="39">
                  <c:v>206.03254699999999</c:v>
                </c:pt>
                <c:pt idx="40">
                  <c:v>203.31011960000001</c:v>
                </c:pt>
                <c:pt idx="41">
                  <c:v>201.60583500000001</c:v>
                </c:pt>
                <c:pt idx="42">
                  <c:v>200.17134089999999</c:v>
                </c:pt>
                <c:pt idx="43">
                  <c:v>198.8016815</c:v>
                </c:pt>
                <c:pt idx="44">
                  <c:v>196.38777160000001</c:v>
                </c:pt>
                <c:pt idx="45">
                  <c:v>194.27108759999999</c:v>
                </c:pt>
                <c:pt idx="46">
                  <c:v>192.52137759999999</c:v>
                </c:pt>
                <c:pt idx="47">
                  <c:v>191.12146000000001</c:v>
                </c:pt>
                <c:pt idx="48">
                  <c:v>190.23686219999999</c:v>
                </c:pt>
                <c:pt idx="49">
                  <c:v>189.30162050000001</c:v>
                </c:pt>
                <c:pt idx="50">
                  <c:v>188.0243835</c:v>
                </c:pt>
                <c:pt idx="51">
                  <c:v>186.1956787</c:v>
                </c:pt>
                <c:pt idx="52">
                  <c:v>185.09265139999999</c:v>
                </c:pt>
                <c:pt idx="53">
                  <c:v>183.81829830000001</c:v>
                </c:pt>
                <c:pt idx="54">
                  <c:v>182.26048280000001</c:v>
                </c:pt>
                <c:pt idx="55">
                  <c:v>179.95140079999999</c:v>
                </c:pt>
                <c:pt idx="56">
                  <c:v>179.5182495</c:v>
                </c:pt>
                <c:pt idx="57">
                  <c:v>177.35595699999999</c:v>
                </c:pt>
                <c:pt idx="58">
                  <c:v>176.39558410000001</c:v>
                </c:pt>
                <c:pt idx="59">
                  <c:v>174.4431305</c:v>
                </c:pt>
                <c:pt idx="60">
                  <c:v>171.4193573</c:v>
                </c:pt>
                <c:pt idx="61">
                  <c:v>169.4586487</c:v>
                </c:pt>
                <c:pt idx="62">
                  <c:v>166.93850710000001</c:v>
                </c:pt>
                <c:pt idx="63">
                  <c:v>164.33192439999999</c:v>
                </c:pt>
                <c:pt idx="64">
                  <c:v>162.10728449999999</c:v>
                </c:pt>
                <c:pt idx="65">
                  <c:v>158.8803101</c:v>
                </c:pt>
                <c:pt idx="66">
                  <c:v>156.54682919999999</c:v>
                </c:pt>
                <c:pt idx="67">
                  <c:v>153.34246830000001</c:v>
                </c:pt>
                <c:pt idx="68">
                  <c:v>151.59599299999999</c:v>
                </c:pt>
                <c:pt idx="69">
                  <c:v>148.27070620000001</c:v>
                </c:pt>
                <c:pt idx="70">
                  <c:v>145.1437378</c:v>
                </c:pt>
                <c:pt idx="71">
                  <c:v>140.98199460000001</c:v>
                </c:pt>
                <c:pt idx="72">
                  <c:v>139.1968536</c:v>
                </c:pt>
                <c:pt idx="73">
                  <c:v>135.76351930000001</c:v>
                </c:pt>
                <c:pt idx="74">
                  <c:v>132.20425420000001</c:v>
                </c:pt>
                <c:pt idx="75">
                  <c:v>129.54803469999999</c:v>
                </c:pt>
                <c:pt idx="76">
                  <c:v>126.021759</c:v>
                </c:pt>
                <c:pt idx="77">
                  <c:v>123.7861786</c:v>
                </c:pt>
                <c:pt idx="78">
                  <c:v>120.4060822</c:v>
                </c:pt>
                <c:pt idx="79">
                  <c:v>117.1078491</c:v>
                </c:pt>
                <c:pt idx="80">
                  <c:v>113.97135160000001</c:v>
                </c:pt>
                <c:pt idx="81">
                  <c:v>110.90638730000001</c:v>
                </c:pt>
                <c:pt idx="82">
                  <c:v>108.236557</c:v>
                </c:pt>
                <c:pt idx="83">
                  <c:v>105.5414047</c:v>
                </c:pt>
                <c:pt idx="84">
                  <c:v>103.22599030000001</c:v>
                </c:pt>
                <c:pt idx="85">
                  <c:v>99.783576969999999</c:v>
                </c:pt>
                <c:pt idx="86">
                  <c:v>97.572227479999995</c:v>
                </c:pt>
                <c:pt idx="87">
                  <c:v>94.826896669999996</c:v>
                </c:pt>
                <c:pt idx="88">
                  <c:v>93.358169559999993</c:v>
                </c:pt>
                <c:pt idx="89">
                  <c:v>90.423042300000006</c:v>
                </c:pt>
                <c:pt idx="90">
                  <c:v>88.721847530000005</c:v>
                </c:pt>
                <c:pt idx="91">
                  <c:v>85.624755859999993</c:v>
                </c:pt>
                <c:pt idx="92">
                  <c:v>83.615234380000004</c:v>
                </c:pt>
                <c:pt idx="93">
                  <c:v>81.683021550000007</c:v>
                </c:pt>
                <c:pt idx="94">
                  <c:v>79.500648499999997</c:v>
                </c:pt>
                <c:pt idx="95">
                  <c:v>78.438545230000003</c:v>
                </c:pt>
                <c:pt idx="96">
                  <c:v>76.615089420000004</c:v>
                </c:pt>
                <c:pt idx="97">
                  <c:v>74.592430109999995</c:v>
                </c:pt>
                <c:pt idx="98">
                  <c:v>73.217407230000006</c:v>
                </c:pt>
                <c:pt idx="99">
                  <c:v>70.815773010000001</c:v>
                </c:pt>
                <c:pt idx="100">
                  <c:v>70.238265990000002</c:v>
                </c:pt>
                <c:pt idx="101">
                  <c:v>67.960395809999994</c:v>
                </c:pt>
                <c:pt idx="102">
                  <c:v>66.788513179999995</c:v>
                </c:pt>
                <c:pt idx="103">
                  <c:v>64.623138429999997</c:v>
                </c:pt>
                <c:pt idx="104">
                  <c:v>63.610656740000003</c:v>
                </c:pt>
                <c:pt idx="105">
                  <c:v>62.543338779999999</c:v>
                </c:pt>
                <c:pt idx="106">
                  <c:v>60.523513790000003</c:v>
                </c:pt>
                <c:pt idx="107">
                  <c:v>59.176319120000002</c:v>
                </c:pt>
                <c:pt idx="108">
                  <c:v>58.608085629999998</c:v>
                </c:pt>
                <c:pt idx="109">
                  <c:v>56.730270390000001</c:v>
                </c:pt>
                <c:pt idx="110">
                  <c:v>55.331676479999999</c:v>
                </c:pt>
                <c:pt idx="111">
                  <c:v>54.027084350000003</c:v>
                </c:pt>
                <c:pt idx="112">
                  <c:v>52.869892120000003</c:v>
                </c:pt>
                <c:pt idx="113">
                  <c:v>51.628871920000002</c:v>
                </c:pt>
                <c:pt idx="114">
                  <c:v>50.839004520000003</c:v>
                </c:pt>
                <c:pt idx="115">
                  <c:v>49.278976440000001</c:v>
                </c:pt>
                <c:pt idx="116">
                  <c:v>47.851902010000003</c:v>
                </c:pt>
                <c:pt idx="117">
                  <c:v>46.85645676</c:v>
                </c:pt>
                <c:pt idx="118">
                  <c:v>46.182346340000002</c:v>
                </c:pt>
                <c:pt idx="119">
                  <c:v>44.532993320000003</c:v>
                </c:pt>
                <c:pt idx="120">
                  <c:v>42.912120819999998</c:v>
                </c:pt>
                <c:pt idx="121">
                  <c:v>41.781608579999997</c:v>
                </c:pt>
                <c:pt idx="122">
                  <c:v>40.469642640000004</c:v>
                </c:pt>
                <c:pt idx="123">
                  <c:v>39.673061369999999</c:v>
                </c:pt>
                <c:pt idx="124">
                  <c:v>38.783607480000001</c:v>
                </c:pt>
                <c:pt idx="125">
                  <c:v>37.535675050000002</c:v>
                </c:pt>
                <c:pt idx="126">
                  <c:v>36.566860200000001</c:v>
                </c:pt>
                <c:pt idx="127">
                  <c:v>35.541160580000003</c:v>
                </c:pt>
                <c:pt idx="128">
                  <c:v>34.395015720000004</c:v>
                </c:pt>
                <c:pt idx="129">
                  <c:v>33.797565460000001</c:v>
                </c:pt>
                <c:pt idx="130">
                  <c:v>32.069068909999999</c:v>
                </c:pt>
                <c:pt idx="131">
                  <c:v>31.835138319999999</c:v>
                </c:pt>
                <c:pt idx="132">
                  <c:v>30.432603839999999</c:v>
                </c:pt>
                <c:pt idx="133">
                  <c:v>29.75006866</c:v>
                </c:pt>
                <c:pt idx="134">
                  <c:v>28.204866410000001</c:v>
                </c:pt>
                <c:pt idx="135">
                  <c:v>27.723749160000001</c:v>
                </c:pt>
                <c:pt idx="136">
                  <c:v>26.40985298</c:v>
                </c:pt>
                <c:pt idx="137">
                  <c:v>26.24741745</c:v>
                </c:pt>
                <c:pt idx="138">
                  <c:v>24.956123349999999</c:v>
                </c:pt>
                <c:pt idx="139">
                  <c:v>24.46452141</c:v>
                </c:pt>
                <c:pt idx="140">
                  <c:v>23.44620514</c:v>
                </c:pt>
                <c:pt idx="141">
                  <c:v>22.857555390000002</c:v>
                </c:pt>
                <c:pt idx="142">
                  <c:v>21.84717178</c:v>
                </c:pt>
                <c:pt idx="143">
                  <c:v>21.452396390000001</c:v>
                </c:pt>
                <c:pt idx="144">
                  <c:v>20.500265120000002</c:v>
                </c:pt>
                <c:pt idx="145">
                  <c:v>20.185941700000001</c:v>
                </c:pt>
                <c:pt idx="146">
                  <c:v>19.610694890000001</c:v>
                </c:pt>
                <c:pt idx="147">
                  <c:v>18.829364779999999</c:v>
                </c:pt>
                <c:pt idx="148">
                  <c:v>18.194217680000001</c:v>
                </c:pt>
                <c:pt idx="149">
                  <c:v>17.851577760000001</c:v>
                </c:pt>
                <c:pt idx="150">
                  <c:v>17.18725014</c:v>
                </c:pt>
                <c:pt idx="151">
                  <c:v>16.632165910000001</c:v>
                </c:pt>
                <c:pt idx="152">
                  <c:v>16.516090389999999</c:v>
                </c:pt>
                <c:pt idx="153">
                  <c:v>15.75076389</c:v>
                </c:pt>
                <c:pt idx="154">
                  <c:v>15.05716228</c:v>
                </c:pt>
                <c:pt idx="155">
                  <c:v>14.60855198</c:v>
                </c:pt>
                <c:pt idx="156">
                  <c:v>14.44213772</c:v>
                </c:pt>
                <c:pt idx="157">
                  <c:v>14.30832195</c:v>
                </c:pt>
                <c:pt idx="158">
                  <c:v>13.342559809999999</c:v>
                </c:pt>
                <c:pt idx="159">
                  <c:v>12.88524628</c:v>
                </c:pt>
                <c:pt idx="160">
                  <c:v>12.54760265</c:v>
                </c:pt>
                <c:pt idx="161">
                  <c:v>12.28948879</c:v>
                </c:pt>
                <c:pt idx="162">
                  <c:v>11.97097969</c:v>
                </c:pt>
                <c:pt idx="163">
                  <c:v>11.30136776</c:v>
                </c:pt>
                <c:pt idx="164">
                  <c:v>11.097775459999999</c:v>
                </c:pt>
                <c:pt idx="165">
                  <c:v>10.8422184</c:v>
                </c:pt>
                <c:pt idx="166">
                  <c:v>10.64387894</c:v>
                </c:pt>
                <c:pt idx="167">
                  <c:v>10.1385603</c:v>
                </c:pt>
                <c:pt idx="168">
                  <c:v>9.7616472240000007</c:v>
                </c:pt>
                <c:pt idx="169">
                  <c:v>9.6804723740000007</c:v>
                </c:pt>
                <c:pt idx="170">
                  <c:v>9.1691246030000002</c:v>
                </c:pt>
                <c:pt idx="171">
                  <c:v>9.1906986239999995</c:v>
                </c:pt>
                <c:pt idx="172">
                  <c:v>8.8831386569999999</c:v>
                </c:pt>
                <c:pt idx="173">
                  <c:v>8.4815998080000004</c:v>
                </c:pt>
                <c:pt idx="174">
                  <c:v>8.4381799700000002</c:v>
                </c:pt>
                <c:pt idx="175">
                  <c:v>7.8832583429999996</c:v>
                </c:pt>
                <c:pt idx="176">
                  <c:v>7.7614793779999998</c:v>
                </c:pt>
                <c:pt idx="177">
                  <c:v>7.7178225520000003</c:v>
                </c:pt>
                <c:pt idx="178">
                  <c:v>7.057152748</c:v>
                </c:pt>
                <c:pt idx="179">
                  <c:v>7.1695466039999998</c:v>
                </c:pt>
                <c:pt idx="180">
                  <c:v>6.8989081380000004</c:v>
                </c:pt>
                <c:pt idx="181">
                  <c:v>6.6654682159999998</c:v>
                </c:pt>
                <c:pt idx="182">
                  <c:v>6.5025210380000003</c:v>
                </c:pt>
                <c:pt idx="183">
                  <c:v>6.30466032</c:v>
                </c:pt>
                <c:pt idx="184">
                  <c:v>5.8185935019999997</c:v>
                </c:pt>
                <c:pt idx="185">
                  <c:v>5.7436385149999998</c:v>
                </c:pt>
                <c:pt idx="186">
                  <c:v>5.5698838229999996</c:v>
                </c:pt>
                <c:pt idx="187">
                  <c:v>5.3067564960000002</c:v>
                </c:pt>
                <c:pt idx="188">
                  <c:v>5.2492680549999999</c:v>
                </c:pt>
                <c:pt idx="189">
                  <c:v>5.0683941839999997</c:v>
                </c:pt>
                <c:pt idx="190">
                  <c:v>4.9416580200000002</c:v>
                </c:pt>
                <c:pt idx="191">
                  <c:v>4.87005949</c:v>
                </c:pt>
                <c:pt idx="192">
                  <c:v>4.775728226</c:v>
                </c:pt>
                <c:pt idx="193">
                  <c:v>4.556438923</c:v>
                </c:pt>
                <c:pt idx="194">
                  <c:v>4.5120611190000002</c:v>
                </c:pt>
                <c:pt idx="195">
                  <c:v>4.1805658340000003</c:v>
                </c:pt>
                <c:pt idx="196">
                  <c:v>3.948575258</c:v>
                </c:pt>
                <c:pt idx="197">
                  <c:v>3.8243391510000002</c:v>
                </c:pt>
                <c:pt idx="198">
                  <c:v>3.73898983</c:v>
                </c:pt>
                <c:pt idx="199">
                  <c:v>3.5244073870000001</c:v>
                </c:pt>
                <c:pt idx="200">
                  <c:v>3.5267159939999999</c:v>
                </c:pt>
                <c:pt idx="201">
                  <c:v>3.4013118740000001</c:v>
                </c:pt>
                <c:pt idx="202">
                  <c:v>3.3133857249999998</c:v>
                </c:pt>
                <c:pt idx="203">
                  <c:v>3.2122774120000002</c:v>
                </c:pt>
                <c:pt idx="204">
                  <c:v>3.1727948189999999</c:v>
                </c:pt>
                <c:pt idx="205">
                  <c:v>3.0372936730000002</c:v>
                </c:pt>
                <c:pt idx="206">
                  <c:v>2.8900063039999999</c:v>
                </c:pt>
                <c:pt idx="207">
                  <c:v>2.7931747439999999</c:v>
                </c:pt>
                <c:pt idx="208">
                  <c:v>2.7569029330000001</c:v>
                </c:pt>
                <c:pt idx="209">
                  <c:v>2.675565958</c:v>
                </c:pt>
                <c:pt idx="210">
                  <c:v>2.554823874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D38-AA4A-ABFA-E207AACADD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8774799"/>
        <c:axId val="585232559"/>
      </c:scatterChart>
      <c:valAx>
        <c:axId val="678774799"/>
        <c:scaling>
          <c:orientation val="minMax"/>
          <c:max val="700"/>
          <c:min val="49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5232559"/>
        <c:crosses val="autoZero"/>
        <c:crossBetween val="midCat"/>
      </c:valAx>
      <c:valAx>
        <c:axId val="585232559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787747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2FC80"/>
            </a:solidFill>
            <a:ln w="19050">
              <a:solidFill>
                <a:schemeClr val="tx1"/>
              </a:solidFill>
            </a:ln>
            <a:effectLst/>
          </c:spPr>
          <c:invertIfNegative val="0"/>
          <c:cat>
            <c:strRef>
              <c:f>'[Chart 3 in Microsoft PowerPoint]Sel'!$L$14:$N$14</c:f>
              <c:strCache>
                <c:ptCount val="3"/>
                <c:pt idx="0">
                  <c:v>GSH</c:v>
                </c:pt>
                <c:pt idx="1">
                  <c:v>Cys</c:v>
                </c:pt>
                <c:pt idx="2">
                  <c:v>Lys</c:v>
                </c:pt>
              </c:strCache>
            </c:strRef>
          </c:cat>
          <c:val>
            <c:numRef>
              <c:f>'[Chart 3 in Microsoft PowerPoint]Sel'!$L$15:$N$15</c:f>
              <c:numCache>
                <c:formatCode>General</c:formatCode>
                <c:ptCount val="3"/>
                <c:pt idx="0">
                  <c:v>142</c:v>
                </c:pt>
                <c:pt idx="1">
                  <c:v>65</c:v>
                </c:pt>
                <c:pt idx="2">
                  <c:v>1.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CC-A94E-88CA-34E03774AA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3307135"/>
        <c:axId val="32665343"/>
      </c:barChart>
      <c:catAx>
        <c:axId val="68330713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665343"/>
        <c:crosses val="autoZero"/>
        <c:auto val="1"/>
        <c:lblAlgn val="ctr"/>
        <c:lblOffset val="100"/>
        <c:noMultiLvlLbl val="0"/>
      </c:catAx>
      <c:valAx>
        <c:axId val="3266534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3307135"/>
        <c:crosses val="autoZero"/>
        <c:crossBetween val="between"/>
      </c:valAx>
      <c:spPr>
        <a:noFill/>
        <a:ln w="1905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3A10C9-1C84-0A4B-B512-1C19839685A8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336271-343F-F748-AD68-E8A28ECEA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6326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Supplementary figure 2-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ypoxic cells are resistant to Ag5, only when pre-exposed to hypoxic condition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A- </a:t>
            </a:r>
            <a:r>
              <a:rPr lang="en-GB" sz="1200" dirty="0">
                <a:effectLst/>
                <a:latin typeface="Calibri" panose="020F0502020204030204" pitchFamily="34" charset="0"/>
                <a:cs typeface="Times New Roman" panose="02020603050405020304" pitchFamily="18" charset="0"/>
              </a:rPr>
              <a:t>H460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were exposed to different oxygen tensions, as denoted, for 6 h and then treated with Ag5 for 1 h, before carrying out an MTT assay 20 h later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 Timeline for cell viability assays with Ag5, undertaken with pre-exposure to hypoxic condition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- H460 cells were treated with Ag5 for 1 h and at the same time exposed to different oxygen tensions, as denoted and then an MTT assay was carried out 20 h later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- Timeline for cell viability assays with Ag5, undertaken with exposure to hypoxia at the same time as drug administration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ck spots on the graphs shown represent biological repeats (each of which was carried out in triplicate). Data presented a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+SEM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Statistical significance was calculated from a two-way ANOVA test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336271-343F-F748-AD68-E8A28ECEA9F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01045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Supplementary figure 3-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ypoxic cells are resistant to Ag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- RKO cells were exposed to 21 % or 2 % O</a:t>
            </a:r>
            <a:r>
              <a:rPr lang="en-GB" sz="12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baseline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 h before being treated with Ag5 for 1 h and then analysed 20 h later via an MTT assay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ck spots on the graphs shown represent biological repeats (each of which was carried out in triplicate). Data presented a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+SEM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336271-343F-F748-AD68-E8A28ECEA9F9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63102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8921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3084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827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24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321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8672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0807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062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50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064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5834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2F7B4-F601-694E-AE3A-32577EA67E34}" type="datetimeFigureOut">
              <a:rPr lang="en-GB" smtClean="0"/>
              <a:t>24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9FB7B2-E2B0-0E42-A2DB-3A393AE2D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2453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image" Target="../media/image1.emf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5.wdp"/><Relationship Id="rId3" Type="http://schemas.openxmlformats.org/officeDocument/2006/relationships/image" Target="../media/image3.png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microsoft.com/office/2007/relationships/hdphoto" Target="../media/hdphoto4.wdp"/><Relationship Id="rId5" Type="http://schemas.openxmlformats.org/officeDocument/2006/relationships/image" Target="../media/image4.tif"/><Relationship Id="rId15" Type="http://schemas.openxmlformats.org/officeDocument/2006/relationships/image" Target="../media/image10.emf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18AF9040-00DA-5F4C-5F8B-B23E2AEBB8D9}"/>
              </a:ext>
            </a:extLst>
          </p:cNvPr>
          <p:cNvSpPr txBox="1"/>
          <p:nvPr/>
        </p:nvSpPr>
        <p:spPr>
          <a:xfrm>
            <a:off x="6239791" y="0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Figure S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1E9F26E-8104-6233-E404-58878979C7E9}"/>
              </a:ext>
            </a:extLst>
          </p:cNvPr>
          <p:cNvSpPr txBox="1"/>
          <p:nvPr/>
        </p:nvSpPr>
        <p:spPr>
          <a:xfrm>
            <a:off x="0" y="12311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DE6D62-02B8-8530-B2A8-DBAE1E89774C}"/>
              </a:ext>
            </a:extLst>
          </p:cNvPr>
          <p:cNvSpPr txBox="1"/>
          <p:nvPr/>
        </p:nvSpPr>
        <p:spPr>
          <a:xfrm>
            <a:off x="3305936" y="1277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A1EAFDB-636A-C983-A5E2-40B9C1CA7445}"/>
              </a:ext>
            </a:extLst>
          </p:cNvPr>
          <p:cNvSpPr txBox="1"/>
          <p:nvPr/>
        </p:nvSpPr>
        <p:spPr>
          <a:xfrm>
            <a:off x="-4008" y="18731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87DEA39-A9CD-5FBE-AD52-9558CFBA74CF}"/>
              </a:ext>
            </a:extLst>
          </p:cNvPr>
          <p:cNvSpPr txBox="1"/>
          <p:nvPr/>
        </p:nvSpPr>
        <p:spPr>
          <a:xfrm>
            <a:off x="3301928" y="18731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F4849E-E1B0-C92E-6711-FCEFB89D374A}"/>
              </a:ext>
            </a:extLst>
          </p:cNvPr>
          <p:cNvSpPr txBox="1"/>
          <p:nvPr/>
        </p:nvSpPr>
        <p:spPr>
          <a:xfrm>
            <a:off x="73052" y="43792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4A36C65-E6FA-4A42-A674-885630FBB2E6}"/>
              </a:ext>
            </a:extLst>
          </p:cNvPr>
          <p:cNvGrpSpPr/>
          <p:nvPr/>
        </p:nvGrpSpPr>
        <p:grpSpPr>
          <a:xfrm>
            <a:off x="3846397" y="284947"/>
            <a:ext cx="2887634" cy="1726730"/>
            <a:chOff x="235856" y="133728"/>
            <a:chExt cx="3595255" cy="2149869"/>
          </a:xfrm>
        </p:grpSpPr>
        <p:graphicFrame>
          <p:nvGraphicFramePr>
            <p:cNvPr id="31" name="Chart 30">
              <a:extLst>
                <a:ext uri="{FF2B5EF4-FFF2-40B4-BE49-F238E27FC236}">
                  <a16:creationId xmlns:a16="http://schemas.microsoft.com/office/drawing/2014/main" id="{A38777AB-C665-AD3D-E6EC-CACA3B5822A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5215471"/>
                </p:ext>
              </p:extLst>
            </p:nvPr>
          </p:nvGraphicFramePr>
          <p:xfrm>
            <a:off x="465213" y="133728"/>
            <a:ext cx="3365898" cy="19380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6DD519C-D325-0A05-B02F-D69360F4D0E4}"/>
                </a:ext>
              </a:extLst>
            </p:cNvPr>
            <p:cNvSpPr txBox="1"/>
            <p:nvPr/>
          </p:nvSpPr>
          <p:spPr>
            <a:xfrm>
              <a:off x="1453506" y="2013503"/>
              <a:ext cx="1213666" cy="2700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Wavelength/ nm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63ED29D-E999-C913-D0C7-6494C1E62B3C}"/>
                </a:ext>
              </a:extLst>
            </p:cNvPr>
            <p:cNvSpPr txBox="1"/>
            <p:nvPr/>
          </p:nvSpPr>
          <p:spPr>
            <a:xfrm rot="16200000">
              <a:off x="-188453" y="829431"/>
              <a:ext cx="1118711" cy="2700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bsorbance/ A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BC821AF9-D7E2-9B4F-77A9-871C6FA85F0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35851" y="928656"/>
              <a:ext cx="0" cy="4464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8B0F4080-A399-958D-6C6B-4C42C4524E85}"/>
              </a:ext>
            </a:extLst>
          </p:cNvPr>
          <p:cNvGrpSpPr/>
          <p:nvPr/>
        </p:nvGrpSpPr>
        <p:grpSpPr>
          <a:xfrm>
            <a:off x="287258" y="2289318"/>
            <a:ext cx="3041845" cy="1813262"/>
            <a:chOff x="5565006" y="2732295"/>
            <a:chExt cx="3743467" cy="2231503"/>
          </a:xfrm>
        </p:grpSpPr>
        <p:graphicFrame>
          <p:nvGraphicFramePr>
            <p:cNvPr id="46" name="Chart 45">
              <a:extLst>
                <a:ext uri="{FF2B5EF4-FFF2-40B4-BE49-F238E27FC236}">
                  <a16:creationId xmlns:a16="http://schemas.microsoft.com/office/drawing/2014/main" id="{D360C45F-9066-743B-E815-44F81E0EAAA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9413784"/>
                </p:ext>
              </p:extLst>
            </p:nvPr>
          </p:nvGraphicFramePr>
          <p:xfrm>
            <a:off x="5764485" y="2732295"/>
            <a:ext cx="3543988" cy="2027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5B8F3D03-580F-94AD-C90C-FCF4B46241F7}"/>
                </a:ext>
              </a:extLst>
            </p:cNvPr>
            <p:cNvGrpSpPr/>
            <p:nvPr/>
          </p:nvGrpSpPr>
          <p:grpSpPr>
            <a:xfrm>
              <a:off x="5565006" y="2919561"/>
              <a:ext cx="2501398" cy="2044237"/>
              <a:chOff x="5565006" y="2919561"/>
              <a:chExt cx="2501398" cy="2044237"/>
            </a:xfrm>
          </p:grpSpPr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9DA4D66A-D531-2FD8-C8A1-52A0B008BDE2}"/>
                  </a:ext>
                </a:extLst>
              </p:cNvPr>
              <p:cNvSpPr txBox="1"/>
              <p:nvPr/>
            </p:nvSpPr>
            <p:spPr>
              <a:xfrm rot="16200000">
                <a:off x="4709323" y="3775244"/>
                <a:ext cx="19575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Fluorescence Intensity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8CCDA376-0B20-8121-25ED-53D33E2F3C46}"/>
                  </a:ext>
                </a:extLst>
              </p:cNvPr>
              <p:cNvSpPr txBox="1"/>
              <p:nvPr/>
            </p:nvSpPr>
            <p:spPr>
              <a:xfrm>
                <a:off x="6960011" y="4717577"/>
                <a:ext cx="11063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avelength/ nm</a:t>
                </a:r>
              </a:p>
            </p:txBody>
          </p:sp>
          <p:cxnSp>
            <p:nvCxnSpPr>
              <p:cNvPr id="50" name="Straight Arrow Connector 49">
                <a:extLst>
                  <a:ext uri="{FF2B5EF4-FFF2-40B4-BE49-F238E27FC236}">
                    <a16:creationId xmlns:a16="http://schemas.microsoft.com/office/drawing/2014/main" id="{19DD41B7-A71C-A86A-1CCD-010098B719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13208" y="3571617"/>
                <a:ext cx="0" cy="406944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1B70DEE1-B547-42C2-84FB-0EC3A724A58E}"/>
              </a:ext>
            </a:extLst>
          </p:cNvPr>
          <p:cNvGrpSpPr/>
          <p:nvPr/>
        </p:nvGrpSpPr>
        <p:grpSpPr>
          <a:xfrm>
            <a:off x="3817612" y="2261696"/>
            <a:ext cx="3064774" cy="1702907"/>
            <a:chOff x="517523" y="2533531"/>
            <a:chExt cx="4062972" cy="2257544"/>
          </a:xfrm>
        </p:grpSpPr>
        <p:graphicFrame>
          <p:nvGraphicFramePr>
            <p:cNvPr id="55" name="Chart 54">
              <a:extLst>
                <a:ext uri="{FF2B5EF4-FFF2-40B4-BE49-F238E27FC236}">
                  <a16:creationId xmlns:a16="http://schemas.microsoft.com/office/drawing/2014/main" id="{252C43E5-3977-BE6F-15D2-01214FC5F16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8105163"/>
                </p:ext>
              </p:extLst>
            </p:nvPr>
          </p:nvGraphicFramePr>
          <p:xfrm>
            <a:off x="745816" y="2606764"/>
            <a:ext cx="3834679" cy="21843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49F858EA-0922-0953-7F90-601DAD7C51B3}"/>
                </a:ext>
              </a:extLst>
            </p:cNvPr>
            <p:cNvSpPr txBox="1"/>
            <p:nvPr/>
          </p:nvSpPr>
          <p:spPr>
            <a:xfrm rot="16200000">
              <a:off x="-408597" y="3459651"/>
              <a:ext cx="2178656" cy="326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Fluorescence fold change</a:t>
              </a: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2E17EABD-C339-0347-2A8C-9F9046BFAB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3969" y="564952"/>
            <a:ext cx="3015488" cy="111353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8FE5D20-FB20-FA93-C7F7-0111F0C1C8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7257" y="4449673"/>
            <a:ext cx="2197100" cy="220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0379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34DBEF1-477A-0FB4-F062-FB668B07A84B}"/>
              </a:ext>
            </a:extLst>
          </p:cNvPr>
          <p:cNvSpPr txBox="1"/>
          <p:nvPr/>
        </p:nvSpPr>
        <p:spPr>
          <a:xfrm>
            <a:off x="6239791" y="0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Figure S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056A518-A3E7-06CB-DF94-735A02C60D79}"/>
              </a:ext>
            </a:extLst>
          </p:cNvPr>
          <p:cNvSpPr txBox="1"/>
          <p:nvPr/>
        </p:nvSpPr>
        <p:spPr>
          <a:xfrm>
            <a:off x="76117" y="215986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B6B2367-46EC-4099-FB91-4C637A75ACD1}"/>
              </a:ext>
            </a:extLst>
          </p:cNvPr>
          <p:cNvSpPr txBox="1"/>
          <p:nvPr/>
        </p:nvSpPr>
        <p:spPr>
          <a:xfrm>
            <a:off x="2829718" y="21598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8696E0-FD9F-C1A7-C770-4A816B752138}"/>
              </a:ext>
            </a:extLst>
          </p:cNvPr>
          <p:cNvSpPr txBox="1"/>
          <p:nvPr/>
        </p:nvSpPr>
        <p:spPr>
          <a:xfrm>
            <a:off x="76613" y="47224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A3A4ED2-41A7-756C-82FB-65C450B01E6F}"/>
              </a:ext>
            </a:extLst>
          </p:cNvPr>
          <p:cNvSpPr txBox="1"/>
          <p:nvPr/>
        </p:nvSpPr>
        <p:spPr>
          <a:xfrm>
            <a:off x="3390626" y="472723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EF661C3-5CB7-A836-C4C6-77D0EF63E21A}"/>
              </a:ext>
            </a:extLst>
          </p:cNvPr>
          <p:cNvSpPr txBox="1"/>
          <p:nvPr/>
        </p:nvSpPr>
        <p:spPr>
          <a:xfrm>
            <a:off x="76117" y="722462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C6B2F19-4338-0EE1-A2A3-D4A901E866C5}"/>
              </a:ext>
            </a:extLst>
          </p:cNvPr>
          <p:cNvSpPr txBox="1"/>
          <p:nvPr/>
        </p:nvSpPr>
        <p:spPr>
          <a:xfrm>
            <a:off x="3065343" y="7224629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7541E0C-DF32-1C71-3BF8-5C5250AEB3A4}"/>
              </a:ext>
            </a:extLst>
          </p:cNvPr>
          <p:cNvGrpSpPr/>
          <p:nvPr/>
        </p:nvGrpSpPr>
        <p:grpSpPr>
          <a:xfrm>
            <a:off x="310003" y="2467506"/>
            <a:ext cx="2226735" cy="508580"/>
            <a:chOff x="339042" y="442834"/>
            <a:chExt cx="2226735" cy="508580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85900E75-D6E4-C10A-57F4-960A95F594A2}"/>
                </a:ext>
              </a:extLst>
            </p:cNvPr>
            <p:cNvCxnSpPr>
              <a:cxnSpLocks/>
            </p:cNvCxnSpPr>
            <p:nvPr/>
          </p:nvCxnSpPr>
          <p:spPr>
            <a:xfrm>
              <a:off x="342852" y="828304"/>
              <a:ext cx="222074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C66F845-4D03-F70A-84C1-DF13EEF23392}"/>
                </a:ext>
              </a:extLst>
            </p:cNvPr>
            <p:cNvSpPr/>
            <p:nvPr/>
          </p:nvSpPr>
          <p:spPr>
            <a:xfrm>
              <a:off x="466062" y="727610"/>
              <a:ext cx="2043181" cy="201387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5DCF86F-A7A7-219C-0C86-E0A7D0C77569}"/>
                </a:ext>
              </a:extLst>
            </p:cNvPr>
            <p:cNvSpPr txBox="1"/>
            <p:nvPr/>
          </p:nvSpPr>
          <p:spPr>
            <a:xfrm>
              <a:off x="930391" y="705193"/>
              <a:ext cx="11145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ypoxia (30 h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CACB7C1-966B-FE18-79A0-FEC83EF02772}"/>
                </a:ext>
              </a:extLst>
            </p:cNvPr>
            <p:cNvSpPr txBox="1"/>
            <p:nvPr/>
          </p:nvSpPr>
          <p:spPr>
            <a:xfrm>
              <a:off x="665535" y="442834"/>
              <a:ext cx="428627" cy="246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g5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EEFE1C28-0300-BBD7-7B1D-A67584D74D1C}"/>
                </a:ext>
              </a:extLst>
            </p:cNvPr>
            <p:cNvCxnSpPr>
              <a:cxnSpLocks/>
            </p:cNvCxnSpPr>
            <p:nvPr/>
          </p:nvCxnSpPr>
          <p:spPr>
            <a:xfrm>
              <a:off x="840425" y="682136"/>
              <a:ext cx="72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6B35B155-2201-5901-7E42-EF56A83511EB}"/>
                </a:ext>
              </a:extLst>
            </p:cNvPr>
            <p:cNvCxnSpPr>
              <a:cxnSpLocks/>
            </p:cNvCxnSpPr>
            <p:nvPr/>
          </p:nvCxnSpPr>
          <p:spPr>
            <a:xfrm>
              <a:off x="339042" y="727610"/>
              <a:ext cx="0" cy="20138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8398F0FA-DB86-5B9B-A511-165F727AB24F}"/>
                </a:ext>
              </a:extLst>
            </p:cNvPr>
            <p:cNvCxnSpPr>
              <a:cxnSpLocks/>
            </p:cNvCxnSpPr>
            <p:nvPr/>
          </p:nvCxnSpPr>
          <p:spPr>
            <a:xfrm>
              <a:off x="2565777" y="727610"/>
              <a:ext cx="0" cy="20138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F382A0F-E374-3E14-32B5-CBC1CC156FF9}"/>
              </a:ext>
            </a:extLst>
          </p:cNvPr>
          <p:cNvGrpSpPr/>
          <p:nvPr/>
        </p:nvGrpSpPr>
        <p:grpSpPr>
          <a:xfrm>
            <a:off x="322752" y="7560067"/>
            <a:ext cx="2271722" cy="508580"/>
            <a:chOff x="233553" y="5326337"/>
            <a:chExt cx="2271722" cy="508580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95C4366E-10F6-4FD7-15EF-62D2027C9229}"/>
                </a:ext>
              </a:extLst>
            </p:cNvPr>
            <p:cNvCxnSpPr>
              <a:cxnSpLocks/>
            </p:cNvCxnSpPr>
            <p:nvPr/>
          </p:nvCxnSpPr>
          <p:spPr>
            <a:xfrm>
              <a:off x="282350" y="5711807"/>
              <a:ext cx="222074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88A1A77-E62B-9A38-970E-410378ADF46E}"/>
                </a:ext>
              </a:extLst>
            </p:cNvPr>
            <p:cNvSpPr/>
            <p:nvPr/>
          </p:nvSpPr>
          <p:spPr>
            <a:xfrm>
              <a:off x="405560" y="5611113"/>
              <a:ext cx="2043181" cy="201387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27481A9-BD4F-8B69-7EEA-0653983B23EE}"/>
                </a:ext>
              </a:extLst>
            </p:cNvPr>
            <p:cNvSpPr txBox="1"/>
            <p:nvPr/>
          </p:nvSpPr>
          <p:spPr>
            <a:xfrm>
              <a:off x="869889" y="5588696"/>
              <a:ext cx="11145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ypoxia (30 h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CD951A5-DF93-6642-CC9E-B2D7EFBB5133}"/>
                </a:ext>
              </a:extLst>
            </p:cNvPr>
            <p:cNvSpPr txBox="1"/>
            <p:nvPr/>
          </p:nvSpPr>
          <p:spPr>
            <a:xfrm>
              <a:off x="233553" y="5326337"/>
              <a:ext cx="428627" cy="246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g5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2A351FFD-B559-4D7B-45AC-EB286572A738}"/>
                </a:ext>
              </a:extLst>
            </p:cNvPr>
            <p:cNvCxnSpPr>
              <a:cxnSpLocks/>
            </p:cNvCxnSpPr>
            <p:nvPr/>
          </p:nvCxnSpPr>
          <p:spPr>
            <a:xfrm>
              <a:off x="408443" y="5565639"/>
              <a:ext cx="72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E69FF5F3-1DF0-E1C0-5560-F968901D1D18}"/>
                </a:ext>
              </a:extLst>
            </p:cNvPr>
            <p:cNvCxnSpPr>
              <a:cxnSpLocks/>
            </p:cNvCxnSpPr>
            <p:nvPr/>
          </p:nvCxnSpPr>
          <p:spPr>
            <a:xfrm>
              <a:off x="278540" y="5611113"/>
              <a:ext cx="0" cy="20138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AFB3697-560C-FBEF-0020-38B288353FF7}"/>
                </a:ext>
              </a:extLst>
            </p:cNvPr>
            <p:cNvCxnSpPr>
              <a:cxnSpLocks/>
            </p:cNvCxnSpPr>
            <p:nvPr/>
          </p:nvCxnSpPr>
          <p:spPr>
            <a:xfrm>
              <a:off x="2505275" y="5611113"/>
              <a:ext cx="0" cy="20138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8A43214A-2CE2-D4D9-4032-0EBF4A805CBF}"/>
              </a:ext>
            </a:extLst>
          </p:cNvPr>
          <p:cNvGrpSpPr/>
          <p:nvPr/>
        </p:nvGrpSpPr>
        <p:grpSpPr>
          <a:xfrm>
            <a:off x="216032" y="5208954"/>
            <a:ext cx="3365661" cy="1413178"/>
            <a:chOff x="385533" y="7786873"/>
            <a:chExt cx="3365661" cy="1413178"/>
          </a:xfrm>
        </p:grpSpPr>
        <p:pic>
          <p:nvPicPr>
            <p:cNvPr id="48" name="Imagen 5">
              <a:extLst>
                <a:ext uri="{FF2B5EF4-FFF2-40B4-BE49-F238E27FC236}">
                  <a16:creationId xmlns:a16="http://schemas.microsoft.com/office/drawing/2014/main" id="{E095A0D2-51BF-A8E3-0EF0-A93CA2A030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52" t="20020" r="4917" b="5943"/>
            <a:stretch/>
          </p:blipFill>
          <p:spPr>
            <a:xfrm>
              <a:off x="387877" y="8219243"/>
              <a:ext cx="2224800" cy="713333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8652B91-06BF-2B8D-02D2-AB6DC6B87491}"/>
                </a:ext>
              </a:extLst>
            </p:cNvPr>
            <p:cNvSpPr txBox="1"/>
            <p:nvPr/>
          </p:nvSpPr>
          <p:spPr>
            <a:xfrm>
              <a:off x="1920437" y="778687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D78674D-AA08-D401-3764-B98CDC4B0E16}"/>
                </a:ext>
              </a:extLst>
            </p:cNvPr>
            <p:cNvSpPr txBox="1"/>
            <p:nvPr/>
          </p:nvSpPr>
          <p:spPr>
            <a:xfrm>
              <a:off x="812610" y="778687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4DE1413-899B-ABF1-183B-FB6D3E895B7F}"/>
                </a:ext>
              </a:extLst>
            </p:cNvPr>
            <p:cNvSpPr txBox="1"/>
            <p:nvPr/>
          </p:nvSpPr>
          <p:spPr>
            <a:xfrm>
              <a:off x="722849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D995457-D44C-D29C-0FFA-35E04D58CB8F}"/>
                </a:ext>
              </a:extLst>
            </p:cNvPr>
            <p:cNvSpPr txBox="1"/>
            <p:nvPr/>
          </p:nvSpPr>
          <p:spPr>
            <a:xfrm>
              <a:off x="975475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51FEF90-DFA6-6761-17CE-C1963838F5B8}"/>
                </a:ext>
              </a:extLst>
            </p:cNvPr>
            <p:cNvSpPr txBox="1"/>
            <p:nvPr/>
          </p:nvSpPr>
          <p:spPr>
            <a:xfrm>
              <a:off x="1251768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D3D7309-429A-6F92-89D9-C27E28066A51}"/>
                </a:ext>
              </a:extLst>
            </p:cNvPr>
            <p:cNvSpPr txBox="1"/>
            <p:nvPr/>
          </p:nvSpPr>
          <p:spPr>
            <a:xfrm>
              <a:off x="456487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F3DD72C-8BE6-ECA4-0220-F795C0511041}"/>
                </a:ext>
              </a:extLst>
            </p:cNvPr>
            <p:cNvSpPr txBox="1"/>
            <p:nvPr/>
          </p:nvSpPr>
          <p:spPr>
            <a:xfrm>
              <a:off x="1772051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D8F9FF8-C4D7-6F44-53B2-A64850229513}"/>
                </a:ext>
              </a:extLst>
            </p:cNvPr>
            <p:cNvSpPr txBox="1"/>
            <p:nvPr/>
          </p:nvSpPr>
          <p:spPr>
            <a:xfrm>
              <a:off x="2021456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84FFDF03-80F3-4A99-72EA-BF331C5A816D}"/>
                </a:ext>
              </a:extLst>
            </p:cNvPr>
            <p:cNvSpPr txBox="1"/>
            <p:nvPr/>
          </p:nvSpPr>
          <p:spPr>
            <a:xfrm>
              <a:off x="2337557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B254706-620A-F2B0-5A58-29AE0C1F260D}"/>
                </a:ext>
              </a:extLst>
            </p:cNvPr>
            <p:cNvSpPr txBox="1"/>
            <p:nvPr/>
          </p:nvSpPr>
          <p:spPr>
            <a:xfrm>
              <a:off x="1530611" y="80132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FC64A6F-206D-199E-852B-C1BB77863992}"/>
                </a:ext>
              </a:extLst>
            </p:cNvPr>
            <p:cNvSpPr txBox="1"/>
            <p:nvPr/>
          </p:nvSpPr>
          <p:spPr>
            <a:xfrm>
              <a:off x="2595108" y="8013239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g5/ µM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AB61EF52-7293-8B98-6CF3-18B2A5DECDBB}"/>
                </a:ext>
              </a:extLst>
            </p:cNvPr>
            <p:cNvCxnSpPr>
              <a:cxnSpLocks/>
            </p:cNvCxnSpPr>
            <p:nvPr/>
          </p:nvCxnSpPr>
          <p:spPr>
            <a:xfrm>
              <a:off x="490772" y="8011909"/>
              <a:ext cx="9694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274565E-92DE-FC2A-6EEA-30EEA1003448}"/>
                </a:ext>
              </a:extLst>
            </p:cNvPr>
            <p:cNvSpPr txBox="1"/>
            <p:nvPr/>
          </p:nvSpPr>
          <p:spPr>
            <a:xfrm>
              <a:off x="2595108" y="8252388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Oxidised PRDX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1DE315F-4EBE-BE98-2EA3-69C6788D8B12}"/>
                </a:ext>
              </a:extLst>
            </p:cNvPr>
            <p:cNvSpPr txBox="1"/>
            <p:nvPr/>
          </p:nvSpPr>
          <p:spPr>
            <a:xfrm>
              <a:off x="2595108" y="8653362"/>
              <a:ext cx="1156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educed PRDX3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98981D6-38AD-CEE2-EEDC-953486F95101}"/>
                </a:ext>
              </a:extLst>
            </p:cNvPr>
            <p:cNvSpPr txBox="1"/>
            <p:nvPr/>
          </p:nvSpPr>
          <p:spPr>
            <a:xfrm>
              <a:off x="2595108" y="7786873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% O</a:t>
              </a:r>
              <a:r>
                <a:rPr lang="en-GB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64D250D5-EBF2-72CA-EFFF-4F93B8A9AB20}"/>
                </a:ext>
              </a:extLst>
            </p:cNvPr>
            <p:cNvCxnSpPr>
              <a:cxnSpLocks/>
            </p:cNvCxnSpPr>
            <p:nvPr/>
          </p:nvCxnSpPr>
          <p:spPr>
            <a:xfrm>
              <a:off x="1563333" y="8011909"/>
              <a:ext cx="9694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F8BC5256-62D5-D0C0-7098-A6F80AA5195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5533" y="9002013"/>
              <a:ext cx="2224800" cy="149857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FC9E7DE-DA4E-6B9A-742D-0D68CCB59697}"/>
                </a:ext>
              </a:extLst>
            </p:cNvPr>
            <p:cNvSpPr txBox="1"/>
            <p:nvPr/>
          </p:nvSpPr>
          <p:spPr>
            <a:xfrm>
              <a:off x="2595108" y="8953830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91249677-220B-A12A-6B12-D84CCEC7DC39}"/>
              </a:ext>
            </a:extLst>
          </p:cNvPr>
          <p:cNvSpPr txBox="1"/>
          <p:nvPr/>
        </p:nvSpPr>
        <p:spPr>
          <a:xfrm>
            <a:off x="72403" y="27159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AE426206-5DD5-C1CC-8F91-FE6FF3A802F0}"/>
              </a:ext>
            </a:extLst>
          </p:cNvPr>
          <p:cNvGrpSpPr/>
          <p:nvPr/>
        </p:nvGrpSpPr>
        <p:grpSpPr>
          <a:xfrm>
            <a:off x="318841" y="426040"/>
            <a:ext cx="3486669" cy="1468990"/>
            <a:chOff x="318841" y="426040"/>
            <a:chExt cx="3486669" cy="1468990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B8CF6711-03C9-0B70-1976-6925D6F0E745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l="20344" t="42410" r="15604" b="45683"/>
            <a:stretch/>
          </p:blipFill>
          <p:spPr>
            <a:xfrm>
              <a:off x="318841" y="1130950"/>
              <a:ext cx="2880000" cy="21600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A4DCF87-847D-6B44-8891-7251A0718A09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l="18107" t="29289" r="21353" b="59367"/>
            <a:stretch/>
          </p:blipFill>
          <p:spPr>
            <a:xfrm>
              <a:off x="318842" y="858782"/>
              <a:ext cx="2880000" cy="219600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E785469B-641F-49D6-CF5E-FB212964DAEB}"/>
                </a:ext>
              </a:extLst>
            </p:cNvPr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l="16708" t="47485" r="18691" b="41074"/>
            <a:stretch/>
          </p:blipFill>
          <p:spPr>
            <a:xfrm>
              <a:off x="318842" y="1675287"/>
              <a:ext cx="2880000" cy="216000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27566CF-16CD-5F13-7E21-0EE3A9E3616D}"/>
                </a:ext>
              </a:extLst>
            </p:cNvPr>
            <p:cNvSpPr txBox="1"/>
            <p:nvPr/>
          </p:nvSpPr>
          <p:spPr>
            <a:xfrm>
              <a:off x="3139943" y="1648809"/>
              <a:ext cx="5677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0216DBA-BF5D-A056-6701-48D82E4CA5A4}"/>
                </a:ext>
              </a:extLst>
            </p:cNvPr>
            <p:cNvSpPr txBox="1"/>
            <p:nvPr/>
          </p:nvSpPr>
          <p:spPr>
            <a:xfrm>
              <a:off x="3139943" y="860075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IF-1</a:t>
              </a:r>
              <a:r>
                <a:rPr lang="en-GB" sz="1000" dirty="0">
                  <a:latin typeface="Symbol" pitchFamily="2" charset="2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E2936C8-C519-A731-0CDB-8BC48A0673C8}"/>
                </a:ext>
              </a:extLst>
            </p:cNvPr>
            <p:cNvSpPr txBox="1"/>
            <p:nvPr/>
          </p:nvSpPr>
          <p:spPr>
            <a:xfrm>
              <a:off x="3116059" y="426040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% O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1B1E1F7-3748-BCF4-05E2-ABDD0273B19E}"/>
                </a:ext>
              </a:extLst>
            </p:cNvPr>
            <p:cNvSpPr txBox="1"/>
            <p:nvPr/>
          </p:nvSpPr>
          <p:spPr>
            <a:xfrm>
              <a:off x="1260349" y="42604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EFC4067-0D86-2198-D9CF-AD1FB576B3DB}"/>
                </a:ext>
              </a:extLst>
            </p:cNvPr>
            <p:cNvSpPr txBox="1"/>
            <p:nvPr/>
          </p:nvSpPr>
          <p:spPr>
            <a:xfrm>
              <a:off x="544466" y="42604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0B46233-8F35-4887-AACC-150E544B2BDC}"/>
                </a:ext>
              </a:extLst>
            </p:cNvPr>
            <p:cNvSpPr txBox="1"/>
            <p:nvPr/>
          </p:nvSpPr>
          <p:spPr>
            <a:xfrm>
              <a:off x="2556712" y="426040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&lt;0.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0D18535-A095-A1C3-42A3-66640B29538A}"/>
                </a:ext>
              </a:extLst>
            </p:cNvPr>
            <p:cNvSpPr txBox="1"/>
            <p:nvPr/>
          </p:nvSpPr>
          <p:spPr>
            <a:xfrm>
              <a:off x="1905198" y="42604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5A22C33-D9A9-B225-1A1F-8470738BA4DE}"/>
                </a:ext>
              </a:extLst>
            </p:cNvPr>
            <p:cNvSpPr txBox="1"/>
            <p:nvPr/>
          </p:nvSpPr>
          <p:spPr>
            <a:xfrm>
              <a:off x="3116059" y="644699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g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6164798-522B-F52A-CD70-1A3C3A7376AB}"/>
                </a:ext>
              </a:extLst>
            </p:cNvPr>
            <p:cNvSpPr txBox="1"/>
            <p:nvPr/>
          </p:nvSpPr>
          <p:spPr>
            <a:xfrm>
              <a:off x="721213" y="6446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7738BCA-76BF-6513-9206-4EA945EBA50F}"/>
                </a:ext>
              </a:extLst>
            </p:cNvPr>
            <p:cNvSpPr txBox="1"/>
            <p:nvPr/>
          </p:nvSpPr>
          <p:spPr>
            <a:xfrm>
              <a:off x="402083" y="64469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A2CE525-5874-1D0E-5A13-FBA28B311669}"/>
                </a:ext>
              </a:extLst>
            </p:cNvPr>
            <p:cNvSpPr txBox="1"/>
            <p:nvPr/>
          </p:nvSpPr>
          <p:spPr>
            <a:xfrm>
              <a:off x="2490440" y="64469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0655146-B1D6-848A-6436-44FDC693BAE3}"/>
                </a:ext>
              </a:extLst>
            </p:cNvPr>
            <p:cNvSpPr txBox="1"/>
            <p:nvPr/>
          </p:nvSpPr>
          <p:spPr>
            <a:xfrm>
              <a:off x="1092517" y="64469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EC42455-FAF6-B468-7E4B-AE72BA5176FA}"/>
                </a:ext>
              </a:extLst>
            </p:cNvPr>
            <p:cNvSpPr txBox="1"/>
            <p:nvPr/>
          </p:nvSpPr>
          <p:spPr>
            <a:xfrm>
              <a:off x="1798564" y="64469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8CA479E-7656-E952-E675-082728ECB34F}"/>
                </a:ext>
              </a:extLst>
            </p:cNvPr>
            <p:cNvSpPr txBox="1"/>
            <p:nvPr/>
          </p:nvSpPr>
          <p:spPr>
            <a:xfrm>
              <a:off x="2129469" y="6446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00CD8D5-ED84-6B6B-F7CA-521C73F8B9BC}"/>
                </a:ext>
              </a:extLst>
            </p:cNvPr>
            <p:cNvSpPr txBox="1"/>
            <p:nvPr/>
          </p:nvSpPr>
          <p:spPr>
            <a:xfrm>
              <a:off x="1423371" y="6446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60119AC2-764A-B0DB-B7D4-02D77AEDA07A}"/>
                </a:ext>
              </a:extLst>
            </p:cNvPr>
            <p:cNvSpPr txBox="1"/>
            <p:nvPr/>
          </p:nvSpPr>
          <p:spPr>
            <a:xfrm>
              <a:off x="2835600" y="6446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6B287B4-2B32-848D-AE54-FC22A82B40C9}"/>
                </a:ext>
              </a:extLst>
            </p:cNvPr>
            <p:cNvSpPr txBox="1"/>
            <p:nvPr/>
          </p:nvSpPr>
          <p:spPr>
            <a:xfrm>
              <a:off x="3139943" y="1121971"/>
              <a:ext cx="6655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53-S15</a:t>
              </a:r>
              <a:endParaRPr lang="en-GB" sz="1000" dirty="0">
                <a:latin typeface="Symbol" pitchFamily="2" charset="2"/>
                <a:cs typeface="Arial" panose="020B0604020202020204" pitchFamily="34" charset="0"/>
              </a:endParaRPr>
            </a:p>
          </p:txBody>
        </p:sp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9AB1377D-21C2-0FB2-892D-3151DE8D8AC1}"/>
                </a:ext>
              </a:extLst>
            </p:cNvPr>
            <p:cNvPicPr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l="18706" t="51112" r="14768" b="38196"/>
            <a:stretch/>
          </p:blipFill>
          <p:spPr>
            <a:xfrm>
              <a:off x="318841" y="1403118"/>
              <a:ext cx="2880000" cy="216000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24091E60-E995-476B-9933-1A5AC51280CB}"/>
                </a:ext>
              </a:extLst>
            </p:cNvPr>
            <p:cNvSpPr txBox="1"/>
            <p:nvPr/>
          </p:nvSpPr>
          <p:spPr>
            <a:xfrm>
              <a:off x="3139943" y="137592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en-GB" sz="1000" dirty="0">
                <a:latin typeface="Symbol" pitchFamily="2" charset="2"/>
                <a:cs typeface="Arial" panose="020B0604020202020204" pitchFamily="34" charset="0"/>
              </a:endParaRPr>
            </a:p>
          </p:txBody>
        </p: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14F55C78-6586-85D7-E562-64E1EF9D18EA}"/>
                </a:ext>
              </a:extLst>
            </p:cNvPr>
            <p:cNvCxnSpPr>
              <a:cxnSpLocks/>
            </p:cNvCxnSpPr>
            <p:nvPr/>
          </p:nvCxnSpPr>
          <p:spPr>
            <a:xfrm>
              <a:off x="1092517" y="675376"/>
              <a:ext cx="5908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C6CBA5AE-FFD9-E92B-3724-C30B56B2C61A}"/>
                </a:ext>
              </a:extLst>
            </p:cNvPr>
            <p:cNvCxnSpPr>
              <a:cxnSpLocks/>
            </p:cNvCxnSpPr>
            <p:nvPr/>
          </p:nvCxnSpPr>
          <p:spPr>
            <a:xfrm>
              <a:off x="394636" y="675376"/>
              <a:ext cx="5908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C80E0689-0877-4376-FFE9-041F076FC050}"/>
                </a:ext>
              </a:extLst>
            </p:cNvPr>
            <p:cNvCxnSpPr>
              <a:cxnSpLocks/>
            </p:cNvCxnSpPr>
            <p:nvPr/>
          </p:nvCxnSpPr>
          <p:spPr>
            <a:xfrm>
              <a:off x="1790265" y="675376"/>
              <a:ext cx="5908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DC55EF4E-56EE-E932-DBCF-8EFD18F70569}"/>
                </a:ext>
              </a:extLst>
            </p:cNvPr>
            <p:cNvCxnSpPr>
              <a:cxnSpLocks/>
            </p:cNvCxnSpPr>
            <p:nvPr/>
          </p:nvCxnSpPr>
          <p:spPr>
            <a:xfrm>
              <a:off x="2479450" y="675376"/>
              <a:ext cx="5908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83" name="Picture 82">
            <a:extLst>
              <a:ext uri="{FF2B5EF4-FFF2-40B4-BE49-F238E27FC236}">
                <a16:creationId xmlns:a16="http://schemas.microsoft.com/office/drawing/2014/main" id="{CAADCE58-5009-6742-BAD9-EDFC73C8457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95295" y="7476667"/>
            <a:ext cx="3619500" cy="242570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6F27DBE3-C371-91FA-8A09-B516AD71877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196658" y="2371598"/>
            <a:ext cx="3619500" cy="24892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16E1ACF-1ED3-EFC7-FCB7-6AA45FCD6B3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823539" y="4865637"/>
            <a:ext cx="27051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1996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33F469F-50B9-5ED8-2A68-D04A292A6532}"/>
              </a:ext>
            </a:extLst>
          </p:cNvPr>
          <p:cNvSpPr txBox="1"/>
          <p:nvPr/>
        </p:nvSpPr>
        <p:spPr>
          <a:xfrm>
            <a:off x="6239791" y="0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Figure S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C05AC6-84AD-2659-06BB-A75A2C138BE1}"/>
              </a:ext>
            </a:extLst>
          </p:cNvPr>
          <p:cNvSpPr txBox="1"/>
          <p:nvPr/>
        </p:nvSpPr>
        <p:spPr>
          <a:xfrm>
            <a:off x="122770" y="28554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4DCA6C-839F-46A4-0175-124EB3E53A16}"/>
              </a:ext>
            </a:extLst>
          </p:cNvPr>
          <p:cNvSpPr txBox="1"/>
          <p:nvPr/>
        </p:nvSpPr>
        <p:spPr>
          <a:xfrm>
            <a:off x="3336911" y="29027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6BC1734-B403-3DBA-DBA0-EEC4D71FBEE8}"/>
              </a:ext>
            </a:extLst>
          </p:cNvPr>
          <p:cNvGrpSpPr/>
          <p:nvPr/>
        </p:nvGrpSpPr>
        <p:grpSpPr>
          <a:xfrm>
            <a:off x="973660" y="3621375"/>
            <a:ext cx="919358" cy="1868269"/>
            <a:chOff x="632861" y="716791"/>
            <a:chExt cx="919358" cy="1868269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0EEC8DE-119A-4F7D-D1EC-B559C7BE93B6}"/>
                </a:ext>
              </a:extLst>
            </p:cNvPr>
            <p:cNvSpPr txBox="1"/>
            <p:nvPr/>
          </p:nvSpPr>
          <p:spPr>
            <a:xfrm>
              <a:off x="758004" y="716791"/>
              <a:ext cx="6690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173AD23-98FC-9798-26DD-153A0B8E9CEA}"/>
                </a:ext>
              </a:extLst>
            </p:cNvPr>
            <p:cNvSpPr txBox="1"/>
            <p:nvPr/>
          </p:nvSpPr>
          <p:spPr>
            <a:xfrm>
              <a:off x="758004" y="1083831"/>
              <a:ext cx="6690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IF-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C52C7D0-F287-A0DC-9F8F-C8788484DBAD}"/>
                </a:ext>
              </a:extLst>
            </p:cNvPr>
            <p:cNvSpPr txBox="1"/>
            <p:nvPr/>
          </p:nvSpPr>
          <p:spPr>
            <a:xfrm>
              <a:off x="758004" y="1450871"/>
              <a:ext cx="6690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DK1/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A665577-6ACA-3648-BD11-308A0529AA44}"/>
                </a:ext>
              </a:extLst>
            </p:cNvPr>
            <p:cNvSpPr txBox="1"/>
            <p:nvPr/>
          </p:nvSpPr>
          <p:spPr>
            <a:xfrm>
              <a:off x="758004" y="1817911"/>
              <a:ext cx="6690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DH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2F2A3C8-3B9F-3BEB-0057-027DAB338305}"/>
                </a:ext>
              </a:extLst>
            </p:cNvPr>
            <p:cNvSpPr txBox="1"/>
            <p:nvPr/>
          </p:nvSpPr>
          <p:spPr>
            <a:xfrm>
              <a:off x="632861" y="2184950"/>
              <a:ext cx="91935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GB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 consumption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45FAAE63-D958-976B-A635-8B36265BF35E}"/>
                </a:ext>
              </a:extLst>
            </p:cNvPr>
            <p:cNvCxnSpPr>
              <a:cxnSpLocks/>
              <a:stCxn id="8" idx="2"/>
              <a:endCxn id="9" idx="0"/>
            </p:cNvCxnSpPr>
            <p:nvPr/>
          </p:nvCxnSpPr>
          <p:spPr>
            <a:xfrm>
              <a:off x="1092541" y="963012"/>
              <a:ext cx="0" cy="12081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A99FD89D-AE95-CF56-D2CB-7C213B58F915}"/>
                </a:ext>
              </a:extLst>
            </p:cNvPr>
            <p:cNvCxnSpPr/>
            <p:nvPr/>
          </p:nvCxnSpPr>
          <p:spPr>
            <a:xfrm>
              <a:off x="1087546" y="1332767"/>
              <a:ext cx="0" cy="12081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987494A2-1543-9AC0-AF56-17D0B3D5DBFA}"/>
                </a:ext>
              </a:extLst>
            </p:cNvPr>
            <p:cNvCxnSpPr>
              <a:cxnSpLocks/>
              <a:stCxn id="10" idx="2"/>
              <a:endCxn id="11" idx="0"/>
            </p:cNvCxnSpPr>
            <p:nvPr/>
          </p:nvCxnSpPr>
          <p:spPr>
            <a:xfrm>
              <a:off x="1092541" y="1697092"/>
              <a:ext cx="0" cy="12081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8342A960-DE00-C4AC-A17A-B1617EC8F35E}"/>
                </a:ext>
              </a:extLst>
            </p:cNvPr>
            <p:cNvCxnSpPr>
              <a:cxnSpLocks/>
            </p:cNvCxnSpPr>
            <p:nvPr/>
          </p:nvCxnSpPr>
          <p:spPr>
            <a:xfrm>
              <a:off x="995106" y="1825406"/>
              <a:ext cx="178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DEAF9F95-6285-BEF1-34BB-55495B634EB1}"/>
                </a:ext>
              </a:extLst>
            </p:cNvPr>
            <p:cNvCxnSpPr/>
            <p:nvPr/>
          </p:nvCxnSpPr>
          <p:spPr>
            <a:xfrm>
              <a:off x="1087546" y="2038321"/>
              <a:ext cx="0" cy="1329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6648E40F-457E-8ECF-E1F0-332530725618}"/>
                </a:ext>
              </a:extLst>
            </p:cNvPr>
            <p:cNvCxnSpPr>
              <a:cxnSpLocks/>
            </p:cNvCxnSpPr>
            <p:nvPr/>
          </p:nvCxnSpPr>
          <p:spPr>
            <a:xfrm>
              <a:off x="990111" y="2172676"/>
              <a:ext cx="178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C6FF62E8-A1AB-37B9-E3F5-3F4EA192BEC2}"/>
              </a:ext>
            </a:extLst>
          </p:cNvPr>
          <p:cNvSpPr txBox="1"/>
          <p:nvPr/>
        </p:nvSpPr>
        <p:spPr>
          <a:xfrm>
            <a:off x="123266" y="28480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648BDC7-5BDD-DEB9-1637-2D3762A251BB}"/>
              </a:ext>
            </a:extLst>
          </p:cNvPr>
          <p:cNvSpPr txBox="1"/>
          <p:nvPr/>
        </p:nvSpPr>
        <p:spPr>
          <a:xfrm>
            <a:off x="2824643" y="29198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AEFD986-DBB3-C4DA-897D-0BCAEEAB62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76" y="380491"/>
            <a:ext cx="3556000" cy="24384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B00258C-A77A-7D70-22BD-AD29C1884D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62113" y="3309968"/>
            <a:ext cx="2501900" cy="22606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CDEA24B-AFEA-1E2E-1DDE-D483F5A10B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2308" y="603153"/>
            <a:ext cx="2755900" cy="2514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0194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 Theme 2013 -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 2013 -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 2013 -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2891</TotalTime>
  <Words>327</Words>
  <Application>Microsoft Macintosh PowerPoint</Application>
  <PresentationFormat>A4 Paper (210x297 mm)</PresentationFormat>
  <Paragraphs>87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 2013 - 2022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er Hammond</dc:creator>
  <cp:lastModifiedBy>Sophie Twigger</cp:lastModifiedBy>
  <cp:revision>346</cp:revision>
  <dcterms:created xsi:type="dcterms:W3CDTF">2022-12-22T09:35:58Z</dcterms:created>
  <dcterms:modified xsi:type="dcterms:W3CDTF">2024-07-25T10:44:45Z</dcterms:modified>
</cp:coreProperties>
</file>